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56" r:id="rId3"/>
    <p:sldId id="284" r:id="rId4"/>
    <p:sldId id="283" r:id="rId5"/>
    <p:sldId id="285" r:id="rId6"/>
    <p:sldId id="286" r:id="rId7"/>
    <p:sldId id="287" r:id="rId8"/>
    <p:sldId id="257" r:id="rId9"/>
    <p:sldId id="258" r:id="rId10"/>
    <p:sldId id="282" r:id="rId11"/>
    <p:sldId id="259" r:id="rId12"/>
    <p:sldId id="260" r:id="rId13"/>
    <p:sldId id="261" r:id="rId14"/>
    <p:sldId id="262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  <p:sldId id="276" r:id="rId26"/>
    <p:sldId id="279" r:id="rId27"/>
    <p:sldId id="277" r:id="rId28"/>
    <p:sldId id="278" r:id="rId29"/>
    <p:sldId id="280" r:id="rId30"/>
  </p:sldIdLst>
  <p:sldSz cx="12192000" cy="6858000"/>
  <p:notesSz cx="12192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629" y="77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\OneDrive\Desktop\Nanopharma%20Data%20Analyses\04.03.2020%20RNAseq\U87\U87_48hrs%20fb_PMT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glin\OneDrive\Desktop\Nanopharma%20Data%20Analyses\04.03.2020%20RNAseq\U87\U87_48hrs%20fb_PMT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>
                <a:solidFill>
                  <a:sysClr val="windowText" lastClr="000000"/>
                </a:solidFill>
                <a:effectLst/>
              </a:rPr>
              <a:t>Effects of the fb-PMT on expression of cancer driver genes (p adj = 0.05) </a:t>
            </a:r>
            <a:endParaRPr lang="en-US">
              <a:solidFill>
                <a:sysClr val="windowText" lastClr="000000"/>
              </a:solidFill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bar"/>
        <c:grouping val="clustered"/>
        <c:varyColors val="0"/>
        <c:ser>
          <c:idx val="0"/>
          <c:order val="0"/>
          <c:tx>
            <c:strRef>
              <c:f>Sheet9!$B$1</c:f>
              <c:strCache>
                <c:ptCount val="1"/>
                <c:pt idx="0">
                  <c:v>log2FoldChan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  <a:sp3d>
                <a:contourClr>
                  <a:srgbClr val="FF0000"/>
                </a:contourClr>
              </a:sp3d>
            </c:spPr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  <a:sp3d>
                <a:contourClr>
                  <a:srgbClr val="FF0000"/>
                </a:contourClr>
              </a:sp3d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</c:dPt>
          <c:cat>
            <c:strRef>
              <c:f>Sheet9!$A$2:$A$35</c:f>
              <c:strCache>
                <c:ptCount val="34"/>
                <c:pt idx="0">
                  <c:v>CDKN2A</c:v>
                </c:pt>
                <c:pt idx="1">
                  <c:v>RET</c:v>
                </c:pt>
                <c:pt idx="2">
                  <c:v>HRAS</c:v>
                </c:pt>
                <c:pt idx="3">
                  <c:v>BAX</c:v>
                </c:pt>
                <c:pt idx="4">
                  <c:v>RPL22</c:v>
                </c:pt>
                <c:pt idx="5">
                  <c:v>SPOP</c:v>
                </c:pt>
                <c:pt idx="6">
                  <c:v>CCND1</c:v>
                </c:pt>
                <c:pt idx="7">
                  <c:v>TBX3</c:v>
                </c:pt>
                <c:pt idx="8">
                  <c:v>FUBP1</c:v>
                </c:pt>
                <c:pt idx="9">
                  <c:v>TNFAIP3</c:v>
                </c:pt>
                <c:pt idx="10">
                  <c:v>MAPK1</c:v>
                </c:pt>
                <c:pt idx="11">
                  <c:v>BRAF</c:v>
                </c:pt>
                <c:pt idx="12">
                  <c:v>SMAD3</c:v>
                </c:pt>
                <c:pt idx="13">
                  <c:v>ARID1B</c:v>
                </c:pt>
                <c:pt idx="14">
                  <c:v>ARID1A</c:v>
                </c:pt>
                <c:pt idx="15">
                  <c:v>TGFBR2</c:v>
                </c:pt>
                <c:pt idx="16">
                  <c:v>BCOR</c:v>
                </c:pt>
                <c:pt idx="17">
                  <c:v>MET</c:v>
                </c:pt>
                <c:pt idx="18">
                  <c:v>EPAS1</c:v>
                </c:pt>
                <c:pt idx="19">
                  <c:v>ERC1</c:v>
                </c:pt>
                <c:pt idx="20">
                  <c:v>PTCH1</c:v>
                </c:pt>
                <c:pt idx="21">
                  <c:v>MTOR</c:v>
                </c:pt>
                <c:pt idx="22">
                  <c:v>CREBBP</c:v>
                </c:pt>
                <c:pt idx="23">
                  <c:v>NOTCH1</c:v>
                </c:pt>
                <c:pt idx="24">
                  <c:v>EP300</c:v>
                </c:pt>
                <c:pt idx="25">
                  <c:v>MED12</c:v>
                </c:pt>
                <c:pt idx="26">
                  <c:v>KMT2D</c:v>
                </c:pt>
                <c:pt idx="27">
                  <c:v>SPEN</c:v>
                </c:pt>
                <c:pt idx="28">
                  <c:v>KMT2A</c:v>
                </c:pt>
                <c:pt idx="29">
                  <c:v>NSD1</c:v>
                </c:pt>
                <c:pt idx="30">
                  <c:v>NOTCH2</c:v>
                </c:pt>
                <c:pt idx="31">
                  <c:v>FAT4</c:v>
                </c:pt>
                <c:pt idx="32">
                  <c:v>EGFR</c:v>
                </c:pt>
                <c:pt idx="33">
                  <c:v>FAT1</c:v>
                </c:pt>
              </c:strCache>
            </c:strRef>
          </c:cat>
          <c:val>
            <c:numRef>
              <c:f>Sheet9!$B$2:$B$35</c:f>
              <c:numCache>
                <c:formatCode>General</c:formatCode>
                <c:ptCount val="34"/>
                <c:pt idx="0">
                  <c:v>4.9852183021758396</c:v>
                </c:pt>
                <c:pt idx="1">
                  <c:v>2.8652457547732402</c:v>
                </c:pt>
                <c:pt idx="2">
                  <c:v>0.84140176495496299</c:v>
                </c:pt>
                <c:pt idx="3">
                  <c:v>0.71499408328921699</c:v>
                </c:pt>
                <c:pt idx="4">
                  <c:v>0.525968435404218</c:v>
                </c:pt>
                <c:pt idx="5">
                  <c:v>0.31427307386660402</c:v>
                </c:pt>
                <c:pt idx="6">
                  <c:v>-0.305100256607931</c:v>
                </c:pt>
                <c:pt idx="7">
                  <c:v>-0.39302770594649999</c:v>
                </c:pt>
                <c:pt idx="8">
                  <c:v>-0.39508065548841897</c:v>
                </c:pt>
                <c:pt idx="9">
                  <c:v>-0.427362086213119</c:v>
                </c:pt>
                <c:pt idx="10">
                  <c:v>-0.48253604784314902</c:v>
                </c:pt>
                <c:pt idx="11">
                  <c:v>-0.49268066730048599</c:v>
                </c:pt>
                <c:pt idx="12">
                  <c:v>-0.49857164874249899</c:v>
                </c:pt>
                <c:pt idx="13">
                  <c:v>-0.51676282985415301</c:v>
                </c:pt>
                <c:pt idx="14">
                  <c:v>-0.55075547889853005</c:v>
                </c:pt>
                <c:pt idx="15">
                  <c:v>-0.56934527737551299</c:v>
                </c:pt>
                <c:pt idx="16">
                  <c:v>-0.57382162778212698</c:v>
                </c:pt>
                <c:pt idx="17">
                  <c:v>-0.58489006619788197</c:v>
                </c:pt>
                <c:pt idx="18">
                  <c:v>-0.61514796841406605</c:v>
                </c:pt>
                <c:pt idx="19">
                  <c:v>-0.63143580888404904</c:v>
                </c:pt>
                <c:pt idx="20">
                  <c:v>-0.64312621520122404</c:v>
                </c:pt>
                <c:pt idx="21">
                  <c:v>-0.65497994016234795</c:v>
                </c:pt>
                <c:pt idx="22">
                  <c:v>-0.73977650322100696</c:v>
                </c:pt>
                <c:pt idx="23">
                  <c:v>-0.74059629703310903</c:v>
                </c:pt>
                <c:pt idx="24">
                  <c:v>-0.83789733007553902</c:v>
                </c:pt>
                <c:pt idx="25">
                  <c:v>-0.84489424354245901</c:v>
                </c:pt>
                <c:pt idx="26">
                  <c:v>-0.91731949214465103</c:v>
                </c:pt>
                <c:pt idx="27">
                  <c:v>-0.92748349958209497</c:v>
                </c:pt>
                <c:pt idx="28">
                  <c:v>-0.96585171599966702</c:v>
                </c:pt>
                <c:pt idx="29">
                  <c:v>-1.0082493056242099</c:v>
                </c:pt>
                <c:pt idx="30">
                  <c:v>-1.0251242006761001</c:v>
                </c:pt>
                <c:pt idx="31">
                  <c:v>-1.1538992278823801</c:v>
                </c:pt>
                <c:pt idx="32">
                  <c:v>-1.2831227292817899</c:v>
                </c:pt>
                <c:pt idx="33">
                  <c:v>-1.321978326967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11786120"/>
        <c:axId val="311790824"/>
        <c:axId val="0"/>
      </c:bar3DChart>
      <c:catAx>
        <c:axId val="3117861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1790824"/>
        <c:crosses val="autoZero"/>
        <c:auto val="1"/>
        <c:lblAlgn val="ctr"/>
        <c:lblOffset val="100"/>
        <c:tickLblSkip val="1"/>
        <c:noMultiLvlLbl val="0"/>
      </c:catAx>
      <c:valAx>
        <c:axId val="311790824"/>
        <c:scaling>
          <c:orientation val="minMax"/>
          <c:max val="1.5"/>
          <c:min val="-1.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</a:rPr>
                  <a:t>Log</a:t>
                </a:r>
                <a:r>
                  <a:rPr lang="en-US" sz="1400" b="1" baseline="0">
                    <a:solidFill>
                      <a:sysClr val="windowText" lastClr="000000"/>
                    </a:solidFill>
                  </a:rPr>
                  <a:t> 2 Fold Expression Changes</a:t>
                </a:r>
                <a:endParaRPr lang="en-US" sz="1400" b="1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1786120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Effects of the fb-PMT on expression of cancer driver genes (p &lt; 0.05)</a:t>
            </a:r>
            <a:r>
              <a:rPr lang="en-US" sz="1800" b="1" baseline="0">
                <a:solidFill>
                  <a:sysClr val="windowText" lastClr="000000"/>
                </a:solidFill>
              </a:rPr>
              <a:t> </a:t>
            </a:r>
            <a:endParaRPr lang="en-US" sz="1800" b="1">
              <a:solidFill>
                <a:sysClr val="windowText" lastClr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6.1738541427305019E-2"/>
          <c:y val="5.676679884666061E-2"/>
          <c:w val="0.9187963722016832"/>
          <c:h val="0.89391680298391574"/>
        </c:manualLayout>
      </c:layout>
      <c:bar3DChart>
        <c:barDir val="bar"/>
        <c:grouping val="clustered"/>
        <c:varyColors val="0"/>
        <c:ser>
          <c:idx val="0"/>
          <c:order val="0"/>
          <c:tx>
            <c:strRef>
              <c:f>Sheet8!$K$1</c:f>
              <c:strCache>
                <c:ptCount val="1"/>
                <c:pt idx="0">
                  <c:v>log2FoldChan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Sheet8!$J$2:$J$63</c:f>
              <c:strCache>
                <c:ptCount val="62"/>
                <c:pt idx="0">
                  <c:v>CDKN2A</c:v>
                </c:pt>
                <c:pt idx="1">
                  <c:v>RET</c:v>
                </c:pt>
                <c:pt idx="2">
                  <c:v>HRAS</c:v>
                </c:pt>
                <c:pt idx="3">
                  <c:v>BAX</c:v>
                </c:pt>
                <c:pt idx="4">
                  <c:v>RPL22</c:v>
                </c:pt>
                <c:pt idx="5">
                  <c:v>CDK4</c:v>
                </c:pt>
                <c:pt idx="6">
                  <c:v>RPL5</c:v>
                </c:pt>
                <c:pt idx="7">
                  <c:v>NPM1</c:v>
                </c:pt>
                <c:pt idx="8">
                  <c:v>CHEK2</c:v>
                </c:pt>
                <c:pt idx="9">
                  <c:v>RAC1</c:v>
                </c:pt>
                <c:pt idx="10">
                  <c:v>SPOP</c:v>
                </c:pt>
                <c:pt idx="11">
                  <c:v>B2M</c:v>
                </c:pt>
                <c:pt idx="12">
                  <c:v>CCND1</c:v>
                </c:pt>
                <c:pt idx="13">
                  <c:v>CUX1</c:v>
                </c:pt>
                <c:pt idx="14">
                  <c:v>ASXL1</c:v>
                </c:pt>
                <c:pt idx="15">
                  <c:v>ETV6</c:v>
                </c:pt>
                <c:pt idx="16">
                  <c:v>TBX3</c:v>
                </c:pt>
                <c:pt idx="17">
                  <c:v>FUBP1</c:v>
                </c:pt>
                <c:pt idx="18">
                  <c:v>LARP4B</c:v>
                </c:pt>
                <c:pt idx="19">
                  <c:v>TNFAIP3</c:v>
                </c:pt>
                <c:pt idx="20">
                  <c:v>PRDM2</c:v>
                </c:pt>
                <c:pt idx="21">
                  <c:v>SETD1B</c:v>
                </c:pt>
                <c:pt idx="22">
                  <c:v>MAPK1</c:v>
                </c:pt>
                <c:pt idx="23">
                  <c:v>CIC</c:v>
                </c:pt>
                <c:pt idx="24">
                  <c:v>BRAF</c:v>
                </c:pt>
                <c:pt idx="25">
                  <c:v>SMAD3</c:v>
                </c:pt>
                <c:pt idx="26">
                  <c:v>NCOR2</c:v>
                </c:pt>
                <c:pt idx="27">
                  <c:v>CDK12</c:v>
                </c:pt>
                <c:pt idx="28">
                  <c:v>ARID1B</c:v>
                </c:pt>
                <c:pt idx="29">
                  <c:v>TSC1</c:v>
                </c:pt>
                <c:pt idx="30">
                  <c:v>RUNX1</c:v>
                </c:pt>
                <c:pt idx="31">
                  <c:v>POLE</c:v>
                </c:pt>
                <c:pt idx="32">
                  <c:v>AMER1</c:v>
                </c:pt>
                <c:pt idx="33">
                  <c:v>ARID1A</c:v>
                </c:pt>
                <c:pt idx="34">
                  <c:v>TGFBR2</c:v>
                </c:pt>
                <c:pt idx="35">
                  <c:v>BCOR</c:v>
                </c:pt>
                <c:pt idx="36">
                  <c:v>MET</c:v>
                </c:pt>
                <c:pt idx="37">
                  <c:v>EPAS1</c:v>
                </c:pt>
                <c:pt idx="38">
                  <c:v>ERC1</c:v>
                </c:pt>
                <c:pt idx="39">
                  <c:v>PTCH1</c:v>
                </c:pt>
                <c:pt idx="40">
                  <c:v>MTOR</c:v>
                </c:pt>
                <c:pt idx="41">
                  <c:v>CREBBP</c:v>
                </c:pt>
                <c:pt idx="42">
                  <c:v>NOTCH1</c:v>
                </c:pt>
                <c:pt idx="43">
                  <c:v>KMT2C</c:v>
                </c:pt>
                <c:pt idx="44">
                  <c:v>CTNND1</c:v>
                </c:pt>
                <c:pt idx="45">
                  <c:v>EP300</c:v>
                </c:pt>
                <c:pt idx="46">
                  <c:v>SETD2</c:v>
                </c:pt>
                <c:pt idx="47">
                  <c:v>MED12</c:v>
                </c:pt>
                <c:pt idx="48">
                  <c:v>UBR5</c:v>
                </c:pt>
                <c:pt idx="49">
                  <c:v>NF1</c:v>
                </c:pt>
                <c:pt idx="50">
                  <c:v>MAML2</c:v>
                </c:pt>
                <c:pt idx="51">
                  <c:v>KMT2D</c:v>
                </c:pt>
                <c:pt idx="52">
                  <c:v>SPEN</c:v>
                </c:pt>
                <c:pt idx="53">
                  <c:v>KMT2A</c:v>
                </c:pt>
                <c:pt idx="54">
                  <c:v>NBEA</c:v>
                </c:pt>
                <c:pt idx="55">
                  <c:v>NSD1</c:v>
                </c:pt>
                <c:pt idx="56">
                  <c:v>NOTCH2</c:v>
                </c:pt>
                <c:pt idx="57">
                  <c:v>BIRC6</c:v>
                </c:pt>
                <c:pt idx="58">
                  <c:v>FAT4</c:v>
                </c:pt>
                <c:pt idx="59">
                  <c:v>EGFR</c:v>
                </c:pt>
                <c:pt idx="60">
                  <c:v>FAT1</c:v>
                </c:pt>
                <c:pt idx="61">
                  <c:v>SRGAP3</c:v>
                </c:pt>
              </c:strCache>
            </c:strRef>
          </c:cat>
          <c:val>
            <c:numRef>
              <c:f>Sheet8!$K$2:$K$63</c:f>
              <c:numCache>
                <c:formatCode>General</c:formatCode>
                <c:ptCount val="62"/>
                <c:pt idx="0">
                  <c:v>4.9852183021758396</c:v>
                </c:pt>
                <c:pt idx="1">
                  <c:v>2.8652457547732402</c:v>
                </c:pt>
                <c:pt idx="2">
                  <c:v>0.84140176495496299</c:v>
                </c:pt>
                <c:pt idx="3">
                  <c:v>0.71499408328921699</c:v>
                </c:pt>
                <c:pt idx="4">
                  <c:v>0.525968435404218</c:v>
                </c:pt>
                <c:pt idx="5">
                  <c:v>0.52592798000006302</c:v>
                </c:pt>
                <c:pt idx="6">
                  <c:v>0.47307944992095602</c:v>
                </c:pt>
                <c:pt idx="7">
                  <c:v>0.44140289197480198</c:v>
                </c:pt>
                <c:pt idx="8">
                  <c:v>0.34399392113176802</c:v>
                </c:pt>
                <c:pt idx="9">
                  <c:v>0.32296258601168598</c:v>
                </c:pt>
                <c:pt idx="10">
                  <c:v>0.31427307386660402</c:v>
                </c:pt>
                <c:pt idx="11">
                  <c:v>0.304183566578487</c:v>
                </c:pt>
                <c:pt idx="12">
                  <c:v>-0.305100256607931</c:v>
                </c:pt>
                <c:pt idx="13">
                  <c:v>-0.32091663507243401</c:v>
                </c:pt>
                <c:pt idx="14">
                  <c:v>-0.35917797171292498</c:v>
                </c:pt>
                <c:pt idx="15">
                  <c:v>-0.36068774620248201</c:v>
                </c:pt>
                <c:pt idx="16">
                  <c:v>-0.39302770594649999</c:v>
                </c:pt>
                <c:pt idx="17">
                  <c:v>-0.39508065548841897</c:v>
                </c:pt>
                <c:pt idx="18">
                  <c:v>-0.39520294671970801</c:v>
                </c:pt>
                <c:pt idx="19">
                  <c:v>-0.427362086213119</c:v>
                </c:pt>
                <c:pt idx="20">
                  <c:v>-0.44176034618866</c:v>
                </c:pt>
                <c:pt idx="21">
                  <c:v>-0.457809085612986</c:v>
                </c:pt>
                <c:pt idx="22">
                  <c:v>-0.48253604784314902</c:v>
                </c:pt>
                <c:pt idx="23">
                  <c:v>-0.49107356588850498</c:v>
                </c:pt>
                <c:pt idx="24">
                  <c:v>-0.49268066730048599</c:v>
                </c:pt>
                <c:pt idx="25">
                  <c:v>-0.49857164874249899</c:v>
                </c:pt>
                <c:pt idx="26">
                  <c:v>-0.49907051613873099</c:v>
                </c:pt>
                <c:pt idx="27">
                  <c:v>-0.51015840283007596</c:v>
                </c:pt>
                <c:pt idx="28">
                  <c:v>-0.51676282985415301</c:v>
                </c:pt>
                <c:pt idx="29">
                  <c:v>-0.51906379636483702</c:v>
                </c:pt>
                <c:pt idx="30">
                  <c:v>-0.52457543246994798</c:v>
                </c:pt>
                <c:pt idx="31">
                  <c:v>-0.540391574675533</c:v>
                </c:pt>
                <c:pt idx="32">
                  <c:v>-0.54191128767193097</c:v>
                </c:pt>
                <c:pt idx="33">
                  <c:v>-0.55075547889853005</c:v>
                </c:pt>
                <c:pt idx="34">
                  <c:v>-0.56934527737551299</c:v>
                </c:pt>
                <c:pt idx="35">
                  <c:v>-0.57382162778212698</c:v>
                </c:pt>
                <c:pt idx="36">
                  <c:v>-0.58489006619788197</c:v>
                </c:pt>
                <c:pt idx="37">
                  <c:v>-0.61514796841406605</c:v>
                </c:pt>
                <c:pt idx="38">
                  <c:v>-0.63143580888404904</c:v>
                </c:pt>
                <c:pt idx="39">
                  <c:v>-0.64312621520122404</c:v>
                </c:pt>
                <c:pt idx="40">
                  <c:v>-0.65497994016234795</c:v>
                </c:pt>
                <c:pt idx="41">
                  <c:v>-0.73977650322100696</c:v>
                </c:pt>
                <c:pt idx="42">
                  <c:v>-0.74059629703310903</c:v>
                </c:pt>
                <c:pt idx="43">
                  <c:v>-0.78881172737730998</c:v>
                </c:pt>
                <c:pt idx="44">
                  <c:v>-0.80119607248352198</c:v>
                </c:pt>
                <c:pt idx="45">
                  <c:v>-0.83789733007553902</c:v>
                </c:pt>
                <c:pt idx="46">
                  <c:v>-0.84222988164514601</c:v>
                </c:pt>
                <c:pt idx="47">
                  <c:v>-0.84489424354245901</c:v>
                </c:pt>
                <c:pt idx="48">
                  <c:v>-0.89333865327322803</c:v>
                </c:pt>
                <c:pt idx="49">
                  <c:v>-0.90299417034062501</c:v>
                </c:pt>
                <c:pt idx="50">
                  <c:v>-0.90882093459180902</c:v>
                </c:pt>
                <c:pt idx="51">
                  <c:v>-0.91731949214465103</c:v>
                </c:pt>
                <c:pt idx="52">
                  <c:v>-0.92748349958209497</c:v>
                </c:pt>
                <c:pt idx="53">
                  <c:v>-0.96585171599966702</c:v>
                </c:pt>
                <c:pt idx="54">
                  <c:v>-0.97558055063068205</c:v>
                </c:pt>
                <c:pt idx="55">
                  <c:v>-1.0082493056242099</c:v>
                </c:pt>
                <c:pt idx="56">
                  <c:v>-1.0251242006761001</c:v>
                </c:pt>
                <c:pt idx="57">
                  <c:v>-1.0785218268749299</c:v>
                </c:pt>
                <c:pt idx="58">
                  <c:v>-1.1538992278823801</c:v>
                </c:pt>
                <c:pt idx="59">
                  <c:v>-1.2831227292817899</c:v>
                </c:pt>
                <c:pt idx="60">
                  <c:v>-1.32197832696754</c:v>
                </c:pt>
                <c:pt idx="61">
                  <c:v>-1.36392080409206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11792392"/>
        <c:axId val="311790040"/>
        <c:axId val="0"/>
      </c:bar3DChart>
      <c:catAx>
        <c:axId val="3117923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1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1790040"/>
        <c:crosses val="autoZero"/>
        <c:auto val="1"/>
        <c:lblAlgn val="ctr"/>
        <c:lblOffset val="100"/>
        <c:tickLblSkip val="1"/>
        <c:noMultiLvlLbl val="0"/>
      </c:catAx>
      <c:valAx>
        <c:axId val="311790040"/>
        <c:scaling>
          <c:orientation val="minMax"/>
          <c:max val="1.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</a:rPr>
                  <a:t>Log2</a:t>
                </a:r>
                <a:r>
                  <a:rPr lang="en-US" sz="1200" b="1" baseline="0">
                    <a:solidFill>
                      <a:sysClr val="windowText" lastClr="000000"/>
                    </a:solidFill>
                  </a:rPr>
                  <a:t> Fold Expression Changes</a:t>
                </a:r>
                <a:endParaRPr lang="en-US" sz="1200" b="1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1792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6126</cdr:x>
      <cdr:y>0.31871</cdr:y>
    </cdr:from>
    <cdr:to>
      <cdr:x>0.78063</cdr:x>
      <cdr:y>0.4236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863102" y="2002890"/>
          <a:ext cx="1900719" cy="6592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28 down-regulated </a:t>
          </a:r>
        </a:p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cancer driver genes</a:t>
          </a:r>
        </a:p>
      </cdr:txBody>
    </cdr:sp>
  </cdr:relSizeAnchor>
  <cdr:relSizeAnchor xmlns:cdr="http://schemas.openxmlformats.org/drawingml/2006/chartDrawing">
    <cdr:from>
      <cdr:x>0.25883</cdr:x>
      <cdr:y>0.69737</cdr:y>
    </cdr:from>
    <cdr:to>
      <cdr:x>0.47826</cdr:x>
      <cdr:y>0.78874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242620" y="4382498"/>
          <a:ext cx="1901290" cy="5742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6 up-regulated </a:t>
          </a:r>
        </a:p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cancer driver genes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336</cdr:x>
      <cdr:y>0.35831</cdr:y>
    </cdr:from>
    <cdr:to>
      <cdr:x>0.75296</cdr:x>
      <cdr:y>0.4632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623371" y="2251753"/>
          <a:ext cx="1900719" cy="6592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50 down-regulated </a:t>
          </a:r>
        </a:p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cancer driver genes</a:t>
          </a:r>
        </a:p>
      </cdr:txBody>
    </cdr:sp>
  </cdr:relSizeAnchor>
  <cdr:relSizeAnchor xmlns:cdr="http://schemas.openxmlformats.org/drawingml/2006/chartDrawing">
    <cdr:from>
      <cdr:x>0.23116</cdr:x>
      <cdr:y>0.73697</cdr:y>
    </cdr:from>
    <cdr:to>
      <cdr:x>0.45059</cdr:x>
      <cdr:y>0.82834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002889" y="4631361"/>
          <a:ext cx="1901290" cy="5742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12 up-regulated </a:t>
          </a:r>
        </a:p>
        <a:p xmlns:a="http://schemas.openxmlformats.org/drawingml/2006/main">
          <a:pPr algn="ctr"/>
          <a:r>
            <a:rPr lang="en-US" sz="1600" b="1">
              <a:solidFill>
                <a:sysClr val="windowText" lastClr="000000"/>
              </a:solidFill>
            </a:rPr>
            <a:t>cancer driver genes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2408301" y="1103503"/>
            <a:ext cx="7375397" cy="23304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b="0" i="0">
                <a:solidFill>
                  <a:schemeClr val="tx1"/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727073" y="3974414"/>
            <a:ext cx="8737853" cy="106870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36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0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40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 sz="1800" b="1" i="0">
                <a:solidFill>
                  <a:srgbClr val="FF0000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0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40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0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Only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3479459" y="76518"/>
            <a:ext cx="5242647" cy="6733655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40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0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0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1036142" y="47624"/>
            <a:ext cx="10119715" cy="1732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40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78307" y="3141980"/>
            <a:ext cx="11035385" cy="3425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800" b="1" i="0">
                <a:solidFill>
                  <a:srgbClr val="FF0000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0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5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5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5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5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5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5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195616"/>
              </p:ext>
            </p:extLst>
          </p:nvPr>
        </p:nvGraphicFramePr>
        <p:xfrm>
          <a:off x="762000" y="4191000"/>
          <a:ext cx="10515600" cy="12420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57401"/>
                <a:gridCol w="4452257"/>
                <a:gridCol w="2002971"/>
                <a:gridCol w="2002971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>
                          <a:effectLst/>
                        </a:rPr>
                        <a:t>Statistical </a:t>
                      </a:r>
                      <a:r>
                        <a:rPr lang="en-US" sz="2000" b="1" u="none" strike="noStrike" dirty="0" smtClean="0">
                          <a:effectLst/>
                        </a:rPr>
                        <a:t>cut-off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Number of significant differentially expressed genes (DEGS)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Up-regulated DEGs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Down-regulated DEGs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p &lt; 0.05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3673 genes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2085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1588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577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 err="1" smtClean="0">
                          <a:effectLst/>
                        </a:rPr>
                        <a:t>Padj</a:t>
                      </a:r>
                      <a:r>
                        <a:rPr lang="en-US" sz="2000" b="1" u="none" strike="noStrike" dirty="0" smtClean="0">
                          <a:effectLst/>
                        </a:rPr>
                        <a:t> </a:t>
                      </a:r>
                      <a:r>
                        <a:rPr lang="en-US" sz="2000" b="1" u="none" strike="noStrike" dirty="0">
                          <a:effectLst/>
                        </a:rPr>
                        <a:t>&lt; 0.05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 smtClean="0">
                          <a:effectLst/>
                        </a:rPr>
                        <a:t>1397 </a:t>
                      </a:r>
                      <a:r>
                        <a:rPr lang="en-US" sz="2000" b="1" u="none" strike="noStrike" dirty="0">
                          <a:effectLst/>
                        </a:rPr>
                        <a:t>genes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>
                          <a:effectLst/>
                        </a:rPr>
                        <a:t>764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1" u="none" strike="noStrike" dirty="0">
                          <a:effectLst/>
                        </a:rPr>
                        <a:t>633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3" name="object 2"/>
          <p:cNvSpPr txBox="1"/>
          <p:nvPr/>
        </p:nvSpPr>
        <p:spPr>
          <a:xfrm>
            <a:off x="457200" y="304800"/>
            <a:ext cx="11277599" cy="3301032"/>
          </a:xfrm>
          <a:prstGeom prst="rect">
            <a:avLst/>
          </a:prstGeom>
        </p:spPr>
        <p:txBody>
          <a:bodyPr vert="horz" wrap="square" lIns="0" tIns="94615" rIns="0" bIns="0" rtlCol="0">
            <a:spAutoFit/>
          </a:bodyPr>
          <a:lstStyle/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sz="4400" b="0" spc="-5" dirty="0">
                <a:latin typeface="Arial" panose="020B0604020202020204" pitchFamily="34" charset="0"/>
                <a:cs typeface="Arial" panose="020B0604020202020204" pitchFamily="34" charset="0"/>
              </a:rPr>
              <a:t>fb-PMT </a:t>
            </a:r>
            <a:r>
              <a:rPr sz="4400" b="0" spc="-60" dirty="0" smtClean="0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en-US" sz="4400" b="0" spc="-6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sz="4400" b="0" spc="-6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4400" b="0" spc="-5" dirty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sz="4400" b="0" spc="-15" dirty="0"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sz="4400" b="0" spc="-25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sz="4400" b="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endParaRPr lang="en-US" sz="4400" b="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sz="4400" b="0" dirty="0" smtClean="0">
                <a:latin typeface="Arial" panose="020B0604020202020204" pitchFamily="34" charset="0"/>
                <a:cs typeface="Arial" panose="020B0604020202020204" pitchFamily="34" charset="0"/>
              </a:rPr>
              <a:t>U87 </a:t>
            </a:r>
            <a:r>
              <a:rPr lang="en-US" sz="4400" b="0" dirty="0" smtClean="0">
                <a:latin typeface="Arial" panose="020B0604020202020204" pitchFamily="34" charset="0"/>
                <a:cs typeface="Arial" panose="020B0604020202020204" pitchFamily="34" charset="0"/>
              </a:rPr>
              <a:t>human </a:t>
            </a:r>
            <a:r>
              <a:rPr lang="en-US" sz="4400" dirty="0" smtClean="0">
                <a:latin typeface="Arial" panose="020B0604020202020204" pitchFamily="34" charset="0"/>
                <a:cs typeface="Arial" panose="020B0604020202020204" pitchFamily="34" charset="0"/>
              </a:rPr>
              <a:t>glioblastoma</a:t>
            </a:r>
            <a:r>
              <a:rPr lang="en-US" sz="4400" b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4400" b="0" spc="-10" dirty="0" smtClean="0">
                <a:latin typeface="Arial" panose="020B0604020202020204" pitchFamily="34" charset="0"/>
                <a:cs typeface="Arial" panose="020B0604020202020204" pitchFamily="34" charset="0"/>
              </a:rPr>
              <a:t>cells  </a:t>
            </a:r>
            <a:endParaRPr lang="en-US" sz="4400" b="0" spc="-1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endParaRPr lang="en-US" sz="4400" b="0" spc="-1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lang="en-US" sz="4000" spc="-1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of </a:t>
            </a:r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sz="4000" b="0" spc="-20" dirty="0" smtClean="0">
                <a:latin typeface="Arial" panose="020B0604020202020204" pitchFamily="34" charset="0"/>
                <a:cs typeface="Arial" panose="020B0604020202020204" pitchFamily="34" charset="0"/>
              </a:rPr>
              <a:t>-regulated</a:t>
            </a:r>
            <a:r>
              <a:rPr sz="4000" b="0" spc="-55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4000" b="0" spc="-15" dirty="0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en-US" sz="4000" b="0" spc="-15" dirty="0" smtClean="0">
                <a:latin typeface="Arial" panose="020B0604020202020204" pitchFamily="34" charset="0"/>
                <a:cs typeface="Arial" panose="020B0604020202020204" pitchFamily="34" charset="0"/>
              </a:rPr>
              <a:t> identified by the RNA-seq expression profiling experiments</a:t>
            </a:r>
            <a:endParaRPr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50718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Grp="1"/>
          </p:cNvGraphicFramePr>
          <p:nvPr>
            <p:extLst/>
          </p:nvPr>
        </p:nvGraphicFramePr>
        <p:xfrm>
          <a:off x="76201" y="685797"/>
          <a:ext cx="12039598" cy="579567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762375"/>
                <a:gridCol w="632593"/>
                <a:gridCol w="7644630"/>
              </a:tblGrid>
              <a:tr h="122421">
                <a:tc>
                  <a:txBody>
                    <a:bodyPr/>
                    <a:lstStyle/>
                    <a:p>
                      <a:pPr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erm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89535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P-value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Genes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483034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050" dirty="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5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NGF Homo sapiens</a:t>
                      </a:r>
                      <a:r>
                        <a:rPr sz="1000" b="1" spc="-1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166520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31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5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1.05E-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31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61514" marR="12065" indent="-1951355" algn="ctr">
                        <a:lnSpc>
                          <a:spcPct val="100000"/>
                        </a:lnSpc>
                        <a:spcBef>
                          <a:spcPts val="10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HLPP2;TRIO;PHLPP1;AHCYL1;PRDM4;IRS1;ITPR3;ADCY7;DUSP16;EGFR;CRKL;AKAP13;SPRED2;BCL2L11;PSMD5;PRKAR2A;PIP4K2A;MAPK1</a:t>
                      </a: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1961514" marR="12065" indent="-1951355" algn="ctr">
                        <a:lnSpc>
                          <a:spcPct val="100000"/>
                        </a:lnSpc>
                        <a:spcBef>
                          <a:spcPts val="105"/>
                        </a:spcBef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SPTBN1;JAK1;PLEKHG2;PDPK1;PRKCE;A 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HGEF17;FN1;PRKCA;MTOR;TIAM1;ADAM17;GDNF;AGO4;AGO1;AGO2;ARHGEF7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133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32748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35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PDGF Homo sapiens</a:t>
                      </a:r>
                      <a:r>
                        <a:rPr sz="1000" b="1" spc="-1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18679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5.54E-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HLPP2;AHCYL1;PHLPP1;IRS1;ITPR3;THBS2;ADCY7;DUSP16;THBS1;EGFR;CRKL;SPRED2;PSMD5;PRKAR2A;PIP4K2A;MAPK1;SPTBN1;JAK1;PDPK1</a:t>
                      </a: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RKCE;FN1;PRKCA;MTOR;GDNF;AGO4;AGO1;AGO2;COL6A3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Pre-NOTCH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Transcription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and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Translation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1000" b="1" spc="-9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191240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4.26E-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2;CREBBP;CCND1;MAML1;AGO4;AGO1;AGO2;EP300;MAMLD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399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EGFR Homo sapiens</a:t>
                      </a:r>
                      <a:r>
                        <a:rPr sz="1000" b="1" spc="-1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17792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3.40E-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PRKCA;MTOR;ADAM17;GDNF;AGO4;AGO1;AGO2;ADAM12;ARHGEF7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FGFR3</a:t>
                      </a:r>
                      <a:r>
                        <a:rPr sz="10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708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5.30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FGFR Homo sapiens</a:t>
                      </a:r>
                      <a:r>
                        <a:rPr sz="1000" b="1" spc="-1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190236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4.50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RBFOX2;PDPK1;PRKCE;FN1;PRKCA;MTOR;GDNF;AGO4;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GO1;AGO2;VC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FGFR1</a:t>
                      </a:r>
                      <a:r>
                        <a:rPr sz="10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687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6.14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FGFR4</a:t>
                      </a:r>
                      <a:r>
                        <a:rPr sz="10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716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5.30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FGFR1 Homo sapiens</a:t>
                      </a:r>
                      <a:r>
                        <a:rPr sz="10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736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2.78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RKCA;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0"/>
                        </a:lnSpc>
                        <a:spcBef>
                          <a:spcPts val="5"/>
                        </a:spcBef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FGFR2</a:t>
                      </a:r>
                      <a:r>
                        <a:rPr sz="10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69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0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5.30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</a:t>
                      </a: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MTOR;GDNF;AGO4;AGO1;AGO2;</a:t>
                      </a:r>
                      <a:r>
                        <a:rPr sz="1000" b="1" dirty="0" smtClean="0">
                          <a:latin typeface="Calibri"/>
                          <a:cs typeface="Calibri"/>
                        </a:rPr>
                        <a:t>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Pre-NOTCH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and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Processing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1912422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6.97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2;CREBBP;CCND1;MAML1;AGO4;AGO1;AGO2;EP300;MAMLD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39757">
                <a:tc>
                  <a:txBody>
                    <a:bodyPr/>
                    <a:lstStyle/>
                    <a:p>
                      <a:pPr marL="1270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YAP1-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and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WWTR1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(TAZ)-stimulated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gene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1000" b="1" spc="-6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2032785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2.62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ELZ2;CREBBP;NCOA6;TBL1X;PPARA;RUNX2;HIPK2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FGFR3 Homo sapiens</a:t>
                      </a:r>
                      <a:r>
                        <a:rPr sz="10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74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2.38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RKCA;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39757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EGFR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interacts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ith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phospholipase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C-gamma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21271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7.86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HCYL1;PRKAR2A;PRKCE;ITPR3;PRKCA;ADCY7;EGF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FGFR2 Homo sapiens</a:t>
                      </a:r>
                      <a:r>
                        <a:rPr sz="10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73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3.55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CBL;ADCY7;DUSP16;EGFR;SPRED2;PSMD5;PRKAR2A;PIP4K2A;MAPK1;SPTBN1;JAK1;RBFOX2;PDPK1;PRKCE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FN1;PRKCA;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57093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FGFR4 Homo sapiens</a:t>
                      </a:r>
                      <a:r>
                        <a:rPr sz="10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-HSA-5654743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2.26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RKCA;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y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NOTCH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1000" b="1" spc="-10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157118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1.32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2;CREBBP;MAML1;NEURL1B;ADAM17;CCND1;AGO4;AGO1;AGO2;NUMB;EP300;TBL1X;MAMLD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87079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 dirty="0">
                        <a:latin typeface="Times New Roman"/>
                        <a:cs typeface="Times New Roman"/>
                      </a:endParaRPr>
                    </a:p>
                    <a:p>
                      <a:pPr marL="635" algn="ctr">
                        <a:lnSpc>
                          <a:spcPts val="905"/>
                        </a:lnSpc>
                        <a:spcBef>
                          <a:spcPts val="5"/>
                        </a:spcBef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NGF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ling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via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TRKA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from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the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plasma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membrane</a:t>
                      </a:r>
                      <a:r>
                        <a:rPr sz="10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187037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 algn="ctr">
                        <a:lnSpc>
                          <a:spcPts val="905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1.62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HLPP2;AHCYL1;PHLPP1;IRS1;ITPR3;ADCY7;DUSP16;EGFR;CRKL;SPRED2;PSMD5;PRKAR2A;PIP4K2A;MAPK1;SPTBN1;JAK1;PDPK1;PRKCE;FN1;</a:t>
                      </a:r>
                      <a:endParaRPr lang="en-US" sz="1000" b="1" spc="-5" dirty="0" smtClean="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5"/>
                        </a:lnSpc>
                      </a:pPr>
                      <a:r>
                        <a:rPr sz="1000" b="1" spc="-5" dirty="0" smtClean="0">
                          <a:latin typeface="Calibri"/>
                          <a:cs typeface="Calibri"/>
                        </a:rPr>
                        <a:t>PRKCA;MTOR;GDNF;AGO4;AGO1;AGO2;VCL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1000" b="1" dirty="0">
                          <a:latin typeface="Calibri"/>
                          <a:cs typeface="Calibri"/>
                        </a:rPr>
                        <a:t>Nuclear</a:t>
                      </a:r>
                      <a:r>
                        <a:rPr sz="10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Envelope</a:t>
                      </a:r>
                      <a:r>
                        <a:rPr sz="10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Breakdown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10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0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R-HSA-298076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1.84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marR="3175" algn="ctr">
                        <a:lnSpc>
                          <a:spcPts val="8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UP214;NEK9;NUP205;NUP188;NUP155;PRKCA;NUP98;LPIN2</a:t>
                      </a:r>
                      <a:endParaRPr sz="1000" dirty="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</a:tbl>
          </a:graphicData>
        </a:graphic>
      </p:graphicFrame>
      <p:sp>
        <p:nvSpPr>
          <p:cNvPr id="3" name="object 3"/>
          <p:cNvSpPr txBox="1"/>
          <p:nvPr/>
        </p:nvSpPr>
        <p:spPr>
          <a:xfrm>
            <a:off x="3382771" y="17780"/>
            <a:ext cx="5532629" cy="25904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600" b="1" spc="-10" dirty="0">
                <a:latin typeface="Calibri"/>
                <a:cs typeface="Calibri"/>
              </a:rPr>
              <a:t>Reactome </a:t>
            </a:r>
            <a:r>
              <a:rPr sz="1600" b="1" dirty="0">
                <a:latin typeface="Calibri"/>
                <a:cs typeface="Calibri"/>
              </a:rPr>
              <a:t>2016 </a:t>
            </a:r>
            <a:r>
              <a:rPr sz="1600" b="1" spc="-5" dirty="0" smtClean="0">
                <a:latin typeface="Calibri"/>
                <a:cs typeface="Calibri"/>
              </a:rPr>
              <a:t>(</a:t>
            </a:r>
            <a:r>
              <a:rPr lang="en-US" sz="1600" b="1" spc="-5" dirty="0" smtClean="0">
                <a:latin typeface="Calibri"/>
                <a:cs typeface="Calibri"/>
              </a:rPr>
              <a:t>selected </a:t>
            </a:r>
            <a:r>
              <a:rPr sz="1600" b="1" spc="-5" dirty="0" smtClean="0">
                <a:latin typeface="Calibri"/>
                <a:cs typeface="Calibri"/>
              </a:rPr>
              <a:t>significantly </a:t>
            </a:r>
            <a:r>
              <a:rPr sz="1600" b="1" spc="-15" dirty="0">
                <a:latin typeface="Calibri"/>
                <a:cs typeface="Calibri"/>
              </a:rPr>
              <a:t>affected</a:t>
            </a:r>
            <a:r>
              <a:rPr sz="1600" b="1" spc="-20" dirty="0">
                <a:latin typeface="Calibri"/>
                <a:cs typeface="Calibri"/>
              </a:rPr>
              <a:t> </a:t>
            </a:r>
            <a:r>
              <a:rPr sz="1600" b="1" spc="-15" dirty="0">
                <a:latin typeface="Calibri"/>
                <a:cs typeface="Calibri"/>
              </a:rPr>
              <a:t>pathways)</a:t>
            </a:r>
            <a:endParaRPr sz="1600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6717264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Grp="1"/>
          </p:cNvGraphicFramePr>
          <p:nvPr/>
        </p:nvGraphicFramePr>
        <p:xfrm>
          <a:off x="131673" y="595630"/>
          <a:ext cx="11861798" cy="59626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32860"/>
                <a:gridCol w="497204"/>
                <a:gridCol w="7531734"/>
              </a:tblGrid>
              <a:tr h="122300">
                <a:tc>
                  <a:txBody>
                    <a:bodyPr/>
                    <a:lstStyle/>
                    <a:p>
                      <a:pPr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Term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89535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P-value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Genes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6390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5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NGF Homo sapiens</a:t>
                      </a:r>
                      <a:r>
                        <a:rPr sz="800" b="1" spc="-1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166520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31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90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5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05E-0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31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61514" marR="12065" indent="-1951355">
                        <a:lnSpc>
                          <a:spcPct val="100000"/>
                        </a:lnSpc>
                        <a:spcBef>
                          <a:spcPts val="10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TRIO;PHLPP1;AHCYL1;PRDM4;IRS1;ITPR3;ADCY7;DUSP16;EGFR;CRKL;AKAP13;SPRED2;BCL2L11;PSMD5;PRKAR2A;PIP4K2A;MAPK1;SPTBN1;JAK1;PLEKHG2;PDPK1;PRKCE;A  RHGEF17;FN1;PRKCA;MTOR;TIAM1;ADAM17;GDNF;AGO4;AGO1;AGO2;ARHGEF7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133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3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PDGF Homo sapiens</a:t>
                      </a:r>
                      <a:r>
                        <a:rPr sz="800" b="1" spc="-1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86797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5.54E-0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THBS2;ADCY7;DUSP16;THBS1;EGFR;CRKL;SPRED2;PSMD5;PRKAR2A;PIP4K2A;MAPK1;SPTBN1;JAK1;PDPK1;PRKCE;FN1;PRKCA;MTOR;GDNF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4;AGO1;AGO2;COL6A3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7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Pre-NOTCH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Transcription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and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Translation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9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191240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4.26E-0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NOTCH2;CREBBP;CCND1;MAML1;AGO4;AGO1;AGO2;EP300;MAMLD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EGFR Homo sapiens</a:t>
                      </a:r>
                      <a:r>
                        <a:rPr sz="800" b="1" spc="-1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77929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3.40E-0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PRKCA;MTOR;ADAM17;GDNF;AGO4;A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GO1;AGO2;ADAM12;ARHGEF7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1002">
                <a:tc>
                  <a:txBody>
                    <a:bodyPr/>
                    <a:lstStyle/>
                    <a:p>
                      <a:pPr marL="2540" algn="ctr">
                        <a:lnSpc>
                          <a:spcPts val="915"/>
                        </a:lnSpc>
                        <a:spcBef>
                          <a:spcPts val="17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Chromatin modifying enzymes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 R-HSA-3247509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222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915"/>
                        </a:lnSpc>
                        <a:spcBef>
                          <a:spcPts val="17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3.60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222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915"/>
                        </a:lnSpc>
                        <a:spcBef>
                          <a:spcPts val="17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KMT2D;KDM5B;SMARCC1;CREBBP;KDM3B;KMT2A;TRRAP;BRPF3;ARID1A;ARID1B;CCND1;YEATS2;KANSL1;NSD1;KAT6A;EP400;EP300;TBL1X;WHSC1;RCOR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222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FGFR3</a:t>
                      </a:r>
                      <a:r>
                        <a:rPr sz="8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70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5.30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MTOR;GDNF;AGO4;AGO1;AGO2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FGFR Homo sapiens</a:t>
                      </a:r>
                      <a:r>
                        <a:rPr sz="800" b="1" spc="-1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9023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4.50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RBFOX2;PDPK1;PRKCE;FN1;PRKCA;MTOR;GDNF;AGO4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1;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34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FGFR1</a:t>
                      </a:r>
                      <a:r>
                        <a:rPr sz="8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687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6.14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MTOR;GDNF;AGO4;AGO1;AGO2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00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ctivation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gene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8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REBF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(SREBP)</a:t>
                      </a:r>
                      <a:r>
                        <a:rPr sz="8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242616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4.39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HELZ2;CREBBP;NFYA;NCOA6;SP1;TBL1X;PPARA;ACACA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34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FGFR4</a:t>
                      </a:r>
                      <a:r>
                        <a:rPr sz="8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71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5.30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MTOR;GDNF;AGO4;AGO1;AGO2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00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PPARA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ctivates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 gene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8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98978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5.96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CREBBP;NFYA;NCOA6;NCOA3;MED13L;HELZ2;MED12;SP1;EP300;TBL1X;RGL1;PPARA;PPARGC1B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1002">
                <a:tc>
                  <a:txBody>
                    <a:bodyPr/>
                    <a:lstStyle/>
                    <a:p>
                      <a:pPr marL="2540" algn="ctr">
                        <a:lnSpc>
                          <a:spcPts val="910"/>
                        </a:lnSpc>
                        <a:spcBef>
                          <a:spcPts val="17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Chromatin organization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9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483972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222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910"/>
                        </a:lnSpc>
                        <a:spcBef>
                          <a:spcPts val="17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3.60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222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910"/>
                        </a:lnSpc>
                        <a:spcBef>
                          <a:spcPts val="17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KMT2D;KDM5B;SMARCC1;CREBBP;KDM3B;KMT2A;TRRAP;BRPF3;ARID1A;ARID1B;CCND1;YEATS2;KANSL1;NSD1;KAT6A;EP400;EP300;TBL1X;WHSC1;RCOR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222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FGFR1 Homo sapiens</a:t>
                      </a:r>
                      <a:r>
                        <a:rPr sz="8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73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2.78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PRKCA;MTOR;GDNF;AGO4;AGO1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910"/>
                        </a:lnSpc>
                        <a:spcBef>
                          <a:spcPts val="5"/>
                        </a:spcBef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Downstream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ctivated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FGFR2</a:t>
                      </a:r>
                      <a:r>
                        <a:rPr sz="8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69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5.30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MTOR;GDNF;AGO4;AGO1;AGO2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635" marR="3175" algn="ctr">
                        <a:lnSpc>
                          <a:spcPts val="910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7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Non-integrin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membrane-ECM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interactions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1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300017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4.39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LAMA1;LAMA3;TNC;PRKCA;LAMC1;THBS1;HSPG2;DDR2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00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Pre-NOTCH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and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Processing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912422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6.97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NOTCH2;CREBBP;CCND1;MAML1;AGO4;AGO1;AGO2;EP300;MAMLD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34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910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Downstream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transduction Homo sapiens</a:t>
                      </a:r>
                      <a:r>
                        <a:rPr sz="800" b="1" spc="-1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186763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3.57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CRKL;SPRED2;PSMD5;PRKAR2A;PIP4K2A;MAPK1;SPTBN1;JAK1;PDPK1;PRKCE;FN1;PRKCA;MTOR;GDNF;AGO4;AGO1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1270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00">
                <a:tc>
                  <a:txBody>
                    <a:bodyPr/>
                    <a:lstStyle/>
                    <a:p>
                      <a:pPr marL="1270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YAP1-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and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WWTR1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(TAZ)-stimulated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gene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800" b="1" spc="-6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203278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2.62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HELZ2;CREBBP;NCOA6;TBL1X;PPARA;RUNX2;HIPK2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FGFR3 Homo sapiens</a:t>
                      </a:r>
                      <a:r>
                        <a:rPr sz="8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74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2.38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PRKCA;MTOR;GDNF;AGO4;AGO1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428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EGFR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interacts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with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phospholipase</a:t>
                      </a:r>
                      <a:r>
                        <a:rPr sz="8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C-gamma</a:t>
                      </a:r>
                      <a:r>
                        <a:rPr sz="8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21271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7.86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HCYL1;PRKAR2A;PRKCE;ITPR3;PRKCA;ADCY7;EGFR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FGFR2 Homo sapiens</a:t>
                      </a:r>
                      <a:r>
                        <a:rPr sz="8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73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3.55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RBFOX2;PDPK1;PRKCE;FN1;PRKCA;MTOR;GDNF;AGO4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1;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20">
                <a:tc>
                  <a:txBody>
                    <a:bodyPr/>
                    <a:lstStyle/>
                    <a:p>
                      <a:pPr marL="63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Regulation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of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 lipid</a:t>
                      </a:r>
                      <a:r>
                        <a:rPr sz="800" b="1" spc="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metabolism</a:t>
                      </a:r>
                      <a:r>
                        <a:rPr sz="8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Peroxisome</a:t>
                      </a:r>
                      <a:r>
                        <a:rPr sz="8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proliferator-activated</a:t>
                      </a:r>
                      <a:r>
                        <a:rPr sz="8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eceptor</a:t>
                      </a:r>
                      <a:r>
                        <a:rPr sz="8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lpha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2540" algn="ctr">
                        <a:lnSpc>
                          <a:spcPts val="90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(PPARalpha) Homo sapiens</a:t>
                      </a:r>
                      <a:r>
                        <a:rPr sz="800" b="1" spc="-8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40020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0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82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R="3810" algn="ctr">
                        <a:lnSpc>
                          <a:spcPts val="90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CREBBP;NFYA;NCOA6;NCOA3;MED13L;HELZ2;MED12;SP1;SIN3A;EP300;TBL1X;RGL1;PPARA;PPARGC1B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34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FGFR4 Homo sapiens</a:t>
                      </a:r>
                      <a:r>
                        <a:rPr sz="800" b="1" spc="-1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5654743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2.26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CBL;ADCY7;DUSP16;EGFR;SPRED2;PSMD5;PRKAR2A;PIP4K2A;MAPK1;SPTBN1;JAK1;PDPK1;PRKCE;FN1;PRKCA;MTOR;GDNF;AGO4;AGO1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1905" marR="3175" algn="ctr">
                        <a:lnSpc>
                          <a:spcPts val="910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2973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910"/>
                        </a:lnSpc>
                        <a:spcBef>
                          <a:spcPts val="66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Developmental Biology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114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26673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80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10"/>
                        </a:lnSpc>
                        <a:spcBef>
                          <a:spcPts val="66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9.74E-05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90830" marR="109220" indent="-182880">
                        <a:lnSpc>
                          <a:spcPct val="100000"/>
                        </a:lnSpc>
                        <a:spcBef>
                          <a:spcPts val="62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EMA5A;KMT2D;TRIO;PAXIP1;IRS1;EPAS1;LAMA1;LAMC1;ACVR1B;DUSP16;EGFR;ARHGAP35;MED12;HELZ2;EFNB2;SPRED2;PSMD5;ABL2;PLXNA1;EP300;MAPK1;TBL1X;NEO1;  SPTBN1;CLASP1;JAK1;CDON;CREBBP;SMAD3;CSNK2A1;TSC22D1;NCOA6;NCOA3;FN1;MED13L;TIAM1;GDNF;SCN8A;NUMB;KCNQ3;COL6A3;PPARA;ARHGEF7;MET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793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79197">
                <a:tc>
                  <a:txBody>
                    <a:bodyPr/>
                    <a:lstStyle/>
                    <a:p>
                      <a:pPr marL="635" algn="ctr">
                        <a:lnSpc>
                          <a:spcPts val="910"/>
                        </a:lnSpc>
                        <a:spcBef>
                          <a:spcPts val="400"/>
                        </a:spcBef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DAP12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1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242449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080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910"/>
                        </a:lnSpc>
                        <a:spcBef>
                          <a:spcPts val="400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08E-04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080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910"/>
                        </a:lnSpc>
                        <a:spcBef>
                          <a:spcPts val="400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SPRED2;PSMD5;PRKAR2A;PIP4K2A;MAPK1;SPTBN1;JAK1;PDPK1;PRKCE;FN1;PRKCA;MTOR;GDNF;AGO4;AGO1;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5080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5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y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NOTCH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10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57118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32E-04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NOTCH2;CREBBP;MAML1;NEURL1B;ADAM17;CCND1;AGO4;AGO1;AGO2;NUMB;EP300;TBL1X;MAMLD1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39">
                <a:tc>
                  <a:txBody>
                    <a:bodyPr/>
                    <a:lstStyle/>
                    <a:p>
                      <a:pPr marL="635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RORA</a:t>
                      </a:r>
                      <a:r>
                        <a:rPr sz="8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activates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 gene</a:t>
                      </a:r>
                      <a:r>
                        <a:rPr sz="8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xpression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368082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65E-04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HELZ2;CREBBP;NCOA6;EP300;TBL1X;PPARA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5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Circadian Clock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8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R-HSA-400253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55E-04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HELZ2;PER2;RAI1;CREBBP;NCOA6;EP300;TBL1X;BTRC;PPARA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427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35" algn="ctr">
                        <a:lnSpc>
                          <a:spcPts val="905"/>
                        </a:lnSpc>
                        <a:spcBef>
                          <a:spcPts val="5"/>
                        </a:spcBef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NGF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signalling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via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TRKA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spc="-5" dirty="0">
                          <a:latin typeface="Calibri"/>
                          <a:cs typeface="Calibri"/>
                        </a:rPr>
                        <a:t>from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the</a:t>
                      </a:r>
                      <a:r>
                        <a:rPr sz="8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plasma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membrane</a:t>
                      </a:r>
                      <a:r>
                        <a:rPr sz="8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187037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750">
                        <a:latin typeface="Times New Roman"/>
                        <a:cs typeface="Times New Roman"/>
                      </a:endParaRPr>
                    </a:p>
                    <a:p>
                      <a:pPr marL="65405">
                        <a:lnSpc>
                          <a:spcPts val="905"/>
                        </a:lnSpc>
                        <a:spcBef>
                          <a:spcPts val="5"/>
                        </a:spcBef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62E-04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marR="3175" algn="ctr">
                        <a:lnSpc>
                          <a:spcPts val="91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PHLPP2;AHCYL1;PHLPP1;IRS1;ITPR3;ADCY7;DUSP16;EGFR;CRKL;SPRED2;PSMD5;PRKAR2A;PIP4K2A;MAPK1;SPTBN1;JAK1;PDPK1;PRKCE;FN1;PRKCA;MTOR;GDNF;AGO4;AGO1;</a:t>
                      </a:r>
                      <a:endParaRPr sz="800">
                        <a:latin typeface="Calibri"/>
                        <a:cs typeface="Calibri"/>
                      </a:endParaRPr>
                    </a:p>
                    <a:p>
                      <a:pPr marL="1270" marR="3175" algn="ctr">
                        <a:lnSpc>
                          <a:spcPts val="90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AGO2;VCL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22351">
                <a:tc>
                  <a:txBody>
                    <a:bodyPr/>
                    <a:lstStyle/>
                    <a:p>
                      <a:pPr marL="2540" algn="ctr">
                        <a:lnSpc>
                          <a:spcPts val="865"/>
                        </a:lnSpc>
                      </a:pPr>
                      <a:r>
                        <a:rPr sz="800" b="1" dirty="0">
                          <a:latin typeface="Calibri"/>
                          <a:cs typeface="Calibri"/>
                        </a:rPr>
                        <a:t>Nuclear</a:t>
                      </a:r>
                      <a:r>
                        <a:rPr sz="8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Envelope</a:t>
                      </a:r>
                      <a:r>
                        <a:rPr sz="8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Breakdown</a:t>
                      </a:r>
                      <a:r>
                        <a:rPr sz="8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Homo</a:t>
                      </a:r>
                      <a:r>
                        <a:rPr sz="800" b="1" spc="-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8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800" b="1" dirty="0">
                          <a:latin typeface="Calibri"/>
                          <a:cs typeface="Calibri"/>
                        </a:rPr>
                        <a:t>R-HSA-2980766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5405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1.84E-04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marR="3175" algn="ctr">
                        <a:lnSpc>
                          <a:spcPts val="865"/>
                        </a:lnSpc>
                      </a:pPr>
                      <a:r>
                        <a:rPr sz="800" b="1" spc="-5" dirty="0">
                          <a:latin typeface="Calibri"/>
                          <a:cs typeface="Calibri"/>
                        </a:rPr>
                        <a:t>NUP214;NEK9;NUP205;NUP188;NUP155;PRKCA;NUP98;LPIN2</a:t>
                      </a:r>
                      <a:endParaRPr sz="8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</a:tbl>
          </a:graphicData>
        </a:graphic>
      </p:graphicFrame>
      <p:sp>
        <p:nvSpPr>
          <p:cNvPr id="3" name="object 3"/>
          <p:cNvSpPr txBox="1"/>
          <p:nvPr/>
        </p:nvSpPr>
        <p:spPr>
          <a:xfrm>
            <a:off x="3382771" y="17780"/>
            <a:ext cx="526224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Reactome </a:t>
            </a:r>
            <a:r>
              <a:rPr sz="1800" b="1" dirty="0">
                <a:latin typeface="Calibri"/>
                <a:cs typeface="Calibri"/>
              </a:rPr>
              <a:t>2016 </a:t>
            </a:r>
            <a:r>
              <a:rPr sz="1800" b="1" spc="-5" dirty="0">
                <a:latin typeface="Calibri"/>
                <a:cs typeface="Calibri"/>
              </a:rPr>
              <a:t>(top </a:t>
            </a:r>
            <a:r>
              <a:rPr sz="1800" b="1" dirty="0">
                <a:latin typeface="Calibri"/>
                <a:cs typeface="Calibri"/>
              </a:rPr>
              <a:t>30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</a:t>
            </a:r>
            <a:r>
              <a:rPr sz="1800" b="1" spc="-20" dirty="0">
                <a:latin typeface="Calibri"/>
                <a:cs typeface="Calibri"/>
              </a:rPr>
              <a:t> </a:t>
            </a:r>
            <a:r>
              <a:rPr sz="1800" b="1" spc="-15" dirty="0">
                <a:latin typeface="Calibri"/>
                <a:cs typeface="Calibri"/>
              </a:rPr>
              <a:t>pathways)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390657" y="560831"/>
            <a:ext cx="2734040" cy="611124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432690" y="590887"/>
            <a:ext cx="5992293" cy="598100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908930" y="578611"/>
            <a:ext cx="1598930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NCI-Nature</a:t>
            </a:r>
            <a:r>
              <a:rPr sz="1800" b="1" spc="-95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2016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3023616" y="425965"/>
            <a:ext cx="6111239" cy="273404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>
            <a:spLocks noGrp="1"/>
          </p:cNvSpPr>
          <p:nvPr>
            <p:ph type="title"/>
          </p:nvPr>
        </p:nvSpPr>
        <p:spPr>
          <a:xfrm>
            <a:off x="3226689" y="23876"/>
            <a:ext cx="590867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NCI-Nature </a:t>
            </a:r>
            <a:r>
              <a:rPr sz="1800" b="1" dirty="0">
                <a:latin typeface="Calibri"/>
                <a:cs typeface="Calibri"/>
              </a:rPr>
              <a:t>2016 </a:t>
            </a:r>
            <a:r>
              <a:rPr sz="1800" b="1" spc="-10" dirty="0">
                <a:latin typeface="Calibri"/>
                <a:cs typeface="Calibri"/>
              </a:rPr>
              <a:t>(examples </a:t>
            </a:r>
            <a:r>
              <a:rPr sz="1800" b="1" dirty="0">
                <a:latin typeface="Calibri"/>
                <a:cs typeface="Calibri"/>
              </a:rPr>
              <a:t>of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</a:t>
            </a:r>
            <a:r>
              <a:rPr sz="1800" b="1" spc="-40" dirty="0">
                <a:latin typeface="Calibri"/>
                <a:cs typeface="Calibri"/>
              </a:rPr>
              <a:t> </a:t>
            </a:r>
            <a:r>
              <a:rPr sz="1800" b="1" spc="-15" dirty="0">
                <a:latin typeface="Calibri"/>
                <a:cs typeface="Calibri"/>
              </a:rPr>
              <a:t>pathways)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165352" y="3235833"/>
            <a:ext cx="10291445" cy="308546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8232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Integrins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in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angiogenesis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omo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apiens</a:t>
            </a:r>
            <a:r>
              <a:rPr sz="1800" b="1" spc="-10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2ddeac89-6194-11e5-8ac5-06603eb7f303</a:t>
            </a:r>
            <a:endParaRPr sz="1800">
              <a:latin typeface="Calibri"/>
              <a:cs typeface="Calibri"/>
            </a:endParaRPr>
          </a:p>
          <a:p>
            <a:pPr marR="455930" algn="ctr">
              <a:lnSpc>
                <a:spcPct val="100000"/>
              </a:lnSpc>
              <a:spcBef>
                <a:spcPts val="70"/>
              </a:spcBef>
            </a:pPr>
            <a:r>
              <a:rPr sz="1800" b="1" i="1" spc="-5" dirty="0">
                <a:latin typeface="Calibri"/>
                <a:cs typeface="Calibri"/>
              </a:rPr>
              <a:t>IRS1;COL12A1;COL5A2;FN1;COL6A3;MAPK1;CBL;VCL;IGF1R;TGFBR2</a:t>
            </a:r>
            <a:endParaRPr sz="1800">
              <a:latin typeface="Calibri"/>
              <a:cs typeface="Calibri"/>
            </a:endParaRPr>
          </a:p>
          <a:p>
            <a:pPr marR="454659" algn="ctr">
              <a:lnSpc>
                <a:spcPct val="100000"/>
              </a:lnSpc>
              <a:spcBef>
                <a:spcPts val="745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Beta1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integrin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cell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surface interactions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omo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apiens</a:t>
            </a:r>
            <a:r>
              <a:rPr sz="1800" b="1" spc="-3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2fd0bc63-618d-11e5-8ac5-06603eb7f303</a:t>
            </a:r>
            <a:endParaRPr sz="1800">
              <a:latin typeface="Calibri"/>
              <a:cs typeface="Calibri"/>
            </a:endParaRPr>
          </a:p>
          <a:p>
            <a:pPr marR="457834" algn="ctr">
              <a:lnSpc>
                <a:spcPct val="100000"/>
              </a:lnSpc>
              <a:spcBef>
                <a:spcPts val="155"/>
              </a:spcBef>
            </a:pPr>
            <a:r>
              <a:rPr sz="1800" b="1" i="1" spc="-5" dirty="0">
                <a:latin typeface="Calibri"/>
                <a:cs typeface="Calibri"/>
              </a:rPr>
              <a:t>LAMA1;LAMA3;COL5A2;TNC;FN1;COL6A3;LAMC1;THBS2;THBS1;FBN1</a:t>
            </a:r>
            <a:endParaRPr sz="1800">
              <a:latin typeface="Calibri"/>
              <a:cs typeface="Calibri"/>
            </a:endParaRPr>
          </a:p>
          <a:p>
            <a:pPr marR="228600" algn="ctr">
              <a:lnSpc>
                <a:spcPct val="100000"/>
              </a:lnSpc>
              <a:spcBef>
                <a:spcPts val="665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Notch signaling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800" b="1" spc="-8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88f83518-6194-11e5-8ac5-06603eb7f303</a:t>
            </a:r>
            <a:endParaRPr sz="1800">
              <a:latin typeface="Calibri"/>
              <a:cs typeface="Calibri"/>
            </a:endParaRPr>
          </a:p>
          <a:p>
            <a:pPr marR="561340" algn="ctr">
              <a:lnSpc>
                <a:spcPct val="100000"/>
              </a:lnSpc>
              <a:spcBef>
                <a:spcPts val="65"/>
              </a:spcBef>
            </a:pPr>
            <a:r>
              <a:rPr sz="1800" b="1" i="1" spc="-5" dirty="0">
                <a:latin typeface="Calibri"/>
                <a:cs typeface="Calibri"/>
              </a:rPr>
              <a:t>NOTCH2;SPEN;CCND1;MAML1;ADAM12;NUMB;EP300;PSEN1;CBL</a:t>
            </a:r>
            <a:endParaRPr sz="1800">
              <a:latin typeface="Calibri"/>
              <a:cs typeface="Calibri"/>
            </a:endParaRPr>
          </a:p>
          <a:p>
            <a:pPr algn="ctr">
              <a:lnSpc>
                <a:spcPts val="2160"/>
              </a:lnSpc>
              <a:spcBef>
                <a:spcPts val="670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Hedgehog signaling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events mediated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by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Gli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proteins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omo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apiens</a:t>
            </a:r>
            <a:r>
              <a:rPr sz="1800" b="1" spc="1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153b6970-6193-11e5-8ac5-06603eb7f303</a:t>
            </a:r>
            <a:endParaRPr sz="1800">
              <a:latin typeface="Calibri"/>
              <a:cs typeface="Calibri"/>
            </a:endParaRPr>
          </a:p>
          <a:p>
            <a:pPr marR="260350" algn="ctr">
              <a:lnSpc>
                <a:spcPts val="2160"/>
              </a:lnSpc>
            </a:pPr>
            <a:r>
              <a:rPr sz="1800" b="1" i="1" spc="-5" dirty="0">
                <a:latin typeface="Calibri"/>
                <a:cs typeface="Calibri"/>
              </a:rPr>
              <a:t>CREBBP;SIN3A;FBXW11;PTCH1;GLI3;GLI2;CSNK1G1</a:t>
            </a:r>
            <a:endParaRPr sz="1800">
              <a:latin typeface="Calibri"/>
              <a:cs typeface="Calibri"/>
            </a:endParaRPr>
          </a:p>
          <a:p>
            <a:pPr marL="6985" algn="ctr">
              <a:lnSpc>
                <a:spcPts val="2160"/>
              </a:lnSpc>
              <a:spcBef>
                <a:spcPts val="130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events mediated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by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VEGFR1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and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VEGFR2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800" b="1" spc="2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d6f6ae1f-6195-11e5-8ac5-06603eb7f303</a:t>
            </a:r>
            <a:endParaRPr sz="1800">
              <a:latin typeface="Calibri"/>
              <a:cs typeface="Calibri"/>
            </a:endParaRPr>
          </a:p>
          <a:p>
            <a:pPr marR="475615" algn="ctr">
              <a:lnSpc>
                <a:spcPts val="2160"/>
              </a:lnSpc>
            </a:pPr>
            <a:r>
              <a:rPr sz="1800" b="1" i="1" spc="-10" dirty="0">
                <a:latin typeface="Calibri"/>
                <a:cs typeface="Calibri"/>
              </a:rPr>
              <a:t>FBXW11;PDPK1;MYOF;GRB10;MAPK1;PTPRJ;PRKCA;CBL;VCL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3891788" y="20827"/>
            <a:ext cx="437832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Calibri"/>
                <a:cs typeface="Calibri"/>
              </a:rPr>
              <a:t>NCI-Nature 2016 (top </a:t>
            </a:r>
            <a:r>
              <a:rPr sz="1400" b="1" dirty="0">
                <a:latin typeface="Calibri"/>
                <a:cs typeface="Calibri"/>
              </a:rPr>
              <a:t>40 of </a:t>
            </a:r>
            <a:r>
              <a:rPr sz="1400" b="1" spc="-5" dirty="0">
                <a:latin typeface="Calibri"/>
                <a:cs typeface="Calibri"/>
              </a:rPr>
              <a:t>significantly </a:t>
            </a:r>
            <a:r>
              <a:rPr sz="1400" b="1" spc="-10" dirty="0">
                <a:latin typeface="Calibri"/>
                <a:cs typeface="Calibri"/>
              </a:rPr>
              <a:t>affected</a:t>
            </a:r>
            <a:r>
              <a:rPr sz="1400" b="1" spc="-60" dirty="0">
                <a:latin typeface="Calibri"/>
                <a:cs typeface="Calibri"/>
              </a:rPr>
              <a:t> </a:t>
            </a:r>
            <a:r>
              <a:rPr sz="1400" b="1" spc="-10" dirty="0">
                <a:latin typeface="Calibri"/>
                <a:cs typeface="Calibri"/>
              </a:rPr>
              <a:t>pathways)</a:t>
            </a:r>
            <a:endParaRPr sz="1400">
              <a:latin typeface="Calibri"/>
              <a:cs typeface="Calibri"/>
            </a:endParaRPr>
          </a:p>
        </p:txBody>
      </p:sp>
      <p:graphicFrame>
        <p:nvGraphicFramePr>
          <p:cNvPr id="3" name="object 3"/>
          <p:cNvGraphicFramePr>
            <a:graphicFrameLocks noGrp="1"/>
          </p:cNvGraphicFramePr>
          <p:nvPr/>
        </p:nvGraphicFramePr>
        <p:xfrm>
          <a:off x="261061" y="301370"/>
          <a:ext cx="11706224" cy="645095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54875"/>
                <a:gridCol w="750570"/>
                <a:gridCol w="3700779"/>
              </a:tblGrid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erm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-value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Genes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yndecan-4-mediated signaling events Homo sapiens</a:t>
                      </a:r>
                      <a:r>
                        <a:rPr sz="1000" b="1" spc="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076bc549-6196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4.17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LAMA1;LAMA3;ADAM12;TNC;FN1;PRKCA;THBS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pathway Homo sapiens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88f83518-6194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9.20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2;SPEN;CCND1;MAML1;ADAM12;NUMB;EP300;PSEN1;CB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ntegrins in angiogenesis Homo sapiens</a:t>
                      </a:r>
                      <a:r>
                        <a:rPr sz="1000" b="1" spc="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2ddeac89-6194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8.60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RS1;COL12A1;COL5A2;FN1;COL6A3;MAPK1;CBL;VCL;IGF1R;TGFBR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5227"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40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Beta1 integrin cell surface interactions Homo sapiens</a:t>
                      </a:r>
                      <a:r>
                        <a:rPr sz="10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2fd0bc63-618d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60"/>
                        </a:lnSpc>
                        <a:spcBef>
                          <a:spcPts val="40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4.01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40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LAMA1;LAMA3;COL5A2;TNC;FN1;COL6A3;LAMC1;THBS2;THBS1;FB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FN-gamma pathway Homo sapiens 51b1ed75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2.31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EP300;MAPK1;CBL;MTOR;CRKL;JA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events mediated by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VEGFR1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VEGFR2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1000" b="1" spc="1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d6f6ae1f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2.80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BXW11;PDPK1;MYOF;GRB10;MAPK1;PTPRJ;PRKCA;CBL;VC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edgehog signaling events mediated by Gli proteins Homo sapiens</a:t>
                      </a:r>
                      <a:r>
                        <a:rPr sz="1000" b="1" spc="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153b6970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6.44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SIN3A;FBXW11;PTCH1;GLI3;GLI2;CSNK1G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events mediated by Hepatocyte Growth Factor Receptor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(c-Met)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1000" b="1" spc="1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c39d2b9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7.14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DPK1;NUMB;MAPK1;PTPRJ;CBL;ETS1;MET;MTOR;CRK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IF-2-alpha transcription factor network Homo sapiens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37358832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6.20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EPAS1;SP1;EP300;ARNT;ETS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6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L4-mediated signaling events Homo sapiens</a:t>
                      </a:r>
                      <a:r>
                        <a:rPr sz="1000" b="1" spc="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cff33f50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5.77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BCL6;IRS1;SP1;CBL;ETS1;MTOR;JAK1;IL13RA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68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  <a:spcBef>
                          <a:spcPts val="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Direct p53 effectors Homo sapiens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67c3b75d-6191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ts val="1160"/>
                        </a:lnSpc>
                        <a:spcBef>
                          <a:spcPts val="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3.88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905" algn="ctr">
                        <a:lnSpc>
                          <a:spcPts val="114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APAF1;NFYA;TRRAP;HTT;EGFR;BCL6;SP1;TP53BP2;EP300;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marL="1905"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DROSHA;PMS2;MET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egulation of RhoA activity Homo sapiens</a:t>
                      </a:r>
                      <a:r>
                        <a:rPr sz="10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49ece019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5.63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KAP13;FARP1;ARHGEF10;TRIO;OPHN1;ARHGEF17;ARHGAP3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events mediated by focal adhesion kinase Homo sapiens</a:t>
                      </a:r>
                      <a:r>
                        <a:rPr sz="1000" b="1" spc="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8fb80085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4.57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GIT2;CCND1;PTPN21;MAPK1;ARHGEF7;ETS1;ARHGAP35;VC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oregulation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rogen receptor activity Homo sapiens</a:t>
                      </a:r>
                      <a:r>
                        <a:rPr sz="10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27e0e369-6191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2540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5.14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VIL;HIP1;LATS2;CCND1;ZMIZ1;NCOA6;PRKDC;ZNF31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events mediated by Stem cell factor receptor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(c-Kit)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1000" b="1" spc="6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c6b6861c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19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PRED2;CREBBP;PDPK1;GRB10;CBL;SH2B3;CRK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6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-MYB transcription factor network Homo sapiens</a:t>
                      </a:r>
                      <a:r>
                        <a:rPr sz="10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61020228-618e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12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KI;CREBBP;CCND1;MAT2A;SIN3A;SP1;EP300;ETS1;HIPK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ole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Calcineurin-dependent NFAT signaling in lymphocytes Homo sapiens</a:t>
                      </a:r>
                      <a:r>
                        <a:rPr sz="1000" b="1" spc="9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61bdd46d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3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UP214;CREBBP;CSNK2A1;PRKCE;EP300;NFATC2;PRKCA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etinoic acid receptors-mediated signaling Homo sapiens</a:t>
                      </a:r>
                      <a:r>
                        <a:rPr sz="1000" b="1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5797691b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67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NCOA3;EP300;MAPK1;PRKCA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GF1 pathway Homo sapiens</a:t>
                      </a:r>
                      <a:r>
                        <a:rPr sz="10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5e904cd6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67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RS1;PDPK1;GRB10;IGF1R;CRK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Beta3 integrin cell surface interactions Homo sapiens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c2800165-618d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20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NC;FN1;LAMC1;THBS1;TGFBR2;FB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6b1 and a6b4 Integrin signaling Homo sapiens</a:t>
                      </a:r>
                      <a:r>
                        <a:rPr sz="10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73d1a893-6186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79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LAMA1;LAMA3;PRKCA;LAMC1;MET;EGF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resenilin action in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Notch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Wnt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Homo sapiens</a:t>
                      </a:r>
                      <a:r>
                        <a:rPr sz="1000" b="1" spc="10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f51de83a-6194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13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CCND1;CSNK2A1;FBXW11;MAPK1;PSE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oxO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family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Homo sapiens</a:t>
                      </a:r>
                      <a:r>
                        <a:rPr sz="10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d06dbbda-6192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89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BCL2L11;BCL6;EP300;FBXO32;CSNK1G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egulation of nuclear SMAD2/3 signaling Homo sapiens</a:t>
                      </a:r>
                      <a:r>
                        <a:rPr sz="1000" b="1" spc="7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246aac04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407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KI;CREBBP;SMAD3;SIN3A;SP1;EP300;LAMC1;RUNX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yndecan-2-mediated signaling events Homo sapiens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fe05ead7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5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EPB41;LAMA1;LAMA3;FN1;MAP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lpha6 beta4 integrin-ligand interactions Homo sapiens</a:t>
                      </a:r>
                      <a:r>
                        <a:rPr sz="1000" b="1" spc="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01416eb3-6188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43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LAMA1;LAMA3;LAMC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-mediated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HES/HEY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network Homo sapiens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8ee56389-6194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89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PEN;CREBBP;MAML1;EP300;ARNT;RUNX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egulation of nuclear beta catenin signaling and target gene transcription Homo sapiens</a:t>
                      </a:r>
                      <a:r>
                        <a:rPr sz="1000" b="1" spc="7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1590a3b3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48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MED12;CCND1;TRRAP;CHD8;EP300;HBP1;TBL1X;ADCY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IF-1-alpha transcription factor network Homo sapiens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20ef2b81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47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SMAD3;SP1;EP300;ARNT;ETS1;HK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415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Validated transcriptional targets of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AP1 family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members Fra1 and Fra2 Homo sapiens</a:t>
                      </a:r>
                      <a:r>
                        <a:rPr sz="1000" b="1" spc="6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76d028a7-6196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462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CND1;SP1;LAMA3;EP300;NFATC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osttranslational regulation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of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dherens junction stability and dissassembly Homo sapiens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ebb21a59-6194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89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IAM1;CREBBP;GDNF;MET;EGFR;IGF1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egulation of Telomerase Homo sapiens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4dfe97ca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517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MAD3;CCND1;SIN3A;SP1;MAPK1;EGFR;MTO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77"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AP-1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transcription factor network Homo sapiens 3ce2f9c5-6189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1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608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1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BCL2L11;CCND1;SP1;EP300;NFATC2;ETS1;FOSL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27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events regulated by Ret tyrosine kinase Homo sapiens</a:t>
                      </a:r>
                      <a:r>
                        <a:rPr sz="1000" b="1" spc="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e4431190-6195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661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GDNF;IRS1;GRB10;MAPK1;PRKCA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3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CDC42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events Homo sapiens</a:t>
                      </a:r>
                      <a:r>
                        <a:rPr sz="10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50b98ae0-6190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657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IAM1;PRKCE;MAPK1;ARHGEF7;CBL;IQGAP3;MTO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27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GF-beta receptor signaling Homo sapiens</a:t>
                      </a:r>
                      <a:r>
                        <a:rPr sz="1000" b="1" spc="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1f188fcc-6196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698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DAB2;SMAD3;PDPK1;RNF111;SPTBN1;TGFBR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3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VEGFR1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pecific signals Homo sapiens</a:t>
                      </a:r>
                      <a:r>
                        <a:rPr sz="1000" b="1" spc="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8b13143b-6196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977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DPK1;MAPK1;PRKCA;CB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27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GF signaling pathway Homo sapiens</a:t>
                      </a:r>
                      <a:r>
                        <a:rPr sz="1000" b="1" spc="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98ed0df6-6192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1067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DPK1;MAPK1;CBL;MET;RUNX2;SSH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3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IL8-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 CXCR1-mediated signaling events Homo sapiens</a:t>
                      </a:r>
                      <a:r>
                        <a:rPr sz="10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f6a58ef3-6193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1112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PDPK1;PRKCE;PRKCA;CB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329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OXA1 transcription factor network Homo sapiens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aa3927b7-6192-11e5-8ac5-06603eb7f30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1226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SP1;NCOA3;PRDM15;EP300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329697" y="638556"/>
            <a:ext cx="2734040" cy="6041136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597266" y="668266"/>
            <a:ext cx="5809904" cy="591239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800600" y="610994"/>
            <a:ext cx="1808480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KEGG </a:t>
            </a:r>
            <a:r>
              <a:rPr sz="1800" b="1" dirty="0">
                <a:latin typeface="Calibri"/>
                <a:cs typeface="Calibri"/>
              </a:rPr>
              <a:t>2019</a:t>
            </a:r>
            <a:r>
              <a:rPr sz="1800" b="1" spc="-45" dirty="0">
                <a:latin typeface="Calibri"/>
                <a:cs typeface="Calibri"/>
              </a:rPr>
              <a:t> </a:t>
            </a:r>
            <a:r>
              <a:rPr sz="1800" b="1" spc="-5" dirty="0">
                <a:latin typeface="Calibri"/>
                <a:cs typeface="Calibri"/>
              </a:rPr>
              <a:t>Human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797051" y="425965"/>
            <a:ext cx="6042660" cy="273404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>
            <a:spLocks noGrp="1"/>
          </p:cNvSpPr>
          <p:nvPr>
            <p:ph type="title"/>
          </p:nvPr>
        </p:nvSpPr>
        <p:spPr>
          <a:xfrm>
            <a:off x="2879598" y="17780"/>
            <a:ext cx="611441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KEGG </a:t>
            </a:r>
            <a:r>
              <a:rPr sz="1800" b="1" dirty="0">
                <a:latin typeface="Calibri"/>
                <a:cs typeface="Calibri"/>
              </a:rPr>
              <a:t>2019 </a:t>
            </a:r>
            <a:r>
              <a:rPr sz="1800" b="1" spc="-5" dirty="0">
                <a:latin typeface="Calibri"/>
                <a:cs typeface="Calibri"/>
              </a:rPr>
              <a:t>Human </a:t>
            </a:r>
            <a:r>
              <a:rPr sz="1800" b="1" spc="-10" dirty="0">
                <a:latin typeface="Calibri"/>
                <a:cs typeface="Calibri"/>
              </a:rPr>
              <a:t>(examples </a:t>
            </a:r>
            <a:r>
              <a:rPr sz="1800" b="1" dirty="0">
                <a:latin typeface="Calibri"/>
                <a:cs typeface="Calibri"/>
              </a:rPr>
              <a:t>of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</a:t>
            </a:r>
            <a:r>
              <a:rPr sz="1800" b="1" spc="-10" dirty="0">
                <a:latin typeface="Calibri"/>
                <a:cs typeface="Calibri"/>
              </a:rPr>
              <a:t> </a:t>
            </a:r>
            <a:r>
              <a:rPr sz="1800" b="1" spc="-15" dirty="0">
                <a:latin typeface="Calibri"/>
                <a:cs typeface="Calibri"/>
              </a:rPr>
              <a:t>pathways)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629513" y="704784"/>
            <a:ext cx="11130280" cy="5693410"/>
          </a:xfrm>
          <a:prstGeom prst="rect">
            <a:avLst/>
          </a:prstGeom>
        </p:spPr>
        <p:txBody>
          <a:bodyPr vert="horz" wrap="square" lIns="0" tIns="107314" rIns="0" bIns="0" rtlCol="0">
            <a:spAutoFit/>
          </a:bodyPr>
          <a:lstStyle/>
          <a:p>
            <a:pPr marL="4701540" algn="ctr">
              <a:lnSpc>
                <a:spcPct val="100000"/>
              </a:lnSpc>
              <a:spcBef>
                <a:spcPts val="844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Hedgehog signaling</a:t>
            </a:r>
            <a:r>
              <a:rPr sz="1800" b="1" spc="-5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endParaRPr sz="1800">
              <a:latin typeface="Calibri"/>
              <a:cs typeface="Calibri"/>
            </a:endParaRPr>
          </a:p>
          <a:p>
            <a:pPr marL="4727575" algn="ctr">
              <a:lnSpc>
                <a:spcPct val="100000"/>
              </a:lnSpc>
              <a:spcBef>
                <a:spcPts val="750"/>
              </a:spcBef>
            </a:pPr>
            <a:r>
              <a:rPr sz="1800" b="1" i="1" spc="-5" dirty="0">
                <a:latin typeface="Calibri"/>
                <a:cs typeface="Calibri"/>
              </a:rPr>
              <a:t>EVC;CCND1;FBXW11;PTCH1;BTRC;GLI3;GLI2;CDON;CSNK1G1</a:t>
            </a:r>
            <a:endParaRPr sz="1800">
              <a:latin typeface="Calibri"/>
              <a:cs typeface="Calibri"/>
            </a:endParaRPr>
          </a:p>
          <a:p>
            <a:pPr marL="4705985" algn="ctr">
              <a:lnSpc>
                <a:spcPct val="100000"/>
              </a:lnSpc>
              <a:spcBef>
                <a:spcPts val="815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Notch signaling</a:t>
            </a:r>
            <a:r>
              <a:rPr sz="1800" b="1" spc="-5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endParaRPr sz="1800">
              <a:latin typeface="Calibri"/>
              <a:cs typeface="Calibri"/>
            </a:endParaRPr>
          </a:p>
          <a:p>
            <a:pPr marL="4720590" algn="ctr">
              <a:lnSpc>
                <a:spcPct val="100000"/>
              </a:lnSpc>
              <a:spcBef>
                <a:spcPts val="380"/>
              </a:spcBef>
            </a:pPr>
            <a:r>
              <a:rPr sz="1800" b="1" i="1" spc="-5" dirty="0">
                <a:latin typeface="Calibri"/>
                <a:cs typeface="Calibri"/>
              </a:rPr>
              <a:t>NOTCH2;CREBBP;ADAM17;MAML1;NUMB;EP300;PSEN1</a:t>
            </a:r>
            <a:endParaRPr sz="1800">
              <a:latin typeface="Calibri"/>
              <a:cs typeface="Calibri"/>
            </a:endParaRPr>
          </a:p>
          <a:p>
            <a:pPr marL="4715510" algn="ctr">
              <a:lnSpc>
                <a:spcPct val="100000"/>
              </a:lnSpc>
              <a:spcBef>
                <a:spcPts val="290"/>
              </a:spcBef>
            </a:pP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rostate</a:t>
            </a:r>
            <a:r>
              <a:rPr sz="1800" b="1" spc="-2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cancer</a:t>
            </a:r>
            <a:endParaRPr sz="1800">
              <a:latin typeface="Calibri"/>
              <a:cs typeface="Calibri"/>
            </a:endParaRPr>
          </a:p>
          <a:p>
            <a:pPr marL="4867910">
              <a:lnSpc>
                <a:spcPct val="100000"/>
              </a:lnSpc>
              <a:spcBef>
                <a:spcPts val="405"/>
              </a:spcBef>
            </a:pPr>
            <a:r>
              <a:rPr sz="1800" b="1" i="1" spc="-5" dirty="0">
                <a:latin typeface="Calibri"/>
                <a:cs typeface="Calibri"/>
              </a:rPr>
              <a:t>CREBBP;CCND1;PDPK1;CREB3L2;EP300;MAPK1;EGFR;MTOR;IGF1R</a:t>
            </a:r>
            <a:endParaRPr sz="18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35"/>
              </a:spcBef>
            </a:pPr>
            <a:endParaRPr sz="1700">
              <a:latin typeface="Times New Roman"/>
              <a:cs typeface="Times New Roman"/>
            </a:endParaRPr>
          </a:p>
          <a:p>
            <a:pPr marL="96520" algn="ctr">
              <a:lnSpc>
                <a:spcPct val="100000"/>
              </a:lnSpc>
            </a:pP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Thyroid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ormone signaling</a:t>
            </a:r>
            <a:r>
              <a:rPr sz="1800" b="1" spc="-9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endParaRPr sz="1800">
              <a:latin typeface="Calibri"/>
              <a:cs typeface="Calibri"/>
            </a:endParaRPr>
          </a:p>
          <a:p>
            <a:pPr marR="175260" algn="ctr">
              <a:lnSpc>
                <a:spcPct val="100000"/>
              </a:lnSpc>
              <a:spcBef>
                <a:spcPts val="155"/>
              </a:spcBef>
            </a:pPr>
            <a:r>
              <a:rPr sz="1800" b="1" i="1" spc="-5" dirty="0">
                <a:latin typeface="Calibri"/>
                <a:cs typeface="Calibri"/>
              </a:rPr>
              <a:t>NOTCH2;CREBBP;PDPK1;NCOA3;PRKCA;MTOR;MED13L;MED12;CCND1;SIN3A;EP300;MAPK1;SLC16A2</a:t>
            </a:r>
            <a:endParaRPr sz="1800">
              <a:latin typeface="Calibri"/>
              <a:cs typeface="Calibri"/>
            </a:endParaRPr>
          </a:p>
          <a:p>
            <a:pPr marR="130810" algn="ctr">
              <a:lnSpc>
                <a:spcPct val="100000"/>
              </a:lnSpc>
              <a:spcBef>
                <a:spcPts val="220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PI3K-Akt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signaling</a:t>
            </a:r>
            <a:r>
              <a:rPr sz="1800" b="1" spc="-4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endParaRPr sz="1800">
              <a:latin typeface="Calibri"/>
              <a:cs typeface="Calibri"/>
            </a:endParaRPr>
          </a:p>
          <a:p>
            <a:pPr marL="12065" marR="31115" algn="ctr">
              <a:lnSpc>
                <a:spcPct val="100000"/>
              </a:lnSpc>
              <a:spcBef>
                <a:spcPts val="455"/>
              </a:spcBef>
            </a:pPr>
            <a:r>
              <a:rPr sz="1800" b="1" i="1" spc="-5" dirty="0">
                <a:latin typeface="Calibri"/>
                <a:cs typeface="Calibri"/>
              </a:rPr>
              <a:t>PHLPP2;MAGI1;PHLPP1;IRS1;PDPK1;LAMA1;LAMA3;FN1;TNC;PRKCA;LAMC1;OSMR;THBS2;THBS1;EGFR;MTOR;IGF1R;  BCL2L11;CCND1;CREB3L2;COL6A3;MAPK1;MET;JAK1</a:t>
            </a:r>
            <a:endParaRPr sz="1800">
              <a:latin typeface="Calibri"/>
              <a:cs typeface="Calibri"/>
            </a:endParaRPr>
          </a:p>
          <a:p>
            <a:pPr marR="91440" algn="ctr">
              <a:lnSpc>
                <a:spcPct val="100000"/>
              </a:lnSpc>
              <a:spcBef>
                <a:spcPts val="175"/>
              </a:spcBef>
            </a:pPr>
            <a:r>
              <a:rPr sz="1800" b="1" spc="-20" dirty="0">
                <a:solidFill>
                  <a:srgbClr val="FF0000"/>
                </a:solidFill>
                <a:latin typeface="Calibri"/>
                <a:cs typeface="Calibri"/>
              </a:rPr>
              <a:t>Wnt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ignaling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endParaRPr sz="1800">
              <a:latin typeface="Calibri"/>
              <a:cs typeface="Calibri"/>
            </a:endParaRPr>
          </a:p>
          <a:p>
            <a:pPr marL="176530" algn="ctr">
              <a:lnSpc>
                <a:spcPct val="100000"/>
              </a:lnSpc>
              <a:spcBef>
                <a:spcPts val="414"/>
              </a:spcBef>
            </a:pPr>
            <a:r>
              <a:rPr sz="1800" b="1" i="1" spc="-10" dirty="0">
                <a:latin typeface="Calibri"/>
                <a:cs typeface="Calibri"/>
              </a:rPr>
              <a:t>CREBBP;SMAD3;CSNK2A1;FBXW11;CHD8;NFATC2;PRKCA;PSEN1;VANGL1;ZNRF3;CCND1;EP300;TBL1X;BTRC</a:t>
            </a:r>
            <a:endParaRPr sz="1800">
              <a:latin typeface="Calibri"/>
              <a:cs typeface="Calibri"/>
            </a:endParaRPr>
          </a:p>
          <a:p>
            <a:pPr marL="109855" algn="ctr">
              <a:lnSpc>
                <a:spcPct val="100000"/>
              </a:lnSpc>
              <a:spcBef>
                <a:spcPts val="290"/>
              </a:spcBef>
            </a:pP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HIF-1 signaling</a:t>
            </a:r>
            <a:r>
              <a:rPr sz="1800" b="1" spc="-4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endParaRPr sz="1800">
              <a:latin typeface="Calibri"/>
              <a:cs typeface="Calibri"/>
            </a:endParaRPr>
          </a:p>
          <a:p>
            <a:pPr marL="2971800">
              <a:lnSpc>
                <a:spcPct val="100000"/>
              </a:lnSpc>
              <a:spcBef>
                <a:spcPts val="254"/>
              </a:spcBef>
            </a:pPr>
            <a:r>
              <a:rPr sz="1800" b="1" i="1" spc="-10" dirty="0">
                <a:latin typeface="Calibri"/>
                <a:cs typeface="Calibri"/>
              </a:rPr>
              <a:t>CREBBP;EP300;ARNT;MAPK1;PRKCA;HK2;EGFR;MTOR;IGF1R</a:t>
            </a:r>
            <a:endParaRPr sz="1800">
              <a:latin typeface="Calibri"/>
              <a:cs typeface="Calibri"/>
            </a:endParaRPr>
          </a:p>
          <a:p>
            <a:pPr marL="112395" algn="ctr">
              <a:lnSpc>
                <a:spcPct val="100000"/>
              </a:lnSpc>
              <a:spcBef>
                <a:spcPts val="260"/>
              </a:spcBef>
            </a:pP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Pancreatic</a:t>
            </a:r>
            <a:r>
              <a:rPr sz="1800" b="1" spc="-3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cancer</a:t>
            </a:r>
            <a:endParaRPr sz="1800">
              <a:latin typeface="Calibri"/>
              <a:cs typeface="Calibri"/>
            </a:endParaRPr>
          </a:p>
          <a:p>
            <a:pPr marL="172085" algn="ctr">
              <a:lnSpc>
                <a:spcPct val="100000"/>
              </a:lnSpc>
              <a:spcBef>
                <a:spcPts val="305"/>
              </a:spcBef>
            </a:pPr>
            <a:r>
              <a:rPr sz="1800" b="1" i="1" spc="-10" dirty="0">
                <a:latin typeface="Calibri"/>
                <a:cs typeface="Calibri"/>
              </a:rPr>
              <a:t>SMAD3;CCND1;MAPK1;EGFR;MTOR;JAK1;TGFBR2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Grp="1"/>
          </p:cNvGraphicFramePr>
          <p:nvPr/>
        </p:nvGraphicFramePr>
        <p:xfrm>
          <a:off x="261073" y="830580"/>
          <a:ext cx="11741785" cy="523623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22295"/>
                <a:gridCol w="879475"/>
                <a:gridCol w="7740015"/>
              </a:tblGrid>
              <a:tr h="168402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Term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214629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P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v</a:t>
                      </a:r>
                      <a:r>
                        <a:rPr sz="1100" b="1" spc="-10" dirty="0">
                          <a:latin typeface="Calibri"/>
                          <a:cs typeface="Calibri"/>
                        </a:rPr>
                        <a:t>a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l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u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e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Genes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528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Adherens</a:t>
                      </a:r>
                      <a:r>
                        <a:rPr sz="11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juncti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3.61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7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SMAD3;CSNK2A1;PTPRJ;PTPRF;EGFR;IGF1R;TGFBR2;PTPRB;EP300;MAPK1;MET;VCL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3604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28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Focal</a:t>
                      </a:r>
                      <a:r>
                        <a:rPr sz="11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adhesi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R="178435" algn="r">
                        <a:lnSpc>
                          <a:spcPts val="128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1.48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6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marR="3175" algn="ctr">
                        <a:lnSpc>
                          <a:spcPts val="126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DPK1;LAMA1;LAMA3;FN1;TNC;PRKCA;LAMC1;THBS2;THBS1;EGFR;ARHGAP35;CRKL;MYLK;IGF1R;CCND1;COL6A3;MAPK1;TLN2;</a:t>
                      </a:r>
                      <a:endParaRPr sz="1100">
                        <a:latin typeface="Calibri"/>
                        <a:cs typeface="Calibri"/>
                      </a:endParaRPr>
                    </a:p>
                    <a:p>
                      <a:pPr marL="1270" marR="3175" algn="ctr">
                        <a:lnSpc>
                          <a:spcPts val="128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PPP1R12B;MET;VCL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Hedgehog signaling</a:t>
                      </a:r>
                      <a:r>
                        <a:rPr sz="11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1</a:t>
                      </a:r>
                      <a:r>
                        <a:rPr sz="1100" b="1" spc="5" dirty="0">
                          <a:latin typeface="Calibri"/>
                          <a:cs typeface="Calibri"/>
                        </a:rPr>
                        <a:t>.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4</a:t>
                      </a:r>
                      <a:r>
                        <a:rPr sz="1100" b="1" spc="5" dirty="0">
                          <a:latin typeface="Calibri"/>
                          <a:cs typeface="Calibri"/>
                        </a:rPr>
                        <a:t>0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5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EVC;CCND1;FBXW11;PTCH1;BTRC;GLI3;GLI2;CDON;CSNK1G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5420">
                <a:tc>
                  <a:txBody>
                    <a:bodyPr/>
                    <a:lstStyle/>
                    <a:p>
                      <a:pPr algn="ctr">
                        <a:lnSpc>
                          <a:spcPts val="1285"/>
                        </a:lnSpc>
                        <a:spcBef>
                          <a:spcPts val="75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Thyroid hormone signaling</a:t>
                      </a:r>
                      <a:r>
                        <a:rPr sz="11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95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85"/>
                        </a:lnSpc>
                        <a:spcBef>
                          <a:spcPts val="75"/>
                        </a:spcBef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7.84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5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95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85"/>
                        </a:lnSpc>
                        <a:spcBef>
                          <a:spcPts val="75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NOTCH2;CREBBP;PDPK1;NCOA3;PRKCA;MTOR;MED13L;MED12;CCND1;SIN3A;EP300;MAPK1;SLC16A2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95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algn="ctr">
                        <a:lnSpc>
                          <a:spcPts val="1285"/>
                        </a:lnSpc>
                        <a:spcBef>
                          <a:spcPts val="34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roteoglycans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in</a:t>
                      </a:r>
                      <a:r>
                        <a:rPr sz="11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cance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431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85"/>
                        </a:lnSpc>
                        <a:spcBef>
                          <a:spcPts val="340"/>
                        </a:spcBef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7</a:t>
                      </a:r>
                      <a:r>
                        <a:rPr sz="1100" b="1" spc="5" dirty="0">
                          <a:latin typeface="Calibri"/>
                          <a:cs typeface="Calibri"/>
                        </a:rPr>
                        <a:t>.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4</a:t>
                      </a:r>
                      <a:r>
                        <a:rPr sz="1100" b="1" spc="5" dirty="0">
                          <a:latin typeface="Calibri"/>
                          <a:cs typeface="Calibri"/>
                        </a:rPr>
                        <a:t>9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5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431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85"/>
                        </a:lnSpc>
                        <a:spcBef>
                          <a:spcPts val="34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DPK1;PTCH1;FN1;PRKCA;ITPR3;CBL;HSPG2;THBS1;EGFR;MTOR;IGF1R;TIAM1;CCND1;DROSHA;MAPK1;PPP1R12B;MET;CD4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431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3604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28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Human papillomavirus</a:t>
                      </a:r>
                      <a:r>
                        <a:rPr sz="11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infecti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R="178435" algn="r">
                        <a:lnSpc>
                          <a:spcPts val="128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1.46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4445" algn="ctr">
                        <a:lnSpc>
                          <a:spcPts val="126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MAGI1;NOTCH2;CREBBP;MAML1;LAMA1;LAMA3;FN1;TNC;UBR4;PSEN1;LAMC1;THBS2;THBS1;EGFR;MTOR;CCND1;NFX1;TRAF3;CREB</a:t>
                      </a:r>
                      <a:endParaRPr sz="11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128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3L2;ATP6V0A2;EP300;COL6A3;MAPK1;JAK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529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FoxO signaling</a:t>
                      </a:r>
                      <a:r>
                        <a:rPr sz="11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2.90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444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SMAD3;IRS1;PDPK1;FBXO32;EGFR;IGF1R;TGFBR2;BCL2L11;CCND1;BCL6;EP300;MAPK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ECM-receptor</a:t>
                      </a:r>
                      <a:r>
                        <a:rPr sz="11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interacti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2.58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LAMA1;LAMA3;TNC;FN1;COL6A3;LAMC1;THBS2;HSPG2;THBS1;CD4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655">
                <a:tc>
                  <a:txBody>
                    <a:bodyPr/>
                    <a:lstStyle/>
                    <a:p>
                      <a:pPr algn="ctr">
                        <a:lnSpc>
                          <a:spcPts val="123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Ubiquitin mediated</a:t>
                      </a:r>
                      <a:r>
                        <a:rPr sz="11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roteolysis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30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4</a:t>
                      </a:r>
                      <a:r>
                        <a:rPr sz="1100" b="1" spc="5" dirty="0">
                          <a:latin typeface="Calibri"/>
                          <a:cs typeface="Calibri"/>
                        </a:rPr>
                        <a:t>.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1</a:t>
                      </a:r>
                      <a:r>
                        <a:rPr sz="1100" b="1" spc="5" dirty="0">
                          <a:latin typeface="Calibri"/>
                          <a:cs typeface="Calibri"/>
                        </a:rPr>
                        <a:t>6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3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UBE2H;UBE3C;FBXW8;FBXW11;HUWE1;UBE2G1;CBL;MID1;CDC23;HERC2;HERC1;BTRC;ANAPC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3604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28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I3K-Akt signaling</a:t>
                      </a:r>
                      <a:r>
                        <a:rPr sz="11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050">
                        <a:latin typeface="Times New Roman"/>
                        <a:cs typeface="Times New Roman"/>
                      </a:endParaRPr>
                    </a:p>
                    <a:p>
                      <a:pPr marR="178435" algn="r">
                        <a:lnSpc>
                          <a:spcPts val="128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4.12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5080" algn="ctr">
                        <a:lnSpc>
                          <a:spcPts val="126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HLPP2;MAGI1;PHLPP1;IRS1;PDPK1;LAMA1;LAMA3;FN1;TNC;PRKCA;LAMC1;OSMR;THBS2;THBS1;EGFR;MTOR;IGF1R;BCL2L11;CCND1</a:t>
                      </a:r>
                      <a:endParaRPr sz="1100">
                        <a:latin typeface="Calibri"/>
                        <a:cs typeface="Calibri"/>
                      </a:endParaRPr>
                    </a:p>
                    <a:p>
                      <a:pPr marR="3175" algn="ctr">
                        <a:lnSpc>
                          <a:spcPts val="128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;CREB3L2;COL6A3;MAPK1;MET;JAK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TGF-beta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1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5.52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SMAD3;SP1;EP300;MAPK1;ACVR1B;NEO1;THBS1;LTBP1;TGFBR2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5419">
                <a:tc>
                  <a:txBody>
                    <a:bodyPr/>
                    <a:lstStyle/>
                    <a:p>
                      <a:pPr algn="ctr">
                        <a:lnSpc>
                          <a:spcPts val="1285"/>
                        </a:lnSpc>
                        <a:spcBef>
                          <a:spcPts val="75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Wnt signaling</a:t>
                      </a:r>
                      <a:r>
                        <a:rPr sz="11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95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85"/>
                        </a:lnSpc>
                        <a:spcBef>
                          <a:spcPts val="75"/>
                        </a:spcBef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5.10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95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6350" algn="ctr">
                        <a:lnSpc>
                          <a:spcPts val="1285"/>
                        </a:lnSpc>
                        <a:spcBef>
                          <a:spcPts val="75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SMAD3;CSNK2A1;FBXW11;CHD8;NFATC2;PRKCA;PSEN1;VANGL1;ZNRF3;CCND1;EP300;TBL1X;BTRC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95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8684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4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28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athways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in</a:t>
                      </a:r>
                      <a:r>
                        <a:rPr sz="11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cance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1400">
                        <a:latin typeface="Times New Roman"/>
                        <a:cs typeface="Times New Roman"/>
                      </a:endParaRPr>
                    </a:p>
                    <a:p>
                      <a:pPr marR="178435" algn="r">
                        <a:lnSpc>
                          <a:spcPts val="1280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3.96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ct val="100000"/>
                        </a:lnSpc>
                        <a:spcBef>
                          <a:spcPts val="34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NOTCH2;EPAS1;LAMA1;LAMA3;LAMC1;CBL;ADCY7;ETS1;GLI3;EGFR;GLI2;CRKL;IGF1R;BCL2L11;CCND1;EP300;MAPK1;JAK1;IL13RA1;CR</a:t>
                      </a:r>
                      <a:endParaRPr sz="1100">
                        <a:latin typeface="Calibri"/>
                        <a:cs typeface="Calibri"/>
                      </a:endParaRPr>
                    </a:p>
                    <a:p>
                      <a:pPr marR="3810" algn="ctr">
                        <a:lnSpc>
                          <a:spcPts val="1280"/>
                        </a:lnSpc>
                        <a:spcBef>
                          <a:spcPts val="5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EBBP;SMAD3;APAF1;NCOA3;PTCH1;FN1;ARNT;PRKCA;MTOR;TGFBR2;SP1;TRAF3;MET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431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Notch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1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7843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7.33E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-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0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NOTCH2;CREBBP;ADAM17;MAML1;NUMB;EP300;PSEN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Renal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cell</a:t>
                      </a:r>
                      <a:r>
                        <a:rPr sz="11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carcinoma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1472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EPAS1;EP300;ARNT;MAPK1;ETS1;MET;CRKL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2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arathyroid hormone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synthesis, secretion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and</a:t>
                      </a:r>
                      <a:r>
                        <a:rPr sz="1100" b="1" spc="-1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acti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1959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YP27B1;AKAP13;SP1;CREB3L2;MAPK1;PRKCA;ITPR3;ADCY7;RUNX2;EGF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rostate</a:t>
                      </a:r>
                      <a:r>
                        <a:rPr sz="1100" b="1" spc="-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cance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3625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444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CCND1;PDPK1;CREB3L2;EP300;MAPK1;EGFR;MTOR;IGF1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HIF-1 signaling</a:t>
                      </a:r>
                      <a:r>
                        <a:rPr sz="11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pathway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98120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44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EP300;ARNT;MAPK1;PRKCA;HK2;EGFR;MTOR;IGF1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02184">
                <a:tc>
                  <a:txBody>
                    <a:bodyPr/>
                    <a:lstStyle/>
                    <a:p>
                      <a:pPr algn="ctr">
                        <a:lnSpc>
                          <a:spcPts val="1280"/>
                        </a:lnSpc>
                        <a:spcBef>
                          <a:spcPts val="21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Human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T-cell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leukemia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virus 1</a:t>
                      </a:r>
                      <a:r>
                        <a:rPr sz="1100" b="1" spc="-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infecti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2667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80"/>
                        </a:lnSpc>
                        <a:spcBef>
                          <a:spcPts val="210"/>
                        </a:spcBef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4303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2667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6350" algn="ctr">
                        <a:lnSpc>
                          <a:spcPts val="1280"/>
                        </a:lnSpc>
                        <a:spcBef>
                          <a:spcPts val="21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SMAD3;TRRAP;NFATC2;ADCY7;ETS1;TGFBR2;CDC23;CCND1;CREB3L2;EP300;MAPK1;TLN2;ANAPC1;JAK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2667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hosphatidylinositol signaling</a:t>
                      </a:r>
                      <a:r>
                        <a:rPr sz="1100" b="1" spc="-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system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4154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INPP4A;MTMR3;PIP4K2A;OCRL;PRKCA;ITPR3;SYNJ2;MTMR4;DGKI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656">
                <a:tc>
                  <a:txBody>
                    <a:bodyPr/>
                    <a:lstStyle/>
                    <a:p>
                      <a:pPr algn="ctr">
                        <a:lnSpc>
                          <a:spcPts val="123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Hepatitis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B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30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5788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30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CREBBP;SMAD3;APAF1;TRAF3;CREB3L2;EP300;NFATC2;MAPK1;PRKCA;HSPG2;JAK1;TGFBR2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1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Insulin</a:t>
                      </a:r>
                      <a:r>
                        <a:rPr sz="11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resistance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7319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IRS1;PDPK1;PRKCE;GFPT2;CREB3L2;PPARA;PPARGC1B;PTPRF;MTO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579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Hepatocellular</a:t>
                      </a:r>
                      <a:r>
                        <a:rPr sz="11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carcinoma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7315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SMARCC1;SMAD3;CCND1;MAPK1;PRKCA;ARID1A;ARID1B;MET;EGFR;MTOR;IGF1R;TGFBR2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5407">
                <a:tc>
                  <a:txBody>
                    <a:bodyPr/>
                    <a:lstStyle/>
                    <a:p>
                      <a:pPr algn="ctr">
                        <a:lnSpc>
                          <a:spcPts val="1280"/>
                        </a:lnSpc>
                        <a:spcBef>
                          <a:spcPts val="8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Regulation of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actin</a:t>
                      </a:r>
                      <a:r>
                        <a:rPr sz="1100" b="1" spc="-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spc="-5" dirty="0">
                          <a:latin typeface="Calibri"/>
                          <a:cs typeface="Calibri"/>
                        </a:rPr>
                        <a:t>cytoskeleton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1016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80"/>
                        </a:lnSpc>
                        <a:spcBef>
                          <a:spcPts val="80"/>
                        </a:spcBef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8419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1016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810" algn="ctr">
                        <a:lnSpc>
                          <a:spcPts val="1280"/>
                        </a:lnSpc>
                        <a:spcBef>
                          <a:spcPts val="80"/>
                        </a:spcBef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FN1;IQGAP3;EGFR;ARHGAP35;CRKL;MYLK;SSH1;TIAM1;SPATA13;PIP4K2A;MAPK1;ARHGEF7;PPP1R12B;VCL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1016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8402">
                <a:tc>
                  <a:txBody>
                    <a:bodyPr/>
                    <a:lstStyle/>
                    <a:p>
                      <a:pPr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Pancreatic</a:t>
                      </a:r>
                      <a:r>
                        <a:rPr sz="1100" b="1" spc="-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100" b="1" dirty="0">
                          <a:latin typeface="Calibri"/>
                          <a:cs typeface="Calibri"/>
                        </a:rPr>
                        <a:t>cancer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161925" algn="r">
                        <a:lnSpc>
                          <a:spcPts val="1225"/>
                        </a:lnSpc>
                      </a:pPr>
                      <a:r>
                        <a:rPr sz="1100" b="1" dirty="0">
                          <a:latin typeface="Calibri"/>
                          <a:cs typeface="Calibri"/>
                        </a:rPr>
                        <a:t>0.009521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R="3175" algn="ctr">
                        <a:lnSpc>
                          <a:spcPts val="1225"/>
                        </a:lnSpc>
                      </a:pPr>
                      <a:r>
                        <a:rPr sz="1100" b="1" spc="-5" dirty="0">
                          <a:latin typeface="Calibri"/>
                          <a:cs typeface="Calibri"/>
                        </a:rPr>
                        <a:t>SMAD3;CCND1;MAPK1;EGFR;MTOR;JAK1;TGFBR2</a:t>
                      </a:r>
                      <a:endParaRPr sz="11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</a:tbl>
          </a:graphicData>
        </a:graphic>
      </p:graphicFrame>
      <p:sp>
        <p:nvSpPr>
          <p:cNvPr id="3" name="object 3"/>
          <p:cNvSpPr txBox="1">
            <a:spLocks noGrp="1"/>
          </p:cNvSpPr>
          <p:nvPr>
            <p:ph type="title"/>
          </p:nvPr>
        </p:nvSpPr>
        <p:spPr>
          <a:xfrm>
            <a:off x="3166110" y="485089"/>
            <a:ext cx="5828665" cy="3003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KEGG </a:t>
            </a:r>
            <a:r>
              <a:rPr sz="1800" b="1" dirty="0">
                <a:latin typeface="Calibri"/>
                <a:cs typeface="Calibri"/>
              </a:rPr>
              <a:t>2019 Human </a:t>
            </a:r>
            <a:r>
              <a:rPr sz="1800" b="1" spc="-5" dirty="0">
                <a:latin typeface="Calibri"/>
                <a:cs typeface="Calibri"/>
              </a:rPr>
              <a:t>(top </a:t>
            </a:r>
            <a:r>
              <a:rPr sz="1800" b="1" dirty="0">
                <a:latin typeface="Calibri"/>
                <a:cs typeface="Calibri"/>
              </a:rPr>
              <a:t>25 of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</a:t>
            </a:r>
            <a:r>
              <a:rPr sz="1800" b="1" spc="-50" dirty="0">
                <a:latin typeface="Calibri"/>
                <a:cs typeface="Calibri"/>
              </a:rPr>
              <a:t> </a:t>
            </a:r>
            <a:r>
              <a:rPr sz="1800" b="1" spc="-10" dirty="0">
                <a:latin typeface="Calibri"/>
                <a:cs typeface="Calibri"/>
              </a:rPr>
              <a:t>pathways)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364749" y="405383"/>
            <a:ext cx="2734040" cy="625754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182754" y="436158"/>
            <a:ext cx="5963713" cy="612418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876801" y="423417"/>
            <a:ext cx="1469008" cy="289823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Panther</a:t>
            </a:r>
            <a:r>
              <a:rPr sz="1800" b="1" spc="-85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2016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37743" y="404599"/>
            <a:ext cx="6257544" cy="2732577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504545" y="34543"/>
            <a:ext cx="4982210" cy="26924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15" dirty="0">
                <a:latin typeface="Calibri"/>
                <a:cs typeface="Calibri"/>
              </a:rPr>
              <a:t>Panther </a:t>
            </a:r>
            <a:r>
              <a:rPr sz="1600" b="1" spc="-10" dirty="0">
                <a:latin typeface="Calibri"/>
                <a:cs typeface="Calibri"/>
              </a:rPr>
              <a:t>2016 (examples </a:t>
            </a:r>
            <a:r>
              <a:rPr sz="1600" b="1" spc="-5" dirty="0">
                <a:latin typeface="Calibri"/>
                <a:cs typeface="Calibri"/>
              </a:rPr>
              <a:t>of significantly </a:t>
            </a:r>
            <a:r>
              <a:rPr sz="1600" b="1" spc="-15" dirty="0">
                <a:latin typeface="Calibri"/>
                <a:cs typeface="Calibri"/>
              </a:rPr>
              <a:t>affected</a:t>
            </a:r>
            <a:r>
              <a:rPr sz="1600" b="1" spc="160" dirty="0">
                <a:latin typeface="Calibri"/>
                <a:cs typeface="Calibri"/>
              </a:rPr>
              <a:t> </a:t>
            </a:r>
            <a:r>
              <a:rPr sz="1600" b="1" spc="-15" dirty="0">
                <a:latin typeface="Calibri"/>
                <a:cs typeface="Calibri"/>
              </a:rPr>
              <a:t>pathways)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6707505" y="43585"/>
            <a:ext cx="5178425" cy="3104515"/>
          </a:xfrm>
          <a:prstGeom prst="rect">
            <a:avLst/>
          </a:prstGeom>
        </p:spPr>
        <p:txBody>
          <a:bodyPr vert="horz" wrap="square" lIns="0" tIns="49530" rIns="0" bIns="0" rtlCol="0">
            <a:spAutoFit/>
          </a:bodyPr>
          <a:lstStyle/>
          <a:p>
            <a:pPr marR="436880" algn="ctr">
              <a:lnSpc>
                <a:spcPct val="100000"/>
              </a:lnSpc>
              <a:spcBef>
                <a:spcPts val="390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Hedgehog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8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25</a:t>
            </a:r>
            <a:endParaRPr sz="1600">
              <a:latin typeface="Calibri"/>
              <a:cs typeface="Calibri"/>
            </a:endParaRPr>
          </a:p>
          <a:p>
            <a:pPr marR="382270" algn="ctr">
              <a:lnSpc>
                <a:spcPct val="100000"/>
              </a:lnSpc>
              <a:spcBef>
                <a:spcPts val="290"/>
              </a:spcBef>
            </a:pPr>
            <a:r>
              <a:rPr sz="1600" b="1" i="1" spc="-5" dirty="0">
                <a:latin typeface="Calibri"/>
                <a:cs typeface="Calibri"/>
              </a:rPr>
              <a:t>CREBBP;FBXW11;PTCH1;PRKAR2A;BTRC;GLI3</a:t>
            </a:r>
            <a:endParaRPr sz="1600">
              <a:latin typeface="Calibri"/>
              <a:cs typeface="Calibri"/>
            </a:endParaRPr>
          </a:p>
          <a:p>
            <a:pPr marR="393065" algn="ctr">
              <a:lnSpc>
                <a:spcPct val="100000"/>
              </a:lnSpc>
              <a:spcBef>
                <a:spcPts val="905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Notch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4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45</a:t>
            </a:r>
            <a:endParaRPr sz="1600">
              <a:latin typeface="Calibri"/>
              <a:cs typeface="Calibri"/>
            </a:endParaRPr>
          </a:p>
          <a:p>
            <a:pPr marR="334645" algn="ctr">
              <a:lnSpc>
                <a:spcPct val="100000"/>
              </a:lnSpc>
              <a:spcBef>
                <a:spcPts val="370"/>
              </a:spcBef>
            </a:pPr>
            <a:r>
              <a:rPr sz="1600" b="1" i="1" spc="-10" dirty="0">
                <a:latin typeface="Calibri"/>
                <a:cs typeface="Calibri"/>
              </a:rPr>
              <a:t>NOTCH2;ADAM17;MAML1;NUMB;PSEN1</a:t>
            </a:r>
            <a:endParaRPr sz="1600">
              <a:latin typeface="Calibri"/>
              <a:cs typeface="Calibri"/>
            </a:endParaRPr>
          </a:p>
          <a:p>
            <a:pPr marR="236854" algn="ctr">
              <a:lnSpc>
                <a:spcPct val="100000"/>
              </a:lnSpc>
              <a:spcBef>
                <a:spcPts val="520"/>
              </a:spcBef>
            </a:pP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Ras </a:t>
            </a:r>
            <a:r>
              <a:rPr sz="1600" b="1" spc="-20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2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4393</a:t>
            </a:r>
            <a:endParaRPr sz="1600">
              <a:latin typeface="Calibri"/>
              <a:cs typeface="Calibri"/>
            </a:endParaRPr>
          </a:p>
          <a:p>
            <a:pPr marR="203835" algn="ctr">
              <a:lnSpc>
                <a:spcPct val="100000"/>
              </a:lnSpc>
              <a:spcBef>
                <a:spcPts val="380"/>
              </a:spcBef>
            </a:pPr>
            <a:r>
              <a:rPr sz="1600" b="1" i="1" spc="-5" dirty="0">
                <a:latin typeface="Calibri"/>
                <a:cs typeface="Calibri"/>
              </a:rPr>
              <a:t>TIAM1;PDPK1;MAPK1;RGL1;ETS1;MAP3K4</a:t>
            </a:r>
            <a:endParaRPr sz="1600">
              <a:latin typeface="Calibri"/>
              <a:cs typeface="Calibri"/>
            </a:endParaRPr>
          </a:p>
          <a:p>
            <a:pPr marR="81280" algn="ctr">
              <a:lnSpc>
                <a:spcPct val="100000"/>
              </a:lnSpc>
              <a:spcBef>
                <a:spcPts val="645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Angiogenesis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2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05</a:t>
            </a:r>
            <a:endParaRPr sz="160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475"/>
              </a:spcBef>
            </a:pPr>
            <a:r>
              <a:rPr sz="1600" b="1" i="1" spc="-10" dirty="0">
                <a:latin typeface="Calibri"/>
                <a:cs typeface="Calibri"/>
              </a:rPr>
              <a:t>NOTCH2;EFNB2;PTPRB;PRKCE;MAPK1;PRKCA;ETS1;CRKL;JAK1</a:t>
            </a:r>
            <a:endParaRPr sz="1600">
              <a:latin typeface="Calibri"/>
              <a:cs typeface="Calibri"/>
            </a:endParaRPr>
          </a:p>
          <a:p>
            <a:pPr marR="208279" algn="ctr">
              <a:lnSpc>
                <a:spcPct val="100000"/>
              </a:lnSpc>
              <a:spcBef>
                <a:spcPts val="650"/>
              </a:spcBef>
            </a:pP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PDGF signaling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5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47</a:t>
            </a:r>
            <a:endParaRPr sz="1600">
              <a:latin typeface="Calibri"/>
              <a:cs typeface="Calibri"/>
            </a:endParaRPr>
          </a:p>
          <a:p>
            <a:pPr marL="599440">
              <a:lnSpc>
                <a:spcPct val="100000"/>
              </a:lnSpc>
              <a:spcBef>
                <a:spcPts val="515"/>
              </a:spcBef>
            </a:pPr>
            <a:r>
              <a:rPr sz="1600" b="1" i="1" spc="-5" dirty="0">
                <a:latin typeface="Calibri"/>
                <a:cs typeface="Calibri"/>
              </a:rPr>
              <a:t>OPHN1;PDPK1;MAPK1;PRKCA;ITPR3;ETV3;ETS1;JAK1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964183" y="3290976"/>
            <a:ext cx="10202545" cy="3267710"/>
          </a:xfrm>
          <a:prstGeom prst="rect">
            <a:avLst/>
          </a:prstGeom>
        </p:spPr>
        <p:txBody>
          <a:bodyPr vert="horz" wrap="square" lIns="0" tIns="419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330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Insulin/IGF pathway-mitogen activated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rotein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kinase kinase/MAP kinase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cascade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14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32</a:t>
            </a:r>
            <a:endParaRPr sz="1600">
              <a:latin typeface="Calibri"/>
              <a:cs typeface="Calibri"/>
            </a:endParaRPr>
          </a:p>
          <a:p>
            <a:pPr marL="39370" algn="ctr">
              <a:lnSpc>
                <a:spcPts val="1845"/>
              </a:lnSpc>
              <a:spcBef>
                <a:spcPts val="235"/>
              </a:spcBef>
            </a:pPr>
            <a:r>
              <a:rPr sz="1600" b="1" i="1" spc="-10" dirty="0">
                <a:latin typeface="Calibri"/>
                <a:cs typeface="Calibri"/>
              </a:rPr>
              <a:t>IRS1;MAPK1;IGF2R;IGF1R</a:t>
            </a:r>
            <a:endParaRPr sz="1600">
              <a:latin typeface="Calibri"/>
              <a:cs typeface="Calibri"/>
            </a:endParaRPr>
          </a:p>
          <a:p>
            <a:pPr marL="2927985">
              <a:lnSpc>
                <a:spcPts val="1760"/>
              </a:lnSpc>
            </a:pPr>
            <a:r>
              <a:rPr sz="1600" b="1" spc="-25" dirty="0">
                <a:solidFill>
                  <a:srgbClr val="FF0000"/>
                </a:solidFill>
                <a:latin typeface="Calibri"/>
                <a:cs typeface="Calibri"/>
              </a:rPr>
              <a:t>Wnt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5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57</a:t>
            </a:r>
            <a:endParaRPr sz="1600">
              <a:latin typeface="Calibri"/>
              <a:cs typeface="Calibri"/>
            </a:endParaRPr>
          </a:p>
          <a:p>
            <a:pPr marL="58419" algn="ctr">
              <a:lnSpc>
                <a:spcPts val="1839"/>
              </a:lnSpc>
            </a:pPr>
            <a:r>
              <a:rPr sz="1600" b="1" i="1" spc="-10" dirty="0">
                <a:latin typeface="Calibri"/>
                <a:cs typeface="Calibri"/>
              </a:rPr>
              <a:t>SMARCC1;CREBBP;PCDHGB7;SRCAP;FBXW11;PRKCE;PCDHGC3;NFATC2;PRKCA;ITPR3;INO80;CELSR1;ARID1A;CCND1;FAT1;</a:t>
            </a:r>
            <a:endParaRPr sz="1600">
              <a:latin typeface="Calibri"/>
              <a:cs typeface="Calibri"/>
            </a:endParaRPr>
          </a:p>
          <a:p>
            <a:pPr marL="60325" algn="ctr">
              <a:lnSpc>
                <a:spcPct val="100000"/>
              </a:lnSpc>
            </a:pPr>
            <a:r>
              <a:rPr sz="1600" b="1" i="1" spc="-15" dirty="0">
                <a:latin typeface="Calibri"/>
                <a:cs typeface="Calibri"/>
              </a:rPr>
              <a:t>EP400;FAT2;EP300;TBL1X;BTRC</a:t>
            </a:r>
            <a:endParaRPr sz="1600">
              <a:latin typeface="Calibri"/>
              <a:cs typeface="Calibri"/>
            </a:endParaRPr>
          </a:p>
          <a:p>
            <a:pPr marL="1847850">
              <a:lnSpc>
                <a:spcPct val="100000"/>
              </a:lnSpc>
              <a:spcBef>
                <a:spcPts val="135"/>
              </a:spcBef>
            </a:pP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Alzheimer disease-amyloid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secretase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3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03</a:t>
            </a:r>
            <a:endParaRPr sz="1600">
              <a:latin typeface="Calibri"/>
              <a:cs typeface="Calibri"/>
            </a:endParaRPr>
          </a:p>
          <a:p>
            <a:pPr marL="132715" algn="ctr">
              <a:lnSpc>
                <a:spcPct val="100000"/>
              </a:lnSpc>
              <a:spcBef>
                <a:spcPts val="360"/>
              </a:spcBef>
            </a:pPr>
            <a:r>
              <a:rPr sz="1600" b="1" i="1" spc="-10" dirty="0">
                <a:latin typeface="Calibri"/>
                <a:cs typeface="Calibri"/>
              </a:rPr>
              <a:t>BACE1;ADAM17;PRKCE;MAPK1;PRKCA;PSEN1</a:t>
            </a:r>
            <a:endParaRPr sz="1600">
              <a:latin typeface="Calibri"/>
              <a:cs typeface="Calibri"/>
            </a:endParaRPr>
          </a:p>
          <a:p>
            <a:pPr marR="547370" algn="ctr">
              <a:lnSpc>
                <a:spcPct val="100000"/>
              </a:lnSpc>
              <a:spcBef>
                <a:spcPts val="20"/>
              </a:spcBef>
            </a:pP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Alzheimer disease-presenilin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2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04</a:t>
            </a:r>
            <a:endParaRPr sz="1600">
              <a:latin typeface="Calibri"/>
              <a:cs typeface="Calibri"/>
            </a:endParaRPr>
          </a:p>
          <a:p>
            <a:pPr marL="2860675">
              <a:lnSpc>
                <a:spcPct val="100000"/>
              </a:lnSpc>
              <a:spcBef>
                <a:spcPts val="360"/>
              </a:spcBef>
            </a:pPr>
            <a:r>
              <a:rPr sz="1600" b="1" i="1" spc="-10" dirty="0">
                <a:latin typeface="Calibri"/>
                <a:cs typeface="Calibri"/>
              </a:rPr>
              <a:t>ERN1;NOTCH2;BACE1;ADAM17;LRP1;PSEN1;CD44</a:t>
            </a:r>
            <a:endParaRPr sz="1600">
              <a:latin typeface="Calibri"/>
              <a:cs typeface="Calibri"/>
            </a:endParaRPr>
          </a:p>
          <a:p>
            <a:pPr marL="188595" algn="ctr">
              <a:lnSpc>
                <a:spcPts val="1800"/>
              </a:lnSpc>
              <a:spcBef>
                <a:spcPts val="15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Insulin/IGF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-protein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kinase B signaling cascade Homo sapiens</a:t>
            </a:r>
            <a:r>
              <a:rPr sz="1600" b="1" spc="114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33</a:t>
            </a:r>
            <a:endParaRPr sz="1600">
              <a:latin typeface="Calibri"/>
              <a:cs typeface="Calibri"/>
            </a:endParaRPr>
          </a:p>
          <a:p>
            <a:pPr marL="127000" algn="ctr">
              <a:lnSpc>
                <a:spcPts val="1655"/>
              </a:lnSpc>
            </a:pPr>
            <a:r>
              <a:rPr sz="1600" b="1" i="1" spc="-10" dirty="0">
                <a:latin typeface="Calibri"/>
                <a:cs typeface="Calibri"/>
              </a:rPr>
              <a:t>IRS1;PDPK1;IGF2R;IGF1R</a:t>
            </a:r>
            <a:endParaRPr sz="1600">
              <a:latin typeface="Calibri"/>
              <a:cs typeface="Calibri"/>
            </a:endParaRPr>
          </a:p>
          <a:p>
            <a:pPr marL="6985" algn="ctr">
              <a:lnSpc>
                <a:spcPts val="1775"/>
              </a:lnSpc>
            </a:pP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Endothelin signaling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athway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Homo sapiens</a:t>
            </a:r>
            <a:r>
              <a:rPr sz="1600" b="1" spc="4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00019</a:t>
            </a:r>
            <a:endParaRPr sz="1600">
              <a:latin typeface="Calibri"/>
              <a:cs typeface="Calibri"/>
            </a:endParaRPr>
          </a:p>
          <a:p>
            <a:pPr marL="200025" algn="ctr">
              <a:lnSpc>
                <a:spcPct val="100000"/>
              </a:lnSpc>
              <a:spcBef>
                <a:spcPts val="60"/>
              </a:spcBef>
            </a:pPr>
            <a:r>
              <a:rPr sz="1600" b="1" i="1" spc="-10" dirty="0">
                <a:latin typeface="Calibri"/>
                <a:cs typeface="Calibri"/>
              </a:rPr>
              <a:t>PRKCE;PRKAR2A;MAPK1;PRKCA;ITPR3;ADCY7</a:t>
            </a:r>
            <a:endParaRPr sz="16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408301" y="1103503"/>
            <a:ext cx="7374890" cy="2330450"/>
          </a:xfrm>
          <a:prstGeom prst="rect">
            <a:avLst/>
          </a:prstGeom>
        </p:spPr>
        <p:txBody>
          <a:bodyPr vert="horz" wrap="square" lIns="0" tIns="94615" rIns="0" bIns="0" rtlCol="0">
            <a:spAutoFit/>
          </a:bodyPr>
          <a:lstStyle/>
          <a:p>
            <a:pPr marL="12700" marR="5080" indent="-635" algn="ctr">
              <a:lnSpc>
                <a:spcPct val="90000"/>
              </a:lnSpc>
              <a:spcBef>
                <a:spcPts val="745"/>
              </a:spcBef>
            </a:pPr>
            <a:r>
              <a:rPr sz="5400" b="0" spc="-5" dirty="0">
                <a:latin typeface="Calibri Light"/>
                <a:cs typeface="Calibri Light"/>
              </a:rPr>
              <a:t>fb-PMT </a:t>
            </a:r>
            <a:r>
              <a:rPr sz="5400" b="0" spc="-60" dirty="0">
                <a:latin typeface="Calibri Light"/>
                <a:cs typeface="Calibri Light"/>
              </a:rPr>
              <a:t>effect </a:t>
            </a:r>
            <a:r>
              <a:rPr sz="5400" b="0" spc="-5" dirty="0">
                <a:latin typeface="Calibri Light"/>
                <a:cs typeface="Calibri Light"/>
              </a:rPr>
              <a:t>on </a:t>
            </a:r>
            <a:r>
              <a:rPr sz="5400" b="0" spc="-15" dirty="0">
                <a:latin typeface="Calibri Light"/>
                <a:cs typeface="Calibri Light"/>
              </a:rPr>
              <a:t>gene  </a:t>
            </a:r>
            <a:r>
              <a:rPr sz="5400" b="0" spc="-25" dirty="0">
                <a:latin typeface="Calibri Light"/>
                <a:cs typeface="Calibri Light"/>
              </a:rPr>
              <a:t>expression </a:t>
            </a:r>
            <a:r>
              <a:rPr sz="5400" b="0" dirty="0">
                <a:latin typeface="Calibri Light"/>
                <a:cs typeface="Calibri Light"/>
              </a:rPr>
              <a:t>in U87 </a:t>
            </a:r>
            <a:r>
              <a:rPr sz="5400" b="0" spc="-10" dirty="0">
                <a:latin typeface="Calibri Light"/>
                <a:cs typeface="Calibri Light"/>
              </a:rPr>
              <a:t>cells  </a:t>
            </a:r>
            <a:r>
              <a:rPr sz="5400" b="0" dirty="0">
                <a:latin typeface="Calibri Light"/>
                <a:cs typeface="Calibri Light"/>
              </a:rPr>
              <a:t>633 </a:t>
            </a:r>
            <a:r>
              <a:rPr sz="5400" b="0" spc="-20" dirty="0">
                <a:latin typeface="Calibri Light"/>
                <a:cs typeface="Calibri Light"/>
              </a:rPr>
              <a:t>down-regulated</a:t>
            </a:r>
            <a:r>
              <a:rPr sz="5400" b="0" spc="-55" dirty="0">
                <a:latin typeface="Calibri Light"/>
                <a:cs typeface="Calibri Light"/>
              </a:rPr>
              <a:t> </a:t>
            </a:r>
            <a:r>
              <a:rPr sz="5400" b="0" spc="-15" dirty="0">
                <a:latin typeface="Calibri Light"/>
                <a:cs typeface="Calibri Light"/>
              </a:rPr>
              <a:t>genes</a:t>
            </a:r>
            <a:endParaRPr sz="5400" dirty="0">
              <a:latin typeface="Calibri Light"/>
              <a:cs typeface="Calibri Light"/>
            </a:endParaRPr>
          </a:p>
        </p:txBody>
      </p:sp>
      <p:sp>
        <p:nvSpPr>
          <p:cNvPr id="3" name="object 3"/>
          <p:cNvSpPr txBox="1">
            <a:spLocks noGrp="1"/>
          </p:cNvSpPr>
          <p:nvPr>
            <p:ph type="subTitle" idx="4"/>
          </p:nvPr>
        </p:nvSpPr>
        <p:spPr>
          <a:prstGeom prst="rect">
            <a:avLst/>
          </a:prstGeom>
        </p:spPr>
        <p:txBody>
          <a:bodyPr vert="horz" wrap="square" lIns="0" tIns="74930" rIns="0" bIns="0" rtlCol="0">
            <a:spAutoFit/>
          </a:bodyPr>
          <a:lstStyle/>
          <a:p>
            <a:pPr marL="1451610" marR="5080" indent="-1439545">
              <a:lnSpc>
                <a:spcPts val="3890"/>
              </a:lnSpc>
              <a:spcBef>
                <a:spcPts val="590"/>
              </a:spcBef>
            </a:pPr>
            <a:r>
              <a:rPr dirty="0"/>
              <a:t>Summary </a:t>
            </a:r>
            <a:r>
              <a:rPr spc="-5" dirty="0"/>
              <a:t>of </a:t>
            </a:r>
            <a:r>
              <a:rPr dirty="0"/>
              <a:t>the </a:t>
            </a:r>
            <a:r>
              <a:rPr spc="-5" dirty="0"/>
              <a:t>Gene </a:t>
            </a:r>
            <a:r>
              <a:rPr spc="-15" dirty="0"/>
              <a:t>Set </a:t>
            </a:r>
            <a:r>
              <a:rPr spc="-10" dirty="0"/>
              <a:t>Enrichment</a:t>
            </a:r>
            <a:r>
              <a:rPr spc="-130" dirty="0"/>
              <a:t> </a:t>
            </a:r>
            <a:r>
              <a:rPr spc="-5" dirty="0"/>
              <a:t>Analyses  of </a:t>
            </a:r>
            <a:r>
              <a:rPr dirty="0"/>
              <a:t>the ~ </a:t>
            </a:r>
            <a:r>
              <a:rPr lang="en-US" spc="-10" dirty="0"/>
              <a:t>3</a:t>
            </a:r>
            <a:r>
              <a:rPr spc="-10" dirty="0" smtClean="0"/>
              <a:t>0 </a:t>
            </a:r>
            <a:r>
              <a:rPr spc="-5" dirty="0"/>
              <a:t>genomics</a:t>
            </a:r>
            <a:r>
              <a:rPr spc="-25" dirty="0"/>
              <a:t> </a:t>
            </a:r>
            <a:r>
              <a:rPr spc="-10" dirty="0"/>
              <a:t>databases</a:t>
            </a:r>
          </a:p>
        </p:txBody>
      </p:sp>
      <p:sp>
        <p:nvSpPr>
          <p:cNvPr id="4" name="Rectangle 3"/>
          <p:cNvSpPr/>
          <p:nvPr/>
        </p:nvSpPr>
        <p:spPr>
          <a:xfrm>
            <a:off x="3047746" y="579120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633 high confidence down-regulated genes </a:t>
            </a:r>
            <a:br>
              <a:rPr lang="en-US" b="1" dirty="0"/>
            </a:br>
            <a:r>
              <a:rPr lang="en-US" b="1" dirty="0"/>
              <a:t>(adjusted p value &lt; 0.05)</a:t>
            </a:r>
            <a:endParaRPr 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Grp="1"/>
          </p:cNvGraphicFramePr>
          <p:nvPr/>
        </p:nvGraphicFramePr>
        <p:xfrm>
          <a:off x="304203" y="1174241"/>
          <a:ext cx="11654790" cy="471034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951730"/>
                <a:gridCol w="880110"/>
                <a:gridCol w="5822950"/>
              </a:tblGrid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30" dirty="0">
                          <a:latin typeface="Calibri"/>
                          <a:cs typeface="Calibri"/>
                        </a:rPr>
                        <a:t>Term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P-value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Genes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Hedgehog 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7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2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1.32E-0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CREBBP;FBXW11;PTCH1;PRKAR2A;BTRC;GLI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43637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6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410"/>
                        </a:lnSpc>
                      </a:pPr>
                      <a:r>
                        <a:rPr sz="1200" b="1" spc="-15" dirty="0">
                          <a:latin typeface="Calibri"/>
                          <a:cs typeface="Calibri"/>
                        </a:rPr>
                        <a:t>Wnt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Homo sapiens</a:t>
                      </a:r>
                      <a:r>
                        <a:rPr sz="12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P0005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31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16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41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5.83E-0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31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84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SMARCC1;CREBBP;PCDHGB7;SRCAP;FBXW11;PRKCE;PCDHGC3;NFATC2;PRKCA;ITPR3;INO80;</a:t>
                      </a:r>
                      <a:endParaRPr sz="12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410"/>
                        </a:lnSpc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CELSR1;ARID1A;CCND1;FAT1;EP400;FAT2;EP300;TBL1X;BTRC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1594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5999">
                <a:tc>
                  <a:txBody>
                    <a:bodyPr/>
                    <a:lstStyle/>
                    <a:p>
                      <a:pPr algn="ctr">
                        <a:lnSpc>
                          <a:spcPts val="1410"/>
                        </a:lnSpc>
                        <a:spcBef>
                          <a:spcPts val="425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Transcription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regulation b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bZIP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transcription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factor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5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39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0"/>
                        </a:lnSpc>
                        <a:spcBef>
                          <a:spcPts val="42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01951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39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0"/>
                        </a:lnSpc>
                        <a:spcBef>
                          <a:spcPts val="42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CREBBP;PRKAR2A;CREB3L2;EP300;TTF2;TAF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39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023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Notch 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4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0661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NOTCH2;ADAM17;MAML1;NUMB;PSEN1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TGF-beta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5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067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SKI;CREBBP;SMAD3;GDNF;EP300;MAPK1;ACVR1B;TGFBR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18821">
                <a:tc>
                  <a:txBody>
                    <a:bodyPr/>
                    <a:lstStyle/>
                    <a:p>
                      <a:pPr algn="ctr">
                        <a:lnSpc>
                          <a:spcPts val="1410"/>
                        </a:lnSpc>
                        <a:spcBef>
                          <a:spcPts val="21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Alzheimer disease-amyloid secretase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 P0000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30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0"/>
                        </a:lnSpc>
                        <a:spcBef>
                          <a:spcPts val="21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08329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30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0"/>
                        </a:lnSpc>
                        <a:spcBef>
                          <a:spcPts val="215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BACE1;ADAM17;PRKCE;MAPK1;PRKCA;PSEN1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30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67029">
                <a:tc>
                  <a:txBody>
                    <a:bodyPr/>
                    <a:lstStyle/>
                    <a:p>
                      <a:pPr algn="ctr">
                        <a:lnSpc>
                          <a:spcPts val="138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Insulin/IGF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-mitogen activated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rotein kinase kinase/MAP</a:t>
                      </a:r>
                      <a:r>
                        <a:rPr sz="1200" b="1" spc="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kinase</a:t>
                      </a:r>
                      <a:endParaRPr sz="12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41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cascade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3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41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1259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200">
                        <a:latin typeface="Times New Roman"/>
                        <a:cs typeface="Times New Roman"/>
                      </a:endParaRPr>
                    </a:p>
                    <a:p>
                      <a:pPr marL="1270" algn="ctr">
                        <a:lnSpc>
                          <a:spcPts val="141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IRS1;MAPK1;IGF2R;IGF1R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023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Huntington disease Homo sapiens</a:t>
                      </a:r>
                      <a:r>
                        <a:rPr sz="12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29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1710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DYNC1H1;CREBBP;HIP1;APAF1;SP1;SIN3A;EP300;HTT;TAF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73303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64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Insulin/IGF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-protein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kinase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B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cascade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9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3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819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405"/>
                        </a:lnSpc>
                        <a:spcBef>
                          <a:spcPts val="64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217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819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405"/>
                        </a:lnSpc>
                        <a:spcBef>
                          <a:spcPts val="64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IRS1;PDPK1;IGF2R;IGF1R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819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023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Ras </a:t>
                      </a:r>
                      <a:r>
                        <a:rPr sz="1200" b="1" spc="-15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1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439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2185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TIAM1;PDPK1;MAPK1;RGL1;ETS1;MAP3K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18820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21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Dopamine receptor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mediated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6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591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30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21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23913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30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21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EPB41;EPB41L2;PRKAR2A;STX3;ADCY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30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p53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59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24778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CREBBP;APAF1;SIN3A;PDPK1;EP300;THBS1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84150"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PDGF 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4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2592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OPHN1;PDPK1;MAPK1;PRKCA;ITPR3;ETV3;ETS1;JAK1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5999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430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Histamine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2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receptor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mediated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4386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46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430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3106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46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405"/>
                        </a:lnSpc>
                        <a:spcBef>
                          <a:spcPts val="430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PRKAR2A;ADCY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46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91516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Endothelin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19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31388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PRKCE;PRKAR2A;MAPK1;PRKCA;ITPR3;ADCY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91643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Angiogenesis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0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36862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NOTCH2;EFNB2;PTPRB;PRKCE;MAPK1;PRKCA;ETS1;CRKL;JAK1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91643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Alzheimer disease-presenilin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0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376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ERN1;NOTCH2;BACE1;ADAM17;LRP1;PSEN1;CD4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91642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Hypoxia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response via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IF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activation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0030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3898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405"/>
                        </a:lnSpc>
                        <a:spcBef>
                          <a:spcPts val="5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CREBBP;ARNT;MTOR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18744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219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Beta3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adrenergic receptor 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4379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939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219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45524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939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219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STX3;ADCY7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27939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45999"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430"/>
                        </a:spcBef>
                      </a:pPr>
                      <a:r>
                        <a:rPr sz="1200" b="1" spc="-5" dirty="0">
                          <a:latin typeface="Calibri"/>
                          <a:cs typeface="Calibri"/>
                        </a:rPr>
                        <a:t>Histamine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1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receptor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mediated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200" b="1" spc="-10" dirty="0">
                          <a:latin typeface="Calibri"/>
                          <a:cs typeface="Calibri"/>
                        </a:rPr>
                        <a:t>pathway </a:t>
                      </a:r>
                      <a:r>
                        <a:rPr sz="1200" b="1" dirty="0">
                          <a:latin typeface="Calibri"/>
                          <a:cs typeface="Calibri"/>
                        </a:rPr>
                        <a:t>Homo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sapiens</a:t>
                      </a:r>
                      <a:r>
                        <a:rPr sz="12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200" b="1" spc="-5" dirty="0">
                          <a:latin typeface="Calibri"/>
                          <a:cs typeface="Calibri"/>
                        </a:rPr>
                        <a:t>P04385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46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  <a:spcBef>
                          <a:spcPts val="430"/>
                        </a:spcBef>
                      </a:pPr>
                      <a:r>
                        <a:rPr sz="1200" b="1" dirty="0">
                          <a:latin typeface="Calibri"/>
                          <a:cs typeface="Calibri"/>
                        </a:rPr>
                        <a:t>0.047818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46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635" algn="ctr">
                        <a:lnSpc>
                          <a:spcPts val="1405"/>
                        </a:lnSpc>
                        <a:spcBef>
                          <a:spcPts val="430"/>
                        </a:spcBef>
                      </a:pPr>
                      <a:r>
                        <a:rPr sz="1200" b="1" spc="-10" dirty="0">
                          <a:latin typeface="Calibri"/>
                          <a:cs typeface="Calibri"/>
                        </a:rPr>
                        <a:t>PRKCE;ITPR3;PRKCA</a:t>
                      </a:r>
                      <a:endParaRPr sz="1200">
                        <a:latin typeface="Calibri"/>
                        <a:cs typeface="Calibri"/>
                      </a:endParaRPr>
                    </a:p>
                  </a:txBody>
                  <a:tcPr marL="0" marR="0" marT="546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</a:tbl>
          </a:graphicData>
        </a:graphic>
      </p:graphicFrame>
      <p:sp>
        <p:nvSpPr>
          <p:cNvPr id="3" name="object 3"/>
          <p:cNvSpPr txBox="1"/>
          <p:nvPr/>
        </p:nvSpPr>
        <p:spPr>
          <a:xfrm>
            <a:off x="3598290" y="733424"/>
            <a:ext cx="4982210" cy="26924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15" dirty="0">
                <a:latin typeface="Calibri"/>
                <a:cs typeface="Calibri"/>
              </a:rPr>
              <a:t>Panther </a:t>
            </a:r>
            <a:r>
              <a:rPr sz="1600" b="1" spc="-10" dirty="0">
                <a:latin typeface="Calibri"/>
                <a:cs typeface="Calibri"/>
              </a:rPr>
              <a:t>2016 (examples </a:t>
            </a:r>
            <a:r>
              <a:rPr sz="1600" b="1" spc="-5" dirty="0">
                <a:latin typeface="Calibri"/>
                <a:cs typeface="Calibri"/>
              </a:rPr>
              <a:t>of significantly </a:t>
            </a:r>
            <a:r>
              <a:rPr sz="1600" b="1" spc="-15" dirty="0">
                <a:latin typeface="Calibri"/>
                <a:cs typeface="Calibri"/>
              </a:rPr>
              <a:t>affected</a:t>
            </a:r>
            <a:r>
              <a:rPr sz="1600" b="1" spc="160" dirty="0">
                <a:latin typeface="Calibri"/>
                <a:cs typeface="Calibri"/>
              </a:rPr>
              <a:t> </a:t>
            </a:r>
            <a:r>
              <a:rPr sz="1600" b="1" spc="-15" dirty="0">
                <a:latin typeface="Calibri"/>
                <a:cs typeface="Calibri"/>
              </a:rPr>
              <a:t>pathways)</a:t>
            </a:r>
            <a:endParaRPr sz="16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399770" y="499870"/>
            <a:ext cx="2732578" cy="624382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848727" y="530578"/>
            <a:ext cx="6000393" cy="6110762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808601" y="518286"/>
            <a:ext cx="2569845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GO Biological </a:t>
            </a:r>
            <a:r>
              <a:rPr sz="1800" b="1" spc="-10" dirty="0">
                <a:latin typeface="Calibri"/>
                <a:cs typeface="Calibri"/>
              </a:rPr>
              <a:t>Process</a:t>
            </a:r>
            <a:r>
              <a:rPr sz="1800" b="1" spc="-75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2018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3054095" y="425965"/>
            <a:ext cx="6243828" cy="273404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>
            <a:spLocks noGrp="1"/>
          </p:cNvSpPr>
          <p:nvPr>
            <p:ph type="title"/>
          </p:nvPr>
        </p:nvSpPr>
        <p:spPr>
          <a:xfrm>
            <a:off x="2277617" y="17780"/>
            <a:ext cx="7846059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GO Biological </a:t>
            </a:r>
            <a:r>
              <a:rPr sz="1800" b="1" spc="-10" dirty="0">
                <a:latin typeface="Calibri"/>
                <a:cs typeface="Calibri"/>
              </a:rPr>
              <a:t>Process </a:t>
            </a:r>
            <a:r>
              <a:rPr sz="1800" b="1" dirty="0">
                <a:latin typeface="Calibri"/>
                <a:cs typeface="Calibri"/>
              </a:rPr>
              <a:t>2018 </a:t>
            </a:r>
            <a:r>
              <a:rPr sz="1800" b="1" spc="-10" dirty="0">
                <a:latin typeface="Calibri"/>
                <a:cs typeface="Calibri"/>
              </a:rPr>
              <a:t>(examples </a:t>
            </a:r>
            <a:r>
              <a:rPr sz="1800" b="1" dirty="0">
                <a:latin typeface="Calibri"/>
                <a:cs typeface="Calibri"/>
              </a:rPr>
              <a:t>of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 </a:t>
            </a:r>
            <a:r>
              <a:rPr sz="1800" b="1" spc="-5" dirty="0">
                <a:latin typeface="Calibri"/>
                <a:cs typeface="Calibri"/>
              </a:rPr>
              <a:t>biological </a:t>
            </a:r>
            <a:r>
              <a:rPr sz="1800" b="1" spc="-10" dirty="0">
                <a:latin typeface="Calibri"/>
                <a:cs typeface="Calibri"/>
              </a:rPr>
              <a:t>processes)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18033" y="3586377"/>
            <a:ext cx="11821795" cy="2769870"/>
          </a:xfrm>
          <a:prstGeom prst="rect">
            <a:avLst/>
          </a:prstGeom>
        </p:spPr>
        <p:txBody>
          <a:bodyPr vert="horz" wrap="square" lIns="0" tIns="55244" rIns="0" bIns="0" rtlCol="0">
            <a:spAutoFit/>
          </a:bodyPr>
          <a:lstStyle/>
          <a:p>
            <a:pPr marR="535940" algn="ctr">
              <a:lnSpc>
                <a:spcPct val="100000"/>
              </a:lnSpc>
              <a:spcBef>
                <a:spcPts val="434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Regulation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of angiogenesis</a:t>
            </a:r>
            <a:r>
              <a:rPr sz="1600" b="1" spc="1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(GO:0045765)</a:t>
            </a:r>
            <a:endParaRPr sz="160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335"/>
              </a:spcBef>
            </a:pPr>
            <a:r>
              <a:rPr sz="1600" b="1" i="1" spc="-10" dirty="0">
                <a:latin typeface="Calibri"/>
                <a:cs typeface="Calibri"/>
              </a:rPr>
              <a:t>SEMA5A;PDPK1;FOXJ2;TNFAIP3;PRKCA;THBS2;ETS1;HSPG2;THBS1;HK2;AMOT;HIPK2;MECP2;SP1;AGO1;ADAM12;AGO2;ZNF304;SASH1;GTF2I</a:t>
            </a:r>
            <a:endParaRPr sz="1600">
              <a:latin typeface="Calibri"/>
              <a:cs typeface="Calibri"/>
            </a:endParaRPr>
          </a:p>
          <a:p>
            <a:pPr marR="543560" algn="ctr">
              <a:lnSpc>
                <a:spcPct val="100000"/>
              </a:lnSpc>
              <a:spcBef>
                <a:spcPts val="560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ositive regulation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of angiogenesis</a:t>
            </a:r>
            <a:r>
              <a:rPr sz="1600" b="1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(GO:0045766)</a:t>
            </a:r>
            <a:endParaRPr sz="1600">
              <a:latin typeface="Calibri"/>
              <a:cs typeface="Calibri"/>
            </a:endParaRPr>
          </a:p>
          <a:p>
            <a:pPr marL="1809750">
              <a:lnSpc>
                <a:spcPct val="100000"/>
              </a:lnSpc>
              <a:spcBef>
                <a:spcPts val="690"/>
              </a:spcBef>
            </a:pPr>
            <a:r>
              <a:rPr sz="1600" b="1" i="1" spc="-10" dirty="0">
                <a:latin typeface="Calibri"/>
                <a:cs typeface="Calibri"/>
              </a:rPr>
              <a:t>SEMA5A;PDPK1;PRKCA;ETS1;THBS1;HK2;HIPK2;SP1;ADAM12;AGO2;ZNF304;SASH1;JAK1</a:t>
            </a:r>
            <a:endParaRPr sz="1600">
              <a:latin typeface="Calibri"/>
              <a:cs typeface="Calibri"/>
            </a:endParaRPr>
          </a:p>
          <a:p>
            <a:pPr marR="544195" algn="ctr">
              <a:lnSpc>
                <a:spcPct val="100000"/>
              </a:lnSpc>
              <a:spcBef>
                <a:spcPts val="745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ositive regulation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of cell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migration (GO:0030335)</a:t>
            </a:r>
            <a:endParaRPr sz="1600">
              <a:latin typeface="Calibri"/>
              <a:cs typeface="Calibri"/>
            </a:endParaRPr>
          </a:p>
          <a:p>
            <a:pPr marL="139700" marR="39370" algn="ctr">
              <a:lnSpc>
                <a:spcPct val="100000"/>
              </a:lnSpc>
              <a:spcBef>
                <a:spcPts val="745"/>
              </a:spcBef>
            </a:pPr>
            <a:r>
              <a:rPr sz="1600" b="1" i="1" spc="-5" dirty="0">
                <a:latin typeface="Calibri"/>
                <a:cs typeface="Calibri"/>
              </a:rPr>
              <a:t>DOCK5;PRKCE;FN1;PRKCA;ACVR1B;THBS1;EGFR;MTOR;MYLK;IGF1R;TIAM1;ZNF609;ADAM17;DAB2;AGO2;NUMB;ZNF304;ARHGEF7;RREB1;  CLASP1;DDR2</a:t>
            </a:r>
            <a:endParaRPr sz="1600">
              <a:latin typeface="Calibri"/>
              <a:cs typeface="Calibri"/>
            </a:endParaRPr>
          </a:p>
          <a:p>
            <a:pPr marR="551815" algn="ctr">
              <a:lnSpc>
                <a:spcPct val="100000"/>
              </a:lnSpc>
              <a:spcBef>
                <a:spcPts val="470"/>
              </a:spcBef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Positive regulation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of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fibroblast migration</a:t>
            </a:r>
            <a:r>
              <a:rPr sz="1600" b="1" spc="3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(GO:0010763)</a:t>
            </a:r>
            <a:endParaRPr sz="1600">
              <a:latin typeface="Calibri"/>
              <a:cs typeface="Calibri"/>
            </a:endParaRPr>
          </a:p>
          <a:p>
            <a:pPr marL="151130" algn="ctr">
              <a:lnSpc>
                <a:spcPct val="100000"/>
              </a:lnSpc>
              <a:spcBef>
                <a:spcPts val="445"/>
              </a:spcBef>
            </a:pPr>
            <a:r>
              <a:rPr sz="1600" b="1" i="1" spc="-10" dirty="0">
                <a:latin typeface="Calibri"/>
                <a:cs typeface="Calibri"/>
              </a:rPr>
              <a:t>PRKCE;ARHGEF7;THBS1;DDR2</a:t>
            </a:r>
            <a:endParaRPr sz="16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433329" y="431290"/>
            <a:ext cx="2734040" cy="632612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364095" y="462402"/>
            <a:ext cx="6000393" cy="619130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078604" y="449326"/>
            <a:ext cx="2730500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GO Molecular Function</a:t>
            </a:r>
            <a:r>
              <a:rPr sz="1800" b="1" spc="-8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2018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373863" y="318514"/>
            <a:ext cx="2732577" cy="644804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425054" y="350226"/>
            <a:ext cx="5952771" cy="631062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243578" y="337184"/>
            <a:ext cx="2773045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5" dirty="0">
                <a:latin typeface="Calibri"/>
                <a:cs typeface="Calibri"/>
              </a:rPr>
              <a:t>GO Cellular Component</a:t>
            </a:r>
            <a:r>
              <a:rPr sz="1800" b="1" spc="-11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2018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523744" y="818388"/>
            <a:ext cx="7676388" cy="5081016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3103626" y="5097526"/>
            <a:ext cx="247650" cy="1936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b="1" spc="-5" dirty="0">
                <a:latin typeface="Calibri"/>
                <a:cs typeface="Calibri"/>
              </a:rPr>
              <a:t>-1.</a:t>
            </a:r>
            <a:r>
              <a:rPr sz="1100" b="1" dirty="0">
                <a:latin typeface="Calibri"/>
                <a:cs typeface="Calibri"/>
              </a:rPr>
              <a:t>5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6088507" y="5471261"/>
            <a:ext cx="96520" cy="1936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b="1" dirty="0">
                <a:latin typeface="Calibri"/>
                <a:cs typeface="Calibri"/>
              </a:rPr>
              <a:t>0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7078471" y="5616346"/>
            <a:ext cx="205104" cy="1936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b="1" spc="-10" dirty="0">
                <a:latin typeface="Calibri"/>
                <a:cs typeface="Calibri"/>
              </a:rPr>
              <a:t>0</a:t>
            </a:r>
            <a:r>
              <a:rPr sz="1100" b="1" dirty="0">
                <a:latin typeface="Calibri"/>
                <a:cs typeface="Calibri"/>
              </a:rPr>
              <a:t>.5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8217154" y="5752287"/>
            <a:ext cx="96520" cy="1936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b="1" dirty="0">
                <a:latin typeface="Calibri"/>
                <a:cs typeface="Calibri"/>
              </a:rPr>
              <a:t>1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9291066" y="5908040"/>
            <a:ext cx="205104" cy="1936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b="1" spc="-10" dirty="0">
                <a:latin typeface="Calibri"/>
                <a:cs typeface="Calibri"/>
              </a:rPr>
              <a:t>1</a:t>
            </a:r>
            <a:r>
              <a:rPr sz="1100" b="1" dirty="0">
                <a:latin typeface="Calibri"/>
                <a:cs typeface="Calibri"/>
              </a:rPr>
              <a:t>.5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379091" y="854202"/>
            <a:ext cx="715645" cy="4197350"/>
          </a:xfrm>
          <a:prstGeom prst="rect">
            <a:avLst/>
          </a:prstGeom>
        </p:spPr>
        <p:txBody>
          <a:bodyPr vert="horz" wrap="square" lIns="0" tIns="68580" rIns="0" bIns="0" rtlCol="0">
            <a:spAutoFit/>
          </a:bodyPr>
          <a:lstStyle/>
          <a:p>
            <a:pPr marL="12700" marR="165100" indent="197485" algn="r">
              <a:lnSpc>
                <a:spcPct val="69500"/>
              </a:lnSpc>
              <a:spcBef>
                <a:spcPts val="540"/>
              </a:spcBef>
            </a:pPr>
            <a:r>
              <a:rPr sz="1200" b="1" i="1" dirty="0">
                <a:latin typeface="Calibri"/>
                <a:cs typeface="Calibri"/>
              </a:rPr>
              <a:t>FA</a:t>
            </a:r>
            <a:r>
              <a:rPr sz="1200" b="1" i="1" spc="-10" dirty="0">
                <a:latin typeface="Calibri"/>
                <a:cs typeface="Calibri"/>
              </a:rPr>
              <a:t>T</a:t>
            </a:r>
            <a:r>
              <a:rPr sz="1200" b="1" i="1" dirty="0">
                <a:latin typeface="Calibri"/>
                <a:cs typeface="Calibri"/>
              </a:rPr>
              <a:t>1  E</a:t>
            </a:r>
            <a:r>
              <a:rPr sz="1200" b="1" i="1" spc="5" dirty="0">
                <a:latin typeface="Calibri"/>
                <a:cs typeface="Calibri"/>
              </a:rPr>
              <a:t>G</a:t>
            </a:r>
            <a:r>
              <a:rPr sz="1200" b="1" i="1" spc="-15" dirty="0">
                <a:latin typeface="Calibri"/>
                <a:cs typeface="Calibri"/>
              </a:rPr>
              <a:t>F</a:t>
            </a:r>
            <a:r>
              <a:rPr sz="1200" b="1" i="1" dirty="0">
                <a:latin typeface="Calibri"/>
                <a:cs typeface="Calibri"/>
              </a:rPr>
              <a:t>R  FA</a:t>
            </a:r>
            <a:r>
              <a:rPr sz="1200" b="1" i="1" spc="-10" dirty="0">
                <a:latin typeface="Calibri"/>
                <a:cs typeface="Calibri"/>
              </a:rPr>
              <a:t>T</a:t>
            </a:r>
            <a:r>
              <a:rPr sz="1200" b="1" i="1" dirty="0">
                <a:latin typeface="Calibri"/>
                <a:cs typeface="Calibri"/>
              </a:rPr>
              <a:t>4  N</a:t>
            </a:r>
            <a:r>
              <a:rPr sz="1200" b="1" i="1" spc="-15" dirty="0">
                <a:latin typeface="Calibri"/>
                <a:cs typeface="Calibri"/>
              </a:rPr>
              <a:t>O</a:t>
            </a:r>
            <a:r>
              <a:rPr sz="1200" b="1" i="1" dirty="0">
                <a:latin typeface="Calibri"/>
                <a:cs typeface="Calibri"/>
              </a:rPr>
              <a:t>TCH2</a:t>
            </a:r>
            <a:endParaRPr sz="1200">
              <a:latin typeface="Calibri"/>
              <a:cs typeface="Calibri"/>
            </a:endParaRPr>
          </a:p>
          <a:p>
            <a:pPr marL="91440" marR="154940" indent="111760" algn="r">
              <a:lnSpc>
                <a:spcPct val="68600"/>
              </a:lnSpc>
              <a:spcBef>
                <a:spcPts val="5"/>
              </a:spcBef>
            </a:pPr>
            <a:r>
              <a:rPr sz="1200" b="1" i="1" dirty="0">
                <a:latin typeface="Calibri"/>
                <a:cs typeface="Calibri"/>
              </a:rPr>
              <a:t>N</a:t>
            </a:r>
            <a:r>
              <a:rPr sz="1200" b="1" i="1" spc="-10" dirty="0">
                <a:latin typeface="Calibri"/>
                <a:cs typeface="Calibri"/>
              </a:rPr>
              <a:t>S</a:t>
            </a:r>
            <a:r>
              <a:rPr sz="1200" b="1" i="1" spc="-5" dirty="0">
                <a:latin typeface="Calibri"/>
                <a:cs typeface="Calibri"/>
              </a:rPr>
              <a:t>D1  </a:t>
            </a:r>
            <a:r>
              <a:rPr sz="1200" b="1" i="1" dirty="0">
                <a:latin typeface="Calibri"/>
                <a:cs typeface="Calibri"/>
              </a:rPr>
              <a:t>K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T</a:t>
            </a:r>
            <a:r>
              <a:rPr sz="1200" b="1" i="1" spc="-10" dirty="0">
                <a:latin typeface="Calibri"/>
                <a:cs typeface="Calibri"/>
              </a:rPr>
              <a:t>2</a:t>
            </a:r>
            <a:r>
              <a:rPr sz="1200" b="1" i="1" dirty="0">
                <a:latin typeface="Calibri"/>
                <a:cs typeface="Calibri"/>
              </a:rPr>
              <a:t>A</a:t>
            </a:r>
            <a:endParaRPr sz="1200">
              <a:latin typeface="Calibri"/>
              <a:cs typeface="Calibri"/>
            </a:endParaRPr>
          </a:p>
          <a:p>
            <a:pPr marL="51435" marR="66675" indent="180975" algn="r">
              <a:lnSpc>
                <a:spcPct val="66700"/>
              </a:lnSpc>
              <a:spcBef>
                <a:spcPts val="25"/>
              </a:spcBef>
            </a:pPr>
            <a:r>
              <a:rPr sz="1200" b="1" i="1" dirty="0">
                <a:latin typeface="Calibri"/>
                <a:cs typeface="Calibri"/>
              </a:rPr>
              <a:t>S</a:t>
            </a:r>
            <a:r>
              <a:rPr sz="1200" b="1" i="1" spc="-5" dirty="0">
                <a:latin typeface="Calibri"/>
                <a:cs typeface="Calibri"/>
              </a:rPr>
              <a:t>PEN  </a:t>
            </a:r>
            <a:r>
              <a:rPr sz="1200" b="1" i="1" dirty="0">
                <a:latin typeface="Calibri"/>
                <a:cs typeface="Calibri"/>
              </a:rPr>
              <a:t>K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T</a:t>
            </a:r>
            <a:r>
              <a:rPr sz="1200" b="1" i="1" spc="-10" dirty="0">
                <a:latin typeface="Calibri"/>
                <a:cs typeface="Calibri"/>
              </a:rPr>
              <a:t>2</a:t>
            </a:r>
            <a:r>
              <a:rPr sz="1200" b="1" i="1" dirty="0">
                <a:latin typeface="Calibri"/>
                <a:cs typeface="Calibri"/>
              </a:rPr>
              <a:t>D  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ED</a:t>
            </a:r>
            <a:r>
              <a:rPr sz="1200" b="1" i="1" spc="5" dirty="0">
                <a:latin typeface="Calibri"/>
                <a:cs typeface="Calibri"/>
              </a:rPr>
              <a:t>1</a:t>
            </a:r>
            <a:r>
              <a:rPr sz="1200" b="1" i="1" dirty="0">
                <a:latin typeface="Calibri"/>
                <a:cs typeface="Calibri"/>
              </a:rPr>
              <a:t>2  EP3</a:t>
            </a:r>
            <a:r>
              <a:rPr sz="1200" b="1" i="1" spc="-10" dirty="0">
                <a:latin typeface="Calibri"/>
                <a:cs typeface="Calibri"/>
              </a:rPr>
              <a:t>0</a:t>
            </a:r>
            <a:r>
              <a:rPr sz="1200" b="1" i="1" dirty="0">
                <a:latin typeface="Calibri"/>
                <a:cs typeface="Calibri"/>
              </a:rPr>
              <a:t>0  N</a:t>
            </a:r>
            <a:r>
              <a:rPr sz="1200" b="1" i="1" spc="-15" dirty="0">
                <a:latin typeface="Calibri"/>
                <a:cs typeface="Calibri"/>
              </a:rPr>
              <a:t>O</a:t>
            </a:r>
            <a:r>
              <a:rPr sz="1200" b="1" i="1" dirty="0">
                <a:latin typeface="Calibri"/>
                <a:cs typeface="Calibri"/>
              </a:rPr>
              <a:t>TCH1  CREBBP  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T</a:t>
            </a:r>
            <a:r>
              <a:rPr sz="1200" b="1" i="1" spc="-5" dirty="0">
                <a:latin typeface="Calibri"/>
                <a:cs typeface="Calibri"/>
              </a:rPr>
              <a:t>OR  P</a:t>
            </a:r>
            <a:r>
              <a:rPr sz="1200" b="1" i="1" dirty="0">
                <a:latin typeface="Calibri"/>
                <a:cs typeface="Calibri"/>
              </a:rPr>
              <a:t>TCH1  ERC1  EPA</a:t>
            </a:r>
            <a:r>
              <a:rPr sz="1200" b="1" i="1" spc="-10" dirty="0">
                <a:latin typeface="Calibri"/>
                <a:cs typeface="Calibri"/>
              </a:rPr>
              <a:t>S</a:t>
            </a:r>
            <a:r>
              <a:rPr sz="1200" b="1" i="1" dirty="0">
                <a:latin typeface="Calibri"/>
                <a:cs typeface="Calibri"/>
              </a:rPr>
              <a:t>1  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ET  BCOR  T</a:t>
            </a:r>
            <a:r>
              <a:rPr sz="1200" b="1" i="1" spc="-10" dirty="0">
                <a:latin typeface="Calibri"/>
                <a:cs typeface="Calibri"/>
              </a:rPr>
              <a:t>G</a:t>
            </a:r>
            <a:r>
              <a:rPr sz="1200" b="1" i="1" dirty="0">
                <a:latin typeface="Calibri"/>
                <a:cs typeface="Calibri"/>
              </a:rPr>
              <a:t>FB</a:t>
            </a:r>
            <a:r>
              <a:rPr sz="1200" b="1" i="1" spc="-5" dirty="0">
                <a:latin typeface="Calibri"/>
                <a:cs typeface="Calibri"/>
              </a:rPr>
              <a:t>R</a:t>
            </a:r>
            <a:r>
              <a:rPr sz="1200" b="1" i="1" dirty="0">
                <a:latin typeface="Calibri"/>
                <a:cs typeface="Calibri"/>
              </a:rPr>
              <a:t>2  A</a:t>
            </a:r>
            <a:r>
              <a:rPr sz="1200" b="1" i="1" spc="-5" dirty="0">
                <a:latin typeface="Calibri"/>
                <a:cs typeface="Calibri"/>
              </a:rPr>
              <a:t>R</a:t>
            </a:r>
            <a:r>
              <a:rPr sz="1200" b="1" i="1" dirty="0">
                <a:latin typeface="Calibri"/>
                <a:cs typeface="Calibri"/>
              </a:rPr>
              <a:t>I</a:t>
            </a:r>
            <a:r>
              <a:rPr sz="1200" b="1" i="1" spc="-5" dirty="0">
                <a:latin typeface="Calibri"/>
                <a:cs typeface="Calibri"/>
              </a:rPr>
              <a:t>D</a:t>
            </a:r>
            <a:r>
              <a:rPr sz="1200" b="1" i="1" spc="-10" dirty="0">
                <a:latin typeface="Calibri"/>
                <a:cs typeface="Calibri"/>
              </a:rPr>
              <a:t>1</a:t>
            </a:r>
            <a:r>
              <a:rPr sz="1200" b="1" i="1" dirty="0">
                <a:latin typeface="Calibri"/>
                <a:cs typeface="Calibri"/>
              </a:rPr>
              <a:t>A  A</a:t>
            </a:r>
            <a:r>
              <a:rPr sz="1200" b="1" i="1" spc="-5" dirty="0">
                <a:latin typeface="Calibri"/>
                <a:cs typeface="Calibri"/>
              </a:rPr>
              <a:t>R</a:t>
            </a:r>
            <a:r>
              <a:rPr sz="1200" b="1" i="1" dirty="0">
                <a:latin typeface="Calibri"/>
                <a:cs typeface="Calibri"/>
              </a:rPr>
              <a:t>I</a:t>
            </a:r>
            <a:r>
              <a:rPr sz="1200" b="1" i="1" spc="-5" dirty="0">
                <a:latin typeface="Calibri"/>
                <a:cs typeface="Calibri"/>
              </a:rPr>
              <a:t>D</a:t>
            </a:r>
            <a:r>
              <a:rPr sz="1200" b="1" i="1" spc="-10" dirty="0">
                <a:latin typeface="Calibri"/>
                <a:cs typeface="Calibri"/>
              </a:rPr>
              <a:t>1</a:t>
            </a:r>
            <a:r>
              <a:rPr sz="1200" b="1" i="1" dirty="0">
                <a:latin typeface="Calibri"/>
                <a:cs typeface="Calibri"/>
              </a:rPr>
              <a:t>B  S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A</a:t>
            </a:r>
            <a:r>
              <a:rPr sz="1200" b="1" i="1" spc="-5" dirty="0">
                <a:latin typeface="Calibri"/>
                <a:cs typeface="Calibri"/>
              </a:rPr>
              <a:t>D3</a:t>
            </a:r>
            <a:endParaRPr sz="1200">
              <a:latin typeface="Calibri"/>
              <a:cs typeface="Calibri"/>
            </a:endParaRPr>
          </a:p>
          <a:p>
            <a:pPr marL="119380" marR="25400" indent="192405" algn="r">
              <a:lnSpc>
                <a:spcPct val="64100"/>
              </a:lnSpc>
              <a:spcBef>
                <a:spcPts val="15"/>
              </a:spcBef>
            </a:pPr>
            <a:r>
              <a:rPr sz="1200" b="1" i="1" dirty="0">
                <a:latin typeface="Calibri"/>
                <a:cs typeface="Calibri"/>
              </a:rPr>
              <a:t>B</a:t>
            </a:r>
            <a:r>
              <a:rPr sz="1200" b="1" i="1" spc="-5" dirty="0">
                <a:latin typeface="Calibri"/>
                <a:cs typeface="Calibri"/>
              </a:rPr>
              <a:t>R</a:t>
            </a:r>
            <a:r>
              <a:rPr sz="1200" b="1" i="1" dirty="0">
                <a:latin typeface="Calibri"/>
                <a:cs typeface="Calibri"/>
              </a:rPr>
              <a:t>AF  </a:t>
            </a:r>
            <a:r>
              <a:rPr sz="1200" b="1" i="1" spc="-5" dirty="0">
                <a:latin typeface="Calibri"/>
                <a:cs typeface="Calibri"/>
              </a:rPr>
              <a:t>M</a:t>
            </a:r>
            <a:r>
              <a:rPr sz="1200" b="1" i="1" dirty="0">
                <a:latin typeface="Calibri"/>
                <a:cs typeface="Calibri"/>
              </a:rPr>
              <a:t>A</a:t>
            </a:r>
            <a:r>
              <a:rPr sz="1200" b="1" i="1" spc="-5" dirty="0">
                <a:latin typeface="Calibri"/>
                <a:cs typeface="Calibri"/>
              </a:rPr>
              <a:t>PK1  </a:t>
            </a:r>
            <a:r>
              <a:rPr sz="1200" b="1" i="1" dirty="0">
                <a:latin typeface="Calibri"/>
                <a:cs typeface="Calibri"/>
              </a:rPr>
              <a:t>T</a:t>
            </a:r>
            <a:r>
              <a:rPr sz="1200" b="1" i="1" spc="-10" dirty="0">
                <a:latin typeface="Calibri"/>
                <a:cs typeface="Calibri"/>
              </a:rPr>
              <a:t>N</a:t>
            </a:r>
            <a:r>
              <a:rPr sz="1200" b="1" i="1" dirty="0">
                <a:latin typeface="Calibri"/>
                <a:cs typeface="Calibri"/>
              </a:rPr>
              <a:t>FA</a:t>
            </a:r>
            <a:r>
              <a:rPr sz="1200" b="1" i="1" spc="-10" dirty="0">
                <a:latin typeface="Calibri"/>
                <a:cs typeface="Calibri"/>
              </a:rPr>
              <a:t>I</a:t>
            </a:r>
            <a:r>
              <a:rPr sz="1200" b="1" i="1" spc="5" dirty="0">
                <a:latin typeface="Calibri"/>
                <a:cs typeface="Calibri"/>
              </a:rPr>
              <a:t>P</a:t>
            </a:r>
            <a:r>
              <a:rPr sz="1200" b="1" i="1" dirty="0">
                <a:latin typeface="Calibri"/>
                <a:cs typeface="Calibri"/>
              </a:rPr>
              <a:t>3  FUB</a:t>
            </a:r>
            <a:r>
              <a:rPr sz="1200" b="1" i="1" spc="-10" dirty="0">
                <a:latin typeface="Calibri"/>
                <a:cs typeface="Calibri"/>
              </a:rPr>
              <a:t>P</a:t>
            </a:r>
            <a:r>
              <a:rPr sz="1200" b="1" i="1" dirty="0">
                <a:latin typeface="Calibri"/>
                <a:cs typeface="Calibri"/>
              </a:rPr>
              <a:t>1  TBX3  CC</a:t>
            </a:r>
            <a:r>
              <a:rPr sz="1200" b="1" i="1" spc="-5" dirty="0">
                <a:latin typeface="Calibri"/>
                <a:cs typeface="Calibri"/>
              </a:rPr>
              <a:t>ND1  </a:t>
            </a:r>
            <a:r>
              <a:rPr sz="1200" b="1" i="1" dirty="0">
                <a:latin typeface="Calibri"/>
                <a:cs typeface="Calibri"/>
              </a:rPr>
              <a:t>S</a:t>
            </a:r>
            <a:r>
              <a:rPr sz="1200" b="1" i="1" spc="-5" dirty="0">
                <a:latin typeface="Calibri"/>
                <a:cs typeface="Calibri"/>
              </a:rPr>
              <a:t>POP  R</a:t>
            </a:r>
            <a:r>
              <a:rPr sz="1200" b="1" i="1" spc="5" dirty="0">
                <a:latin typeface="Calibri"/>
                <a:cs typeface="Calibri"/>
              </a:rPr>
              <a:t>P</a:t>
            </a:r>
            <a:r>
              <a:rPr sz="1200" b="1" i="1" spc="-5" dirty="0">
                <a:latin typeface="Calibri"/>
                <a:cs typeface="Calibri"/>
              </a:rPr>
              <a:t>L</a:t>
            </a:r>
            <a:r>
              <a:rPr sz="1200" b="1" i="1" spc="-10" dirty="0">
                <a:latin typeface="Calibri"/>
                <a:cs typeface="Calibri"/>
              </a:rPr>
              <a:t>2</a:t>
            </a:r>
            <a:r>
              <a:rPr sz="1200" b="1" i="1" dirty="0">
                <a:latin typeface="Calibri"/>
                <a:cs typeface="Calibri"/>
              </a:rPr>
              <a:t>2</a:t>
            </a:r>
            <a:endParaRPr sz="1200">
              <a:latin typeface="Calibri"/>
              <a:cs typeface="Calibri"/>
            </a:endParaRPr>
          </a:p>
          <a:p>
            <a:pPr marL="174625" marR="5080" indent="250825" algn="r">
              <a:lnSpc>
                <a:spcPct val="62800"/>
              </a:lnSpc>
              <a:spcBef>
                <a:spcPts val="5"/>
              </a:spcBef>
            </a:pPr>
            <a:r>
              <a:rPr sz="1200" b="1" i="1" dirty="0">
                <a:latin typeface="Calibri"/>
                <a:cs typeface="Calibri"/>
              </a:rPr>
              <a:t>BAX  H</a:t>
            </a:r>
            <a:r>
              <a:rPr sz="1200" b="1" i="1" spc="-5" dirty="0">
                <a:latin typeface="Calibri"/>
                <a:cs typeface="Calibri"/>
              </a:rPr>
              <a:t>R</a:t>
            </a:r>
            <a:r>
              <a:rPr sz="1200" b="1" i="1" dirty="0">
                <a:latin typeface="Calibri"/>
                <a:cs typeface="Calibri"/>
              </a:rPr>
              <a:t>AS  </a:t>
            </a:r>
            <a:r>
              <a:rPr sz="1200" b="1" i="1" spc="-5" dirty="0">
                <a:latin typeface="Calibri"/>
                <a:cs typeface="Calibri"/>
              </a:rPr>
              <a:t>R</a:t>
            </a:r>
            <a:r>
              <a:rPr sz="1200" b="1" i="1" dirty="0">
                <a:latin typeface="Calibri"/>
                <a:cs typeface="Calibri"/>
              </a:rPr>
              <a:t>ET  CDK</a:t>
            </a:r>
            <a:r>
              <a:rPr sz="1200" b="1" i="1" spc="-10" dirty="0">
                <a:latin typeface="Calibri"/>
                <a:cs typeface="Calibri"/>
              </a:rPr>
              <a:t>N</a:t>
            </a:r>
            <a:r>
              <a:rPr sz="1200" b="1" i="1" dirty="0">
                <a:latin typeface="Calibri"/>
                <a:cs typeface="Calibri"/>
              </a:rPr>
              <a:t>2A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5181346" y="6103416"/>
            <a:ext cx="225361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Calibri"/>
                <a:cs typeface="Calibri"/>
              </a:rPr>
              <a:t>Log </a:t>
            </a:r>
            <a:r>
              <a:rPr sz="1400" b="1" dirty="0">
                <a:latin typeface="Calibri"/>
                <a:cs typeface="Calibri"/>
              </a:rPr>
              <a:t>2 </a:t>
            </a:r>
            <a:r>
              <a:rPr sz="1400" b="1" spc="-5" dirty="0">
                <a:latin typeface="Calibri"/>
                <a:cs typeface="Calibri"/>
              </a:rPr>
              <a:t>Fold Expression</a:t>
            </a:r>
            <a:r>
              <a:rPr sz="1400" b="1" spc="-70" dirty="0">
                <a:latin typeface="Calibri"/>
                <a:cs typeface="Calibri"/>
              </a:rPr>
              <a:t> </a:t>
            </a:r>
            <a:r>
              <a:rPr sz="1400" b="1" spc="-5" dirty="0">
                <a:latin typeface="Calibri"/>
                <a:cs typeface="Calibri"/>
              </a:rPr>
              <a:t>Changes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0" name="object 10"/>
          <p:cNvSpPr txBox="1">
            <a:spLocks noGrp="1"/>
          </p:cNvSpPr>
          <p:nvPr>
            <p:ph type="title"/>
          </p:nvPr>
        </p:nvSpPr>
        <p:spPr>
          <a:xfrm>
            <a:off x="2690876" y="358902"/>
            <a:ext cx="68072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20" dirty="0">
                <a:latin typeface="Calibri"/>
                <a:cs typeface="Calibri"/>
              </a:rPr>
              <a:t>Effects </a:t>
            </a:r>
            <a:r>
              <a:rPr sz="1800" b="1" dirty="0">
                <a:latin typeface="Calibri"/>
                <a:cs typeface="Calibri"/>
              </a:rPr>
              <a:t>of the </a:t>
            </a:r>
            <a:r>
              <a:rPr sz="1800" b="1" spc="-5" dirty="0">
                <a:latin typeface="Calibri"/>
                <a:cs typeface="Calibri"/>
              </a:rPr>
              <a:t>fb-PMT </a:t>
            </a:r>
            <a:r>
              <a:rPr sz="1800" b="1" dirty="0">
                <a:latin typeface="Calibri"/>
                <a:cs typeface="Calibri"/>
              </a:rPr>
              <a:t>on </a:t>
            </a:r>
            <a:r>
              <a:rPr sz="1800" b="1" spc="-5" dirty="0">
                <a:latin typeface="Calibri"/>
                <a:cs typeface="Calibri"/>
              </a:rPr>
              <a:t>expression </a:t>
            </a:r>
            <a:r>
              <a:rPr sz="1800" b="1" dirty="0">
                <a:latin typeface="Calibri"/>
                <a:cs typeface="Calibri"/>
              </a:rPr>
              <a:t>of </a:t>
            </a:r>
            <a:r>
              <a:rPr sz="1800" b="1" spc="-5" dirty="0">
                <a:latin typeface="Calibri"/>
                <a:cs typeface="Calibri"/>
              </a:rPr>
              <a:t>cancer driver </a:t>
            </a:r>
            <a:r>
              <a:rPr sz="1800" b="1" spc="-10" dirty="0">
                <a:latin typeface="Calibri"/>
                <a:cs typeface="Calibri"/>
              </a:rPr>
              <a:t>genes </a:t>
            </a:r>
            <a:r>
              <a:rPr sz="1800" b="1" dirty="0">
                <a:latin typeface="Calibri"/>
                <a:cs typeface="Calibri"/>
              </a:rPr>
              <a:t>(p adj =</a:t>
            </a:r>
            <a:r>
              <a:rPr sz="1800" b="1" spc="-60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0.05)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6740143" y="2311145"/>
            <a:ext cx="1670050" cy="51308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7145" marR="5080" indent="-5080">
              <a:lnSpc>
                <a:spcPct val="100000"/>
              </a:lnSpc>
              <a:spcBef>
                <a:spcPts val="95"/>
              </a:spcBef>
            </a:pPr>
            <a:r>
              <a:rPr sz="1600" b="1" spc="-5" dirty="0">
                <a:latin typeface="Calibri"/>
                <a:cs typeface="Calibri"/>
              </a:rPr>
              <a:t>28 down-regulated  cancer </a:t>
            </a:r>
            <a:r>
              <a:rPr sz="1600" b="1" spc="-10" dirty="0">
                <a:latin typeface="Calibri"/>
                <a:cs typeface="Calibri"/>
              </a:rPr>
              <a:t>driver</a:t>
            </a:r>
            <a:r>
              <a:rPr sz="1600" b="1" dirty="0">
                <a:latin typeface="Calibri"/>
                <a:cs typeface="Calibri"/>
              </a:rPr>
              <a:t> </a:t>
            </a:r>
            <a:r>
              <a:rPr sz="1600" b="1" spc="-10" dirty="0">
                <a:latin typeface="Calibri"/>
                <a:cs typeface="Calibri"/>
              </a:rPr>
              <a:t>genes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4300854" y="4691253"/>
            <a:ext cx="1263650" cy="26924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600" b="1" spc="-5" dirty="0">
                <a:latin typeface="Calibri"/>
                <a:cs typeface="Calibri"/>
              </a:rPr>
              <a:t>6</a:t>
            </a:r>
            <a:r>
              <a:rPr sz="1600" b="1" spc="-65" dirty="0">
                <a:latin typeface="Calibri"/>
                <a:cs typeface="Calibri"/>
              </a:rPr>
              <a:t> </a:t>
            </a:r>
            <a:r>
              <a:rPr sz="1600" b="1" spc="-5" dirty="0">
                <a:latin typeface="Calibri"/>
                <a:cs typeface="Calibri"/>
              </a:rPr>
              <a:t>up-regulated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4092321" y="4883906"/>
            <a:ext cx="1697355" cy="658495"/>
          </a:xfrm>
          <a:prstGeom prst="rect">
            <a:avLst/>
          </a:prstGeom>
        </p:spPr>
        <p:txBody>
          <a:bodyPr vert="horz" wrap="square" lIns="0" tIns="63500" rIns="0" bIns="0" rtlCol="0">
            <a:spAutoFit/>
          </a:bodyPr>
          <a:lstStyle/>
          <a:p>
            <a:pPr marL="44450">
              <a:lnSpc>
                <a:spcPct val="100000"/>
              </a:lnSpc>
              <a:spcBef>
                <a:spcPts val="500"/>
              </a:spcBef>
            </a:pPr>
            <a:r>
              <a:rPr sz="1600" b="1" spc="-5" dirty="0">
                <a:latin typeface="Calibri"/>
                <a:cs typeface="Calibri"/>
              </a:rPr>
              <a:t>cancer </a:t>
            </a:r>
            <a:r>
              <a:rPr sz="1600" b="1" spc="-10" dirty="0">
                <a:latin typeface="Calibri"/>
                <a:cs typeface="Calibri"/>
              </a:rPr>
              <a:t>driver</a:t>
            </a:r>
            <a:r>
              <a:rPr sz="1600" b="1" spc="5" dirty="0">
                <a:latin typeface="Calibri"/>
                <a:cs typeface="Calibri"/>
              </a:rPr>
              <a:t> </a:t>
            </a:r>
            <a:r>
              <a:rPr sz="1600" b="1" spc="-10" dirty="0">
                <a:latin typeface="Calibri"/>
                <a:cs typeface="Calibri"/>
              </a:rPr>
              <a:t>genes</a:t>
            </a:r>
            <a:endParaRPr sz="1600">
              <a:latin typeface="Calibri"/>
              <a:cs typeface="Calibri"/>
            </a:endParaRPr>
          </a:p>
          <a:p>
            <a:pPr marL="12700">
              <a:lnSpc>
                <a:spcPts val="1190"/>
              </a:lnSpc>
              <a:spcBef>
                <a:spcPts val="280"/>
              </a:spcBef>
            </a:pPr>
            <a:r>
              <a:rPr sz="1100" b="1" spc="-5" dirty="0">
                <a:latin typeface="Calibri"/>
                <a:cs typeface="Calibri"/>
              </a:rPr>
              <a:t>-1</a:t>
            </a:r>
            <a:endParaRPr sz="1100">
              <a:latin typeface="Calibri"/>
              <a:cs typeface="Calibri"/>
            </a:endParaRPr>
          </a:p>
          <a:p>
            <a:pPr marL="927735">
              <a:lnSpc>
                <a:spcPts val="1190"/>
              </a:lnSpc>
            </a:pPr>
            <a:r>
              <a:rPr sz="1100" b="1" spc="-5" dirty="0">
                <a:latin typeface="Calibri"/>
                <a:cs typeface="Calibri"/>
              </a:rPr>
              <a:t>-0.5</a:t>
            </a:r>
            <a:endParaRPr sz="11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6926689"/>
              </p:ext>
            </p:extLst>
          </p:nvPr>
        </p:nvGraphicFramePr>
        <p:xfrm>
          <a:off x="228600" y="381000"/>
          <a:ext cx="8664539" cy="6284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0091155"/>
              </p:ext>
            </p:extLst>
          </p:nvPr>
        </p:nvGraphicFramePr>
        <p:xfrm>
          <a:off x="8153400" y="4343400"/>
          <a:ext cx="3505200" cy="18471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505200"/>
              </a:tblGrid>
              <a:tr h="12035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CDKN2A</a:t>
                      </a:r>
                      <a:r>
                        <a:rPr lang="en-US" sz="1200" b="1" u="none" strike="noStrike" dirty="0">
                          <a:effectLst/>
                        </a:rPr>
                        <a:t>: negative regulator of cell </a:t>
                      </a:r>
                      <a:r>
                        <a:rPr lang="en-US" sz="1200" b="1" u="none" strike="noStrike" dirty="0" smtClean="0">
                          <a:effectLst/>
                        </a:rPr>
                        <a:t>proliferat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62" marR="3062" marT="3062" marB="0" anchor="b"/>
                </a:tc>
              </a:tr>
              <a:tr h="23980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RET</a:t>
                      </a:r>
                      <a:r>
                        <a:rPr lang="en-US" sz="1200" b="1" u="none" strike="noStrike" dirty="0">
                          <a:effectLst/>
                        </a:rPr>
                        <a:t>: dependence receptor (GDNF is a ligand); triggers apoptosis in the absence of the GDNF</a:t>
                      </a:r>
                      <a:endParaRPr lang="en-US" sz="1200" b="1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62" marR="3062" marT="3062" marB="0" anchor="b"/>
                </a:tc>
              </a:tr>
              <a:tr h="36235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62" marR="3062" marT="3062" marB="0" anchor="b"/>
                </a:tc>
              </a:tr>
              <a:tr h="6062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BAX</a:t>
                      </a:r>
                      <a:r>
                        <a:rPr lang="en-US" sz="1200" b="1" u="none" strike="noStrike" dirty="0">
                          <a:effectLst/>
                        </a:rPr>
                        <a:t>: inducer of apoptosi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62" marR="3062" marT="3062" marB="0" anchor="b"/>
                </a:tc>
              </a:tr>
              <a:tr h="8053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RPL22</a:t>
                      </a:r>
                      <a:r>
                        <a:rPr lang="en-US" sz="1200" b="1" u="none" strike="noStrike" dirty="0">
                          <a:effectLst/>
                        </a:rPr>
                        <a:t>: tumor suppresso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62" marR="3062" marT="3062" marB="0" anchor="b"/>
                </a:tc>
              </a:tr>
              <a:tr h="48955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FF0000"/>
                          </a:solidFill>
                          <a:effectLst/>
                        </a:rPr>
                        <a:t>SPOP</a:t>
                      </a:r>
                      <a:r>
                        <a:rPr lang="en-US" sz="1200" b="1" u="none" strike="noStrike" dirty="0">
                          <a:effectLst/>
                        </a:rPr>
                        <a:t>: Inhibits IPF1/PDX1 transactivation of established target promoters, such as insulin</a:t>
                      </a:r>
                      <a:r>
                        <a:rPr lang="en-US" sz="1200" b="1" u="none" strike="noStrike" dirty="0" smtClean="0">
                          <a:effectLst/>
                        </a:rPr>
                        <a:t>, </a:t>
                      </a:r>
                      <a:r>
                        <a:rPr lang="en-US" sz="1200" b="1" u="none" strike="noStrike" dirty="0">
                          <a:effectLst/>
                        </a:rPr>
                        <a:t>by recruiting a repressor complex. In complex with CUL3, involved in ubiquitination of BMI1, H2AFY and DAX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062" marR="3062" marT="3062" marB="0" anchor="b"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914400" y="4419600"/>
            <a:ext cx="762000" cy="762000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08969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73025" rIns="0" bIns="0" rtlCol="0">
            <a:spAutoFit/>
          </a:bodyPr>
          <a:lstStyle/>
          <a:p>
            <a:pPr marL="86995" marR="5080" algn="ctr">
              <a:lnSpc>
                <a:spcPct val="90000"/>
              </a:lnSpc>
              <a:spcBef>
                <a:spcPts val="575"/>
              </a:spcBef>
            </a:pPr>
            <a:r>
              <a:rPr spc="-30" dirty="0"/>
              <a:t>fb-PMT </a:t>
            </a:r>
            <a:r>
              <a:rPr spc="-60" dirty="0"/>
              <a:t>effects </a:t>
            </a:r>
            <a:r>
              <a:rPr spc="-15" dirty="0"/>
              <a:t>on </a:t>
            </a:r>
            <a:r>
              <a:rPr i="1" spc="-20" dirty="0">
                <a:latin typeface="Calibri Light"/>
                <a:cs typeface="Calibri Light"/>
              </a:rPr>
              <a:t>RET </a:t>
            </a:r>
            <a:r>
              <a:rPr spc="-20" dirty="0"/>
              <a:t>and </a:t>
            </a:r>
            <a:r>
              <a:rPr i="1" spc="-30" dirty="0">
                <a:latin typeface="Calibri Light"/>
                <a:cs typeface="Calibri Light"/>
              </a:rPr>
              <a:t>GDNF </a:t>
            </a:r>
            <a:r>
              <a:rPr spc="-40" dirty="0"/>
              <a:t>expression</a:t>
            </a:r>
            <a:r>
              <a:rPr spc="-370" dirty="0"/>
              <a:t> </a:t>
            </a:r>
            <a:r>
              <a:rPr spc="-30" dirty="0"/>
              <a:t>could  </a:t>
            </a:r>
            <a:r>
              <a:rPr spc="-20" dirty="0"/>
              <a:t>be </a:t>
            </a:r>
            <a:r>
              <a:rPr spc="-35" dirty="0"/>
              <a:t>sufficient </a:t>
            </a:r>
            <a:r>
              <a:rPr spc="-30" dirty="0"/>
              <a:t>to </a:t>
            </a:r>
            <a:r>
              <a:rPr spc="-25" dirty="0"/>
              <a:t>induce </a:t>
            </a:r>
            <a:r>
              <a:rPr spc="-20" dirty="0"/>
              <a:t>the </a:t>
            </a:r>
            <a:r>
              <a:rPr spc="-55" dirty="0"/>
              <a:t>programmed </a:t>
            </a:r>
            <a:r>
              <a:rPr spc="-15" dirty="0"/>
              <a:t>cell</a:t>
            </a:r>
            <a:r>
              <a:rPr spc="-415" dirty="0"/>
              <a:t> </a:t>
            </a:r>
            <a:r>
              <a:rPr spc="-35" dirty="0"/>
              <a:t>death  (apoptosis) </a:t>
            </a:r>
            <a:r>
              <a:rPr spc="-15" dirty="0"/>
              <a:t>of </a:t>
            </a:r>
            <a:r>
              <a:rPr spc="-40" dirty="0"/>
              <a:t>glioblastoma</a:t>
            </a:r>
            <a:r>
              <a:rPr spc="-175" dirty="0"/>
              <a:t> </a:t>
            </a:r>
            <a:r>
              <a:rPr spc="-20" dirty="0"/>
              <a:t>cells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1147063" y="2043176"/>
            <a:ext cx="10002520" cy="434784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718185" algn="ctr">
              <a:lnSpc>
                <a:spcPct val="100000"/>
              </a:lnSpc>
              <a:spcBef>
                <a:spcPts val="105"/>
              </a:spcBef>
            </a:pPr>
            <a:r>
              <a:rPr sz="1400" b="1" i="1" spc="-5" dirty="0">
                <a:latin typeface="Arial"/>
                <a:cs typeface="Arial"/>
              </a:rPr>
              <a:t>RET </a:t>
            </a:r>
            <a:r>
              <a:rPr sz="1400" b="1" spc="-5" dirty="0">
                <a:latin typeface="Arial"/>
                <a:cs typeface="Arial"/>
              </a:rPr>
              <a:t>FUNCTIONS:</a:t>
            </a:r>
            <a:endParaRPr sz="1400">
              <a:latin typeface="Arial"/>
              <a:cs typeface="Arial"/>
            </a:endParaRPr>
          </a:p>
          <a:p>
            <a:pPr marL="2616200" marR="1894205" indent="1905" algn="ctr">
              <a:lnSpc>
                <a:spcPct val="99100"/>
              </a:lnSpc>
              <a:spcBef>
                <a:spcPts val="15"/>
              </a:spcBef>
            </a:pPr>
            <a:r>
              <a:rPr sz="1400" b="1" spc="-5" dirty="0">
                <a:latin typeface="Arial"/>
                <a:cs typeface="Arial"/>
              </a:rPr>
              <a:t>Regulates both </a:t>
            </a:r>
            <a:r>
              <a:rPr sz="1400" b="1" dirty="0">
                <a:latin typeface="Arial"/>
                <a:cs typeface="Arial"/>
              </a:rPr>
              <a:t>cell </a:t>
            </a:r>
            <a:r>
              <a:rPr sz="1400" b="1" spc="-5" dirty="0">
                <a:latin typeface="Arial"/>
                <a:cs typeface="Arial"/>
              </a:rPr>
              <a:t>death/survival balance and positional  information. </a:t>
            </a:r>
            <a:r>
              <a:rPr sz="1400" b="1" spc="-5" dirty="0">
                <a:latin typeface="Calibri"/>
                <a:cs typeface="Calibri"/>
              </a:rPr>
              <a:t>Modulates cell </a:t>
            </a:r>
            <a:r>
              <a:rPr sz="1400" b="1" dirty="0">
                <a:latin typeface="Calibri"/>
                <a:cs typeface="Calibri"/>
              </a:rPr>
              <a:t>adhesion </a:t>
            </a:r>
            <a:r>
              <a:rPr sz="1400" b="1" spc="-5" dirty="0">
                <a:latin typeface="Calibri"/>
                <a:cs typeface="Calibri"/>
              </a:rPr>
              <a:t>via </a:t>
            </a:r>
            <a:r>
              <a:rPr sz="1400" b="1" dirty="0">
                <a:latin typeface="Calibri"/>
                <a:cs typeface="Calibri"/>
              </a:rPr>
              <a:t>its </a:t>
            </a:r>
            <a:r>
              <a:rPr sz="1400" b="1" spc="-10" dirty="0">
                <a:latin typeface="Calibri"/>
                <a:cs typeface="Calibri"/>
              </a:rPr>
              <a:t>cleavage </a:t>
            </a:r>
            <a:r>
              <a:rPr sz="1400" b="1" spc="-5" dirty="0">
                <a:latin typeface="Calibri"/>
                <a:cs typeface="Calibri"/>
              </a:rPr>
              <a:t>by caspase </a:t>
            </a:r>
            <a:r>
              <a:rPr sz="1400" b="1" dirty="0">
                <a:latin typeface="Calibri"/>
                <a:cs typeface="Calibri"/>
              </a:rPr>
              <a:t>in  </a:t>
            </a:r>
            <a:r>
              <a:rPr sz="1400" b="1" spc="-5" dirty="0">
                <a:latin typeface="Calibri"/>
                <a:cs typeface="Calibri"/>
              </a:rPr>
              <a:t>sympathetic </a:t>
            </a:r>
            <a:r>
              <a:rPr sz="1400" b="1" dirty="0">
                <a:latin typeface="Calibri"/>
                <a:cs typeface="Calibri"/>
              </a:rPr>
              <a:t>neurons and </a:t>
            </a:r>
            <a:r>
              <a:rPr sz="1400" b="1" spc="-5" dirty="0">
                <a:latin typeface="Calibri"/>
                <a:cs typeface="Calibri"/>
              </a:rPr>
              <a:t>mediates cell migration </a:t>
            </a:r>
            <a:r>
              <a:rPr sz="1400" b="1" dirty="0">
                <a:latin typeface="Calibri"/>
                <a:cs typeface="Calibri"/>
              </a:rPr>
              <a:t>in an </a:t>
            </a:r>
            <a:r>
              <a:rPr sz="1400" b="1" spc="-5" dirty="0">
                <a:latin typeface="Calibri"/>
                <a:cs typeface="Calibri"/>
              </a:rPr>
              <a:t>integrin (e.g.</a:t>
            </a:r>
            <a:r>
              <a:rPr sz="1400" b="1" spc="-200" dirty="0">
                <a:latin typeface="Calibri"/>
                <a:cs typeface="Calibri"/>
              </a:rPr>
              <a:t> </a:t>
            </a:r>
            <a:r>
              <a:rPr sz="1400" b="1" spc="-5" dirty="0">
                <a:latin typeface="Calibri"/>
                <a:cs typeface="Calibri"/>
              </a:rPr>
              <a:t>ITGB1  </a:t>
            </a:r>
            <a:r>
              <a:rPr sz="1400" b="1" dirty="0">
                <a:latin typeface="Calibri"/>
                <a:cs typeface="Calibri"/>
              </a:rPr>
              <a:t>and </a:t>
            </a:r>
            <a:r>
              <a:rPr sz="1400" b="1" spc="-5" dirty="0">
                <a:latin typeface="Calibri"/>
                <a:cs typeface="Calibri"/>
              </a:rPr>
              <a:t>ITGB3)-dependent</a:t>
            </a:r>
            <a:r>
              <a:rPr sz="1400" b="1" spc="-70" dirty="0">
                <a:latin typeface="Calibri"/>
                <a:cs typeface="Calibri"/>
              </a:rPr>
              <a:t> </a:t>
            </a:r>
            <a:r>
              <a:rPr sz="1400" b="1" spc="-20" dirty="0">
                <a:latin typeface="Calibri"/>
                <a:cs typeface="Calibri"/>
              </a:rPr>
              <a:t>manner.</a:t>
            </a:r>
            <a:endParaRPr sz="1400">
              <a:latin typeface="Calibri"/>
              <a:cs typeface="Calibri"/>
            </a:endParaRPr>
          </a:p>
          <a:p>
            <a:pPr marL="2637155" marR="1914525" algn="ctr">
              <a:lnSpc>
                <a:spcPct val="100000"/>
              </a:lnSpc>
            </a:pP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Active in the absence of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ligand,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triggering apoptosis through a</a:t>
            </a:r>
            <a:r>
              <a:rPr sz="1400" b="1" spc="-229" dirty="0">
                <a:solidFill>
                  <a:srgbClr val="00AFEF"/>
                </a:solidFill>
                <a:latin typeface="Calibri"/>
                <a:cs typeface="Calibri"/>
              </a:rPr>
              <a:t>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mechanism  that requires receptor intracellular caspase </a:t>
            </a:r>
            <a:r>
              <a:rPr sz="1400" b="1" spc="-10" dirty="0">
                <a:solidFill>
                  <a:srgbClr val="00AFEF"/>
                </a:solidFill>
                <a:latin typeface="Calibri"/>
                <a:cs typeface="Calibri"/>
              </a:rPr>
              <a:t>cleavage.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Acts as a 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dependence receptor;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in the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presence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of the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ligand </a:t>
            </a:r>
            <a:r>
              <a:rPr sz="1400" b="1" spc="-25" dirty="0">
                <a:solidFill>
                  <a:srgbClr val="00AFEF"/>
                </a:solidFill>
                <a:latin typeface="Calibri"/>
                <a:cs typeface="Calibri"/>
              </a:rPr>
              <a:t>GDNF,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promotes  survival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and down </a:t>
            </a:r>
            <a:r>
              <a:rPr sz="1400" b="1" spc="-10" dirty="0">
                <a:solidFill>
                  <a:srgbClr val="00AFEF"/>
                </a:solidFill>
                <a:latin typeface="Calibri"/>
                <a:cs typeface="Calibri"/>
              </a:rPr>
              <a:t>regulates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growth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hormone (GH)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production,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but  </a:t>
            </a:r>
            <a:r>
              <a:rPr sz="1400" b="1" spc="-5" dirty="0">
                <a:solidFill>
                  <a:srgbClr val="00AFEF"/>
                </a:solidFill>
                <a:latin typeface="Calibri"/>
                <a:cs typeface="Calibri"/>
              </a:rPr>
              <a:t>triggers </a:t>
            </a:r>
            <a:r>
              <a:rPr sz="1400" b="1" dirty="0">
                <a:solidFill>
                  <a:srgbClr val="00AFEF"/>
                </a:solidFill>
                <a:latin typeface="Calibri"/>
                <a:cs typeface="Calibri"/>
              </a:rPr>
              <a:t>apoptosis in absence of</a:t>
            </a:r>
            <a:r>
              <a:rPr sz="1400" b="1" spc="-135" dirty="0">
                <a:solidFill>
                  <a:srgbClr val="00AFEF"/>
                </a:solidFill>
                <a:latin typeface="Calibri"/>
                <a:cs typeface="Calibri"/>
              </a:rPr>
              <a:t> </a:t>
            </a:r>
            <a:r>
              <a:rPr sz="1400" b="1" spc="-20" dirty="0">
                <a:solidFill>
                  <a:srgbClr val="00AFEF"/>
                </a:solidFill>
                <a:latin typeface="Calibri"/>
                <a:cs typeface="Calibri"/>
              </a:rPr>
              <a:t>GDNF.</a:t>
            </a:r>
            <a:endParaRPr sz="140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450">
              <a:latin typeface="Times New Roman"/>
              <a:cs typeface="Times New Roman"/>
            </a:endParaRPr>
          </a:p>
          <a:p>
            <a:pPr marL="2623820" marR="1902460" algn="ctr">
              <a:lnSpc>
                <a:spcPct val="100000"/>
              </a:lnSpc>
            </a:pP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fb-PMT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significantly inhibits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the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GDNF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expression, thus removing  the survival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ligand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for dependence receptor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RET and triggering 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the </a:t>
            </a:r>
            <a:r>
              <a:rPr sz="1600" b="1" spc="-15" dirty="0">
                <a:solidFill>
                  <a:srgbClr val="FF0000"/>
                </a:solidFill>
                <a:latin typeface="Calibri"/>
                <a:cs typeface="Calibri"/>
              </a:rPr>
              <a:t>programmed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cell </a:t>
            </a:r>
            <a:r>
              <a:rPr sz="1600" b="1" spc="-10" dirty="0">
                <a:solidFill>
                  <a:srgbClr val="FF0000"/>
                </a:solidFill>
                <a:latin typeface="Calibri"/>
                <a:cs typeface="Calibri"/>
              </a:rPr>
              <a:t>death</a:t>
            </a:r>
            <a:r>
              <a:rPr sz="1600" b="1" spc="6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600" b="1" spc="-5" dirty="0">
                <a:solidFill>
                  <a:srgbClr val="FF0000"/>
                </a:solidFill>
                <a:latin typeface="Calibri"/>
                <a:cs typeface="Calibri"/>
              </a:rPr>
              <a:t>(apoptosis).</a:t>
            </a:r>
            <a:endParaRPr sz="16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2250">
              <a:latin typeface="Times New Roman"/>
              <a:cs typeface="Times New Roman"/>
            </a:endParaRPr>
          </a:p>
          <a:p>
            <a:pPr algn="ctr">
              <a:lnSpc>
                <a:spcPct val="100000"/>
              </a:lnSpc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events regulated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by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Ret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tyrosine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kinase Homo sapiens</a:t>
            </a:r>
            <a:r>
              <a:rPr sz="1800" b="1" spc="-2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e4431190-6195-11e5-8ac5-06603eb7f303</a:t>
            </a:r>
            <a:endParaRPr sz="1800">
              <a:latin typeface="Calibri"/>
              <a:cs typeface="Calibri"/>
            </a:endParaRPr>
          </a:p>
          <a:p>
            <a:pPr algn="ctr">
              <a:lnSpc>
                <a:spcPct val="100000"/>
              </a:lnSpc>
              <a:spcBef>
                <a:spcPts val="5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(</a:t>
            </a:r>
            <a:r>
              <a:rPr sz="1800" b="1" spc="-5" dirty="0">
                <a:latin typeface="Calibri"/>
                <a:cs typeface="Calibri"/>
              </a:rPr>
              <a:t>genes </a:t>
            </a:r>
            <a:r>
              <a:rPr sz="1800" b="1" spc="-10" dirty="0">
                <a:latin typeface="Calibri"/>
                <a:cs typeface="Calibri"/>
              </a:rPr>
              <a:t>significantly down-regulated </a:t>
            </a:r>
            <a:r>
              <a:rPr sz="1800" b="1" spc="-5" dirty="0">
                <a:latin typeface="Calibri"/>
                <a:cs typeface="Calibri"/>
              </a:rPr>
              <a:t>by</a:t>
            </a:r>
            <a:r>
              <a:rPr sz="1800" b="1" spc="-60" dirty="0">
                <a:latin typeface="Calibri"/>
                <a:cs typeface="Calibri"/>
              </a:rPr>
              <a:t> </a:t>
            </a:r>
            <a:r>
              <a:rPr sz="1800" b="1" spc="-5" dirty="0">
                <a:latin typeface="Calibri"/>
                <a:cs typeface="Calibri"/>
              </a:rPr>
              <a:t>fb-PMT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)</a:t>
            </a:r>
            <a:endParaRPr sz="1800">
              <a:latin typeface="Calibri"/>
              <a:cs typeface="Calibri"/>
            </a:endParaRPr>
          </a:p>
          <a:p>
            <a:pPr marR="88900" algn="ctr">
              <a:lnSpc>
                <a:spcPct val="100000"/>
              </a:lnSpc>
              <a:spcBef>
                <a:spcPts val="765"/>
              </a:spcBef>
            </a:pPr>
            <a:r>
              <a:rPr sz="1800" b="1" i="1" spc="-10" dirty="0">
                <a:latin typeface="Calibri"/>
                <a:cs typeface="Calibri"/>
              </a:rPr>
              <a:t>GDNF;IRS1;GRB10;MAPK1;PRKCA</a:t>
            </a:r>
            <a:endParaRPr sz="18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656332" y="1036319"/>
            <a:ext cx="7519416" cy="4791456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3205733" y="5082032"/>
            <a:ext cx="30797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Calibri"/>
                <a:cs typeface="Calibri"/>
              </a:rPr>
              <a:t>-1.</a:t>
            </a:r>
            <a:r>
              <a:rPr sz="1400" b="1" dirty="0">
                <a:latin typeface="Calibri"/>
                <a:cs typeface="Calibri"/>
              </a:rPr>
              <a:t>5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4179189" y="5192014"/>
            <a:ext cx="171450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Calibri"/>
                <a:cs typeface="Calibri"/>
              </a:rPr>
              <a:t>-1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5049773" y="5324983"/>
            <a:ext cx="30797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Calibri"/>
                <a:cs typeface="Calibri"/>
              </a:rPr>
              <a:t>-0.</a:t>
            </a:r>
            <a:r>
              <a:rPr sz="1400" b="1" dirty="0">
                <a:latin typeface="Calibri"/>
                <a:cs typeface="Calibri"/>
              </a:rPr>
              <a:t>5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6121146" y="5440781"/>
            <a:ext cx="1162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Calibri"/>
                <a:cs typeface="Calibri"/>
              </a:rPr>
              <a:t>0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7066026" y="5583428"/>
            <a:ext cx="252729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Calibri"/>
                <a:cs typeface="Calibri"/>
              </a:rPr>
              <a:t>0.5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8189468" y="5713272"/>
            <a:ext cx="1162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Calibri"/>
                <a:cs typeface="Calibri"/>
              </a:rPr>
              <a:t>1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9218168" y="5866891"/>
            <a:ext cx="252729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Calibri"/>
                <a:cs typeface="Calibri"/>
              </a:rPr>
              <a:t>1.5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2764027" y="4215510"/>
            <a:ext cx="414655" cy="75755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51435" marR="5080" indent="-38735" algn="just">
              <a:lnSpc>
                <a:spcPct val="100200"/>
              </a:lnSpc>
              <a:spcBef>
                <a:spcPts val="90"/>
              </a:spcBef>
            </a:pPr>
            <a:r>
              <a:rPr sz="1600" b="1" i="1" dirty="0">
                <a:latin typeface="Calibri"/>
                <a:cs typeface="Calibri"/>
              </a:rPr>
              <a:t>BAD  </a:t>
            </a:r>
            <a:r>
              <a:rPr sz="1600" b="1" i="1" spc="-5" dirty="0">
                <a:latin typeface="Calibri"/>
                <a:cs typeface="Calibri"/>
              </a:rPr>
              <a:t>BID  </a:t>
            </a:r>
            <a:r>
              <a:rPr sz="1600" b="1" i="1" dirty="0">
                <a:latin typeface="Calibri"/>
                <a:cs typeface="Calibri"/>
              </a:rPr>
              <a:t>BAX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436622" y="2430932"/>
            <a:ext cx="695325" cy="1557020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 marR="41275" indent="48260" algn="just">
              <a:lnSpc>
                <a:spcPct val="105500"/>
              </a:lnSpc>
              <a:spcBef>
                <a:spcPts val="110"/>
              </a:spcBef>
            </a:pPr>
            <a:r>
              <a:rPr sz="1600" b="1" i="1" spc="-5" dirty="0">
                <a:latin typeface="Calibri"/>
                <a:cs typeface="Calibri"/>
              </a:rPr>
              <a:t>PRKCA  </a:t>
            </a:r>
            <a:r>
              <a:rPr sz="1600" b="1" i="1" dirty="0">
                <a:latin typeface="Calibri"/>
                <a:cs typeface="Calibri"/>
              </a:rPr>
              <a:t>M</a:t>
            </a:r>
            <a:r>
              <a:rPr sz="1600" b="1" i="1" spc="-15" dirty="0">
                <a:latin typeface="Calibri"/>
                <a:cs typeface="Calibri"/>
              </a:rPr>
              <a:t>A</a:t>
            </a:r>
            <a:r>
              <a:rPr sz="1600" b="1" i="1" spc="-10" dirty="0">
                <a:latin typeface="Calibri"/>
                <a:cs typeface="Calibri"/>
              </a:rPr>
              <a:t>P</a:t>
            </a:r>
            <a:r>
              <a:rPr sz="1600" b="1" i="1" spc="-5" dirty="0">
                <a:latin typeface="Calibri"/>
                <a:cs typeface="Calibri"/>
              </a:rPr>
              <a:t>K1  GRB10</a:t>
            </a:r>
            <a:endParaRPr sz="1600">
              <a:latin typeface="Calibri"/>
              <a:cs typeface="Calibri"/>
            </a:endParaRPr>
          </a:p>
          <a:p>
            <a:pPr marL="186690" marR="15875" indent="106045">
              <a:lnSpc>
                <a:spcPct val="103600"/>
              </a:lnSpc>
              <a:spcBef>
                <a:spcPts val="15"/>
              </a:spcBef>
            </a:pPr>
            <a:r>
              <a:rPr sz="1600" b="1" i="1" dirty="0">
                <a:latin typeface="Calibri"/>
                <a:cs typeface="Calibri"/>
              </a:rPr>
              <a:t>I</a:t>
            </a:r>
            <a:r>
              <a:rPr sz="1600" b="1" i="1" spc="-5" dirty="0">
                <a:latin typeface="Calibri"/>
                <a:cs typeface="Calibri"/>
              </a:rPr>
              <a:t>RS1  </a:t>
            </a:r>
            <a:r>
              <a:rPr sz="1600" b="1" i="1" spc="-10" dirty="0">
                <a:latin typeface="Calibri"/>
                <a:cs typeface="Calibri"/>
              </a:rPr>
              <a:t>G</a:t>
            </a:r>
            <a:r>
              <a:rPr sz="1600" b="1" i="1" spc="-5" dirty="0">
                <a:latin typeface="Calibri"/>
                <a:cs typeface="Calibri"/>
              </a:rPr>
              <a:t>D</a:t>
            </a:r>
            <a:r>
              <a:rPr sz="1600" b="1" i="1" dirty="0">
                <a:latin typeface="Calibri"/>
                <a:cs typeface="Calibri"/>
              </a:rPr>
              <a:t>N</a:t>
            </a:r>
            <a:r>
              <a:rPr sz="1600" b="1" i="1" spc="-5" dirty="0">
                <a:latin typeface="Calibri"/>
                <a:cs typeface="Calibri"/>
              </a:rPr>
              <a:t>F</a:t>
            </a:r>
            <a:endParaRPr sz="1600">
              <a:latin typeface="Calibri"/>
              <a:cs typeface="Calibri"/>
            </a:endParaRPr>
          </a:p>
          <a:p>
            <a:pPr marL="368300">
              <a:lnSpc>
                <a:spcPct val="100000"/>
              </a:lnSpc>
              <a:spcBef>
                <a:spcPts val="60"/>
              </a:spcBef>
            </a:pPr>
            <a:r>
              <a:rPr sz="1600" b="1" i="1" spc="-5" dirty="0">
                <a:latin typeface="Calibri"/>
                <a:cs typeface="Calibri"/>
              </a:rPr>
              <a:t>RET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2465577" y="1097912"/>
            <a:ext cx="582930" cy="1094105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 marR="5080" indent="84455" algn="just">
              <a:lnSpc>
                <a:spcPct val="109300"/>
              </a:lnSpc>
              <a:spcBef>
                <a:spcPts val="120"/>
              </a:spcBef>
            </a:pPr>
            <a:r>
              <a:rPr sz="1600" b="1" i="1" spc="-5" dirty="0">
                <a:latin typeface="Calibri"/>
                <a:cs typeface="Calibri"/>
              </a:rPr>
              <a:t>EGFR  FGFR1  IGF1R  IGF2R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5069585" y="6107074"/>
            <a:ext cx="2562860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10" dirty="0">
                <a:latin typeface="Calibri"/>
                <a:cs typeface="Calibri"/>
              </a:rPr>
              <a:t>LOG2 </a:t>
            </a:r>
            <a:r>
              <a:rPr sz="1400" b="1" spc="-5" dirty="0">
                <a:latin typeface="Calibri"/>
                <a:cs typeface="Calibri"/>
              </a:rPr>
              <a:t>FOLD EXPRESSION</a:t>
            </a:r>
            <a:r>
              <a:rPr sz="1400" b="1" spc="-40" dirty="0">
                <a:latin typeface="Calibri"/>
                <a:cs typeface="Calibri"/>
              </a:rPr>
              <a:t> </a:t>
            </a:r>
            <a:r>
              <a:rPr sz="1400" b="1" spc="-5" dirty="0">
                <a:latin typeface="Calibri"/>
                <a:cs typeface="Calibri"/>
              </a:rPr>
              <a:t>CHANGES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3218433" y="360425"/>
            <a:ext cx="5745480" cy="517525"/>
          </a:xfrm>
          <a:prstGeom prst="rect">
            <a:avLst/>
          </a:prstGeom>
        </p:spPr>
        <p:txBody>
          <a:bodyPr vert="horz" wrap="square" lIns="0" tIns="7620" rIns="0" bIns="0" rtlCol="0">
            <a:spAutoFit/>
          </a:bodyPr>
          <a:lstStyle/>
          <a:p>
            <a:pPr marL="2102485" marR="5080" indent="-2089785">
              <a:lnSpc>
                <a:spcPct val="101899"/>
              </a:lnSpc>
              <a:spcBef>
                <a:spcPts val="60"/>
              </a:spcBef>
            </a:pPr>
            <a:r>
              <a:rPr sz="1600" b="1" spc="5" dirty="0">
                <a:latin typeface="Calibri"/>
                <a:cs typeface="Calibri"/>
              </a:rPr>
              <a:t>Effects </a:t>
            </a:r>
            <a:r>
              <a:rPr sz="1600" b="1" spc="10" dirty="0">
                <a:latin typeface="Calibri"/>
                <a:cs typeface="Calibri"/>
              </a:rPr>
              <a:t>of </a:t>
            </a:r>
            <a:r>
              <a:rPr sz="1600" b="1" spc="5" dirty="0">
                <a:latin typeface="Calibri"/>
                <a:cs typeface="Calibri"/>
              </a:rPr>
              <a:t>the </a:t>
            </a:r>
            <a:r>
              <a:rPr sz="1600" b="1" spc="15" dirty="0">
                <a:latin typeface="Calibri"/>
                <a:cs typeface="Calibri"/>
              </a:rPr>
              <a:t>fb-PMT </a:t>
            </a:r>
            <a:r>
              <a:rPr sz="1600" b="1" spc="10" dirty="0">
                <a:latin typeface="Calibri"/>
                <a:cs typeface="Calibri"/>
              </a:rPr>
              <a:t>treatment on </a:t>
            </a:r>
            <a:r>
              <a:rPr sz="1600" b="1" spc="5" dirty="0">
                <a:latin typeface="Calibri"/>
                <a:cs typeface="Calibri"/>
              </a:rPr>
              <a:t>gene </a:t>
            </a:r>
            <a:r>
              <a:rPr sz="1600" b="1" spc="10" dirty="0">
                <a:latin typeface="Calibri"/>
                <a:cs typeface="Calibri"/>
              </a:rPr>
              <a:t>expression in </a:t>
            </a:r>
            <a:r>
              <a:rPr sz="1600" b="1" spc="5" dirty="0">
                <a:latin typeface="Calibri"/>
                <a:cs typeface="Calibri"/>
              </a:rPr>
              <a:t>U87 </a:t>
            </a:r>
            <a:r>
              <a:rPr sz="1600" b="1" spc="10" dirty="0">
                <a:latin typeface="Calibri"/>
                <a:cs typeface="Calibri"/>
              </a:rPr>
              <a:t>human  glioblastoma</a:t>
            </a:r>
            <a:r>
              <a:rPr sz="1600" b="1" spc="5" dirty="0">
                <a:latin typeface="Calibri"/>
                <a:cs typeface="Calibri"/>
              </a:rPr>
              <a:t> </a:t>
            </a:r>
            <a:r>
              <a:rPr sz="1600" b="1" spc="15" dirty="0">
                <a:latin typeface="Calibri"/>
                <a:cs typeface="Calibri"/>
              </a:rPr>
              <a:t>cells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4043298" y="3998467"/>
            <a:ext cx="20466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solidFill>
                  <a:srgbClr val="FF0000"/>
                </a:solidFill>
                <a:latin typeface="Calibri"/>
                <a:cs typeface="Calibri"/>
              </a:rPr>
              <a:t>Dependence receptor</a:t>
            </a:r>
            <a:r>
              <a:rPr sz="1400" b="1" spc="-15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400" b="1" dirty="0">
                <a:solidFill>
                  <a:srgbClr val="FF0000"/>
                </a:solidFill>
                <a:latin typeface="Calibri"/>
                <a:cs typeface="Calibri"/>
              </a:rPr>
              <a:t>(RET)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6320409" y="3775328"/>
            <a:ext cx="2955290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solidFill>
                  <a:srgbClr val="006FC0"/>
                </a:solidFill>
                <a:latin typeface="Calibri"/>
                <a:cs typeface="Calibri"/>
              </a:rPr>
              <a:t>Ligand </a:t>
            </a:r>
            <a:r>
              <a:rPr sz="1400" b="1" spc="-5" dirty="0">
                <a:solidFill>
                  <a:srgbClr val="006FC0"/>
                </a:solidFill>
                <a:latin typeface="Calibri"/>
                <a:cs typeface="Calibri"/>
              </a:rPr>
              <a:t>for </a:t>
            </a:r>
            <a:r>
              <a:rPr sz="1400" b="1" dirty="0">
                <a:solidFill>
                  <a:srgbClr val="006FC0"/>
                </a:solidFill>
                <a:latin typeface="Calibri"/>
                <a:cs typeface="Calibri"/>
              </a:rPr>
              <a:t>dependence receptor</a:t>
            </a:r>
            <a:r>
              <a:rPr sz="1400" b="1" spc="-170" dirty="0">
                <a:solidFill>
                  <a:srgbClr val="006FC0"/>
                </a:solidFill>
                <a:latin typeface="Calibri"/>
                <a:cs typeface="Calibri"/>
              </a:rPr>
              <a:t> </a:t>
            </a:r>
            <a:r>
              <a:rPr sz="1400" b="1" spc="-5" dirty="0">
                <a:solidFill>
                  <a:srgbClr val="006FC0"/>
                </a:solidFill>
                <a:latin typeface="Calibri"/>
                <a:cs typeface="Calibri"/>
              </a:rPr>
              <a:t>(GDNF)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6585966" y="3116072"/>
            <a:ext cx="1674495" cy="23939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b="1" dirty="0">
                <a:solidFill>
                  <a:srgbClr val="006FC0"/>
                </a:solidFill>
                <a:latin typeface="Calibri"/>
                <a:cs typeface="Calibri"/>
              </a:rPr>
              <a:t>RET pathway</a:t>
            </a:r>
            <a:r>
              <a:rPr sz="1400" b="1" spc="-120" dirty="0">
                <a:solidFill>
                  <a:srgbClr val="006FC0"/>
                </a:solidFill>
                <a:latin typeface="Calibri"/>
                <a:cs typeface="Calibri"/>
              </a:rPr>
              <a:t> </a:t>
            </a:r>
            <a:r>
              <a:rPr sz="1400" b="1" dirty="0">
                <a:solidFill>
                  <a:srgbClr val="006FC0"/>
                </a:solidFill>
                <a:latin typeface="Calibri"/>
                <a:cs typeface="Calibri"/>
              </a:rPr>
              <a:t>signaling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6335267" y="2718816"/>
            <a:ext cx="163195" cy="1069975"/>
          </a:xfrm>
          <a:custGeom>
            <a:avLst/>
            <a:gdLst/>
            <a:ahLst/>
            <a:cxnLst/>
            <a:rect l="l" t="t" r="r" b="b"/>
            <a:pathLst>
              <a:path w="163195" h="1069975">
                <a:moveTo>
                  <a:pt x="0" y="0"/>
                </a:moveTo>
                <a:lnTo>
                  <a:pt x="0" y="1069848"/>
                </a:lnTo>
                <a:lnTo>
                  <a:pt x="31759" y="1068778"/>
                </a:lnTo>
                <a:lnTo>
                  <a:pt x="57673" y="1065863"/>
                </a:lnTo>
                <a:lnTo>
                  <a:pt x="75134" y="1061543"/>
                </a:lnTo>
                <a:lnTo>
                  <a:pt x="81534" y="1056259"/>
                </a:lnTo>
                <a:lnTo>
                  <a:pt x="81534" y="548513"/>
                </a:lnTo>
                <a:lnTo>
                  <a:pt x="87933" y="543228"/>
                </a:lnTo>
                <a:lnTo>
                  <a:pt x="105394" y="538908"/>
                </a:lnTo>
                <a:lnTo>
                  <a:pt x="131308" y="535993"/>
                </a:lnTo>
                <a:lnTo>
                  <a:pt x="163068" y="534924"/>
                </a:lnTo>
                <a:lnTo>
                  <a:pt x="131308" y="533854"/>
                </a:lnTo>
                <a:lnTo>
                  <a:pt x="105394" y="530939"/>
                </a:lnTo>
                <a:lnTo>
                  <a:pt x="87933" y="526619"/>
                </a:lnTo>
                <a:lnTo>
                  <a:pt x="81534" y="521335"/>
                </a:lnTo>
                <a:lnTo>
                  <a:pt x="81534" y="13588"/>
                </a:lnTo>
                <a:lnTo>
                  <a:pt x="75134" y="8304"/>
                </a:lnTo>
                <a:lnTo>
                  <a:pt x="57673" y="3984"/>
                </a:lnTo>
                <a:lnTo>
                  <a:pt x="31759" y="1069"/>
                </a:lnTo>
                <a:lnTo>
                  <a:pt x="0" y="0"/>
                </a:lnTo>
                <a:close/>
              </a:path>
            </a:pathLst>
          </a:custGeom>
          <a:solidFill>
            <a:srgbClr val="D5DCE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6335267" y="2718816"/>
            <a:ext cx="163195" cy="1069975"/>
          </a:xfrm>
          <a:custGeom>
            <a:avLst/>
            <a:gdLst/>
            <a:ahLst/>
            <a:cxnLst/>
            <a:rect l="l" t="t" r="r" b="b"/>
            <a:pathLst>
              <a:path w="163195" h="1069975">
                <a:moveTo>
                  <a:pt x="0" y="0"/>
                </a:moveTo>
                <a:lnTo>
                  <a:pt x="31759" y="1069"/>
                </a:lnTo>
                <a:lnTo>
                  <a:pt x="57673" y="3984"/>
                </a:lnTo>
                <a:lnTo>
                  <a:pt x="75134" y="8304"/>
                </a:lnTo>
                <a:lnTo>
                  <a:pt x="81534" y="13588"/>
                </a:lnTo>
                <a:lnTo>
                  <a:pt x="81534" y="521335"/>
                </a:lnTo>
                <a:lnTo>
                  <a:pt x="87933" y="526619"/>
                </a:lnTo>
                <a:lnTo>
                  <a:pt x="105394" y="530939"/>
                </a:lnTo>
                <a:lnTo>
                  <a:pt x="131308" y="533854"/>
                </a:lnTo>
                <a:lnTo>
                  <a:pt x="163068" y="534924"/>
                </a:lnTo>
                <a:lnTo>
                  <a:pt x="131308" y="535993"/>
                </a:lnTo>
                <a:lnTo>
                  <a:pt x="105394" y="538908"/>
                </a:lnTo>
                <a:lnTo>
                  <a:pt x="87933" y="543228"/>
                </a:lnTo>
                <a:lnTo>
                  <a:pt x="81534" y="548513"/>
                </a:lnTo>
                <a:lnTo>
                  <a:pt x="81534" y="1056259"/>
                </a:lnTo>
                <a:lnTo>
                  <a:pt x="75134" y="1061543"/>
                </a:lnTo>
                <a:lnTo>
                  <a:pt x="57673" y="1065863"/>
                </a:lnTo>
                <a:lnTo>
                  <a:pt x="31759" y="1068778"/>
                </a:lnTo>
                <a:lnTo>
                  <a:pt x="0" y="1069848"/>
                </a:lnTo>
              </a:path>
            </a:pathLst>
          </a:custGeom>
          <a:ln w="6096">
            <a:solidFill>
              <a:srgbClr val="5B9BD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/>
          <p:nvPr/>
        </p:nvSpPr>
        <p:spPr>
          <a:xfrm>
            <a:off x="6602730" y="1710944"/>
            <a:ext cx="1810385" cy="23939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b="1" dirty="0">
                <a:solidFill>
                  <a:srgbClr val="006FC0"/>
                </a:solidFill>
                <a:latin typeface="Calibri"/>
                <a:cs typeface="Calibri"/>
              </a:rPr>
              <a:t>Growth factor</a:t>
            </a:r>
            <a:r>
              <a:rPr sz="1400" b="1" spc="-135" dirty="0">
                <a:solidFill>
                  <a:srgbClr val="006FC0"/>
                </a:solidFill>
                <a:latin typeface="Calibri"/>
                <a:cs typeface="Calibri"/>
              </a:rPr>
              <a:t> </a:t>
            </a:r>
            <a:r>
              <a:rPr sz="1400" b="1" dirty="0">
                <a:solidFill>
                  <a:srgbClr val="006FC0"/>
                </a:solidFill>
                <a:latin typeface="Calibri"/>
                <a:cs typeface="Calibri"/>
              </a:rPr>
              <a:t>receptors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21" name="object 21"/>
          <p:cNvSpPr/>
          <p:nvPr/>
        </p:nvSpPr>
        <p:spPr>
          <a:xfrm>
            <a:off x="6335267" y="1304544"/>
            <a:ext cx="163195" cy="1071880"/>
          </a:xfrm>
          <a:custGeom>
            <a:avLst/>
            <a:gdLst/>
            <a:ahLst/>
            <a:cxnLst/>
            <a:rect l="l" t="t" r="r" b="b"/>
            <a:pathLst>
              <a:path w="163195" h="1071880">
                <a:moveTo>
                  <a:pt x="0" y="0"/>
                </a:moveTo>
                <a:lnTo>
                  <a:pt x="0" y="1071371"/>
                </a:lnTo>
                <a:lnTo>
                  <a:pt x="31759" y="1070302"/>
                </a:lnTo>
                <a:lnTo>
                  <a:pt x="57673" y="1067387"/>
                </a:lnTo>
                <a:lnTo>
                  <a:pt x="75134" y="1063067"/>
                </a:lnTo>
                <a:lnTo>
                  <a:pt x="81534" y="1057782"/>
                </a:lnTo>
                <a:lnTo>
                  <a:pt x="81534" y="549275"/>
                </a:lnTo>
                <a:lnTo>
                  <a:pt x="87933" y="543990"/>
                </a:lnTo>
                <a:lnTo>
                  <a:pt x="105394" y="539670"/>
                </a:lnTo>
                <a:lnTo>
                  <a:pt x="131308" y="536755"/>
                </a:lnTo>
                <a:lnTo>
                  <a:pt x="163068" y="535685"/>
                </a:lnTo>
                <a:lnTo>
                  <a:pt x="131308" y="534616"/>
                </a:lnTo>
                <a:lnTo>
                  <a:pt x="105394" y="531701"/>
                </a:lnTo>
                <a:lnTo>
                  <a:pt x="87933" y="527381"/>
                </a:lnTo>
                <a:lnTo>
                  <a:pt x="81534" y="522096"/>
                </a:lnTo>
                <a:lnTo>
                  <a:pt x="81534" y="13588"/>
                </a:lnTo>
                <a:lnTo>
                  <a:pt x="75134" y="8304"/>
                </a:lnTo>
                <a:lnTo>
                  <a:pt x="57673" y="3984"/>
                </a:lnTo>
                <a:lnTo>
                  <a:pt x="31759" y="1069"/>
                </a:lnTo>
                <a:lnTo>
                  <a:pt x="0" y="0"/>
                </a:lnTo>
                <a:close/>
              </a:path>
            </a:pathLst>
          </a:custGeom>
          <a:solidFill>
            <a:srgbClr val="D5DCE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6335267" y="1304544"/>
            <a:ext cx="163195" cy="1071880"/>
          </a:xfrm>
          <a:custGeom>
            <a:avLst/>
            <a:gdLst/>
            <a:ahLst/>
            <a:cxnLst/>
            <a:rect l="l" t="t" r="r" b="b"/>
            <a:pathLst>
              <a:path w="163195" h="1071880">
                <a:moveTo>
                  <a:pt x="0" y="0"/>
                </a:moveTo>
                <a:lnTo>
                  <a:pt x="31759" y="1069"/>
                </a:lnTo>
                <a:lnTo>
                  <a:pt x="57673" y="3984"/>
                </a:lnTo>
                <a:lnTo>
                  <a:pt x="75134" y="8304"/>
                </a:lnTo>
                <a:lnTo>
                  <a:pt x="81534" y="13588"/>
                </a:lnTo>
                <a:lnTo>
                  <a:pt x="81534" y="522096"/>
                </a:lnTo>
                <a:lnTo>
                  <a:pt x="87933" y="527381"/>
                </a:lnTo>
                <a:lnTo>
                  <a:pt x="105394" y="531701"/>
                </a:lnTo>
                <a:lnTo>
                  <a:pt x="131308" y="534616"/>
                </a:lnTo>
                <a:lnTo>
                  <a:pt x="163068" y="535685"/>
                </a:lnTo>
                <a:lnTo>
                  <a:pt x="131308" y="536755"/>
                </a:lnTo>
                <a:lnTo>
                  <a:pt x="105394" y="539670"/>
                </a:lnTo>
                <a:lnTo>
                  <a:pt x="87933" y="543990"/>
                </a:lnTo>
                <a:lnTo>
                  <a:pt x="81534" y="549275"/>
                </a:lnTo>
                <a:lnTo>
                  <a:pt x="81534" y="1057782"/>
                </a:lnTo>
                <a:lnTo>
                  <a:pt x="75134" y="1063067"/>
                </a:lnTo>
                <a:lnTo>
                  <a:pt x="57673" y="1067387"/>
                </a:lnTo>
                <a:lnTo>
                  <a:pt x="31759" y="1070302"/>
                </a:lnTo>
                <a:lnTo>
                  <a:pt x="0" y="1071371"/>
                </a:lnTo>
              </a:path>
            </a:pathLst>
          </a:custGeom>
          <a:ln w="6096">
            <a:solidFill>
              <a:srgbClr val="5B9BD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5942076" y="4533900"/>
            <a:ext cx="163195" cy="753110"/>
          </a:xfrm>
          <a:custGeom>
            <a:avLst/>
            <a:gdLst/>
            <a:ahLst/>
            <a:cxnLst/>
            <a:rect l="l" t="t" r="r" b="b"/>
            <a:pathLst>
              <a:path w="163195" h="753110">
                <a:moveTo>
                  <a:pt x="163068" y="0"/>
                </a:moveTo>
                <a:lnTo>
                  <a:pt x="131308" y="1069"/>
                </a:lnTo>
                <a:lnTo>
                  <a:pt x="105394" y="3984"/>
                </a:lnTo>
                <a:lnTo>
                  <a:pt x="87933" y="8304"/>
                </a:lnTo>
                <a:lnTo>
                  <a:pt x="81534" y="13588"/>
                </a:lnTo>
                <a:lnTo>
                  <a:pt x="81534" y="362838"/>
                </a:lnTo>
                <a:lnTo>
                  <a:pt x="75134" y="368123"/>
                </a:lnTo>
                <a:lnTo>
                  <a:pt x="57673" y="372443"/>
                </a:lnTo>
                <a:lnTo>
                  <a:pt x="31759" y="375358"/>
                </a:lnTo>
                <a:lnTo>
                  <a:pt x="0" y="376427"/>
                </a:lnTo>
                <a:lnTo>
                  <a:pt x="31759" y="377497"/>
                </a:lnTo>
                <a:lnTo>
                  <a:pt x="57673" y="380412"/>
                </a:lnTo>
                <a:lnTo>
                  <a:pt x="75134" y="384732"/>
                </a:lnTo>
                <a:lnTo>
                  <a:pt x="81534" y="390017"/>
                </a:lnTo>
                <a:lnTo>
                  <a:pt x="81534" y="739266"/>
                </a:lnTo>
                <a:lnTo>
                  <a:pt x="87933" y="744551"/>
                </a:lnTo>
                <a:lnTo>
                  <a:pt x="105394" y="748871"/>
                </a:lnTo>
                <a:lnTo>
                  <a:pt x="131308" y="751786"/>
                </a:lnTo>
                <a:lnTo>
                  <a:pt x="163068" y="752856"/>
                </a:lnTo>
                <a:lnTo>
                  <a:pt x="163068" y="0"/>
                </a:lnTo>
                <a:close/>
              </a:path>
            </a:pathLst>
          </a:custGeom>
          <a:solidFill>
            <a:srgbClr val="FFFF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5942076" y="4533900"/>
            <a:ext cx="163195" cy="753110"/>
          </a:xfrm>
          <a:custGeom>
            <a:avLst/>
            <a:gdLst/>
            <a:ahLst/>
            <a:cxnLst/>
            <a:rect l="l" t="t" r="r" b="b"/>
            <a:pathLst>
              <a:path w="163195" h="753110">
                <a:moveTo>
                  <a:pt x="163068" y="752856"/>
                </a:moveTo>
                <a:lnTo>
                  <a:pt x="131308" y="751786"/>
                </a:lnTo>
                <a:lnTo>
                  <a:pt x="105394" y="748871"/>
                </a:lnTo>
                <a:lnTo>
                  <a:pt x="87933" y="744551"/>
                </a:lnTo>
                <a:lnTo>
                  <a:pt x="81534" y="739266"/>
                </a:lnTo>
                <a:lnTo>
                  <a:pt x="81534" y="390017"/>
                </a:lnTo>
                <a:lnTo>
                  <a:pt x="75134" y="384732"/>
                </a:lnTo>
                <a:lnTo>
                  <a:pt x="57673" y="380412"/>
                </a:lnTo>
                <a:lnTo>
                  <a:pt x="31759" y="377497"/>
                </a:lnTo>
                <a:lnTo>
                  <a:pt x="0" y="376427"/>
                </a:lnTo>
                <a:lnTo>
                  <a:pt x="31759" y="375358"/>
                </a:lnTo>
                <a:lnTo>
                  <a:pt x="57673" y="372443"/>
                </a:lnTo>
                <a:lnTo>
                  <a:pt x="75134" y="368123"/>
                </a:lnTo>
                <a:lnTo>
                  <a:pt x="81534" y="362838"/>
                </a:lnTo>
                <a:lnTo>
                  <a:pt x="81534" y="13588"/>
                </a:lnTo>
                <a:lnTo>
                  <a:pt x="87933" y="8304"/>
                </a:lnTo>
                <a:lnTo>
                  <a:pt x="105394" y="3984"/>
                </a:lnTo>
                <a:lnTo>
                  <a:pt x="131308" y="1069"/>
                </a:lnTo>
                <a:lnTo>
                  <a:pt x="163068" y="0"/>
                </a:lnTo>
              </a:path>
            </a:pathLst>
          </a:custGeom>
          <a:ln w="6095">
            <a:solidFill>
              <a:srgbClr val="5B9BD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 txBox="1"/>
          <p:nvPr/>
        </p:nvSpPr>
        <p:spPr>
          <a:xfrm>
            <a:off x="4411217" y="4760214"/>
            <a:ext cx="143446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solidFill>
                  <a:srgbClr val="FF0000"/>
                </a:solidFill>
                <a:latin typeface="Calibri"/>
                <a:cs typeface="Calibri"/>
              </a:rPr>
              <a:t>Apoptosis</a:t>
            </a:r>
            <a:r>
              <a:rPr sz="1400" b="1" spc="-8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400" b="1" dirty="0">
                <a:solidFill>
                  <a:srgbClr val="FF0000"/>
                </a:solidFill>
                <a:latin typeface="Calibri"/>
                <a:cs typeface="Calibri"/>
              </a:rPr>
              <a:t>inducers</a:t>
            </a:r>
            <a:endParaRPr sz="14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076849"/>
              </p:ext>
            </p:extLst>
          </p:nvPr>
        </p:nvGraphicFramePr>
        <p:xfrm>
          <a:off x="1763730" y="286820"/>
          <a:ext cx="8664539" cy="6284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459218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0800" y="381000"/>
            <a:ext cx="6857999" cy="6201754"/>
          </a:xfrm>
          <a:prstGeom prst="rect">
            <a:avLst/>
          </a:prstGeom>
        </p:spPr>
      </p:pic>
      <p:sp>
        <p:nvSpPr>
          <p:cNvPr id="3" name="object 4"/>
          <p:cNvSpPr txBox="1"/>
          <p:nvPr/>
        </p:nvSpPr>
        <p:spPr>
          <a:xfrm>
            <a:off x="1828800" y="399288"/>
            <a:ext cx="1797050" cy="566822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b="1" spc="-10" dirty="0" smtClean="0">
                <a:latin typeface="Calibri"/>
                <a:cs typeface="Calibri"/>
              </a:rPr>
              <a:t>Elsevier Pathway Collection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4" name="5-Point Star 3"/>
          <p:cNvSpPr/>
          <p:nvPr/>
        </p:nvSpPr>
        <p:spPr>
          <a:xfrm>
            <a:off x="4800600" y="1905000"/>
            <a:ext cx="152400" cy="152400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4698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5164"/>
            <a:ext cx="12192000" cy="6687671"/>
          </a:xfrm>
          <a:prstGeom prst="rect">
            <a:avLst/>
          </a:prstGeom>
        </p:spPr>
      </p:pic>
      <p:sp>
        <p:nvSpPr>
          <p:cNvPr id="3" name="5-Point Star 2"/>
          <p:cNvSpPr/>
          <p:nvPr/>
        </p:nvSpPr>
        <p:spPr>
          <a:xfrm>
            <a:off x="9906000" y="3505200"/>
            <a:ext cx="304800" cy="228600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852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201650" y="310896"/>
            <a:ext cx="2732577" cy="628802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181600" y="341820"/>
            <a:ext cx="6060207" cy="615401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297426" y="328421"/>
            <a:ext cx="2613660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5" dirty="0">
                <a:latin typeface="Calibri"/>
                <a:cs typeface="Calibri"/>
              </a:rPr>
              <a:t>WikiPathways </a:t>
            </a:r>
            <a:r>
              <a:rPr sz="1800" b="1" dirty="0">
                <a:latin typeface="Calibri"/>
                <a:cs typeface="Calibri"/>
              </a:rPr>
              <a:t>2019</a:t>
            </a:r>
            <a:r>
              <a:rPr sz="1800" b="1" spc="-55" dirty="0">
                <a:latin typeface="Calibri"/>
                <a:cs typeface="Calibri"/>
              </a:rPr>
              <a:t> </a:t>
            </a:r>
            <a:r>
              <a:rPr sz="1800" b="1" spc="-5" dirty="0">
                <a:latin typeface="Calibri"/>
                <a:cs typeface="Calibri"/>
              </a:rPr>
              <a:t>Human</a:t>
            </a:r>
            <a:endParaRPr sz="1800" dirty="0">
              <a:latin typeface="Calibri"/>
              <a:cs typeface="Calibri"/>
            </a:endParaRPr>
          </a:p>
        </p:txBody>
      </p:sp>
      <p:sp>
        <p:nvSpPr>
          <p:cNvPr id="5" name="5-Point Star 4"/>
          <p:cNvSpPr/>
          <p:nvPr/>
        </p:nvSpPr>
        <p:spPr>
          <a:xfrm>
            <a:off x="7391400" y="1828800"/>
            <a:ext cx="152400" cy="152400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5-Point Star 5"/>
          <p:cNvSpPr/>
          <p:nvPr/>
        </p:nvSpPr>
        <p:spPr>
          <a:xfrm>
            <a:off x="3200400" y="3886200"/>
            <a:ext cx="152400" cy="152400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4659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929127" y="425965"/>
            <a:ext cx="6289548" cy="273404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>
            <a:spLocks noGrp="1"/>
          </p:cNvSpPr>
          <p:nvPr>
            <p:ph type="title"/>
          </p:nvPr>
        </p:nvSpPr>
        <p:spPr>
          <a:xfrm>
            <a:off x="2714370" y="24765"/>
            <a:ext cx="6918959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5" dirty="0">
                <a:latin typeface="Calibri"/>
                <a:cs typeface="Calibri"/>
              </a:rPr>
              <a:t>WikiPathways </a:t>
            </a:r>
            <a:r>
              <a:rPr sz="1800" b="1" dirty="0">
                <a:latin typeface="Calibri"/>
                <a:cs typeface="Calibri"/>
              </a:rPr>
              <a:t>2019 </a:t>
            </a:r>
            <a:r>
              <a:rPr sz="1800" b="1" spc="-5" dirty="0">
                <a:latin typeface="Calibri"/>
                <a:cs typeface="Calibri"/>
              </a:rPr>
              <a:t>Human </a:t>
            </a:r>
            <a:r>
              <a:rPr sz="1800" b="1" spc="-10" dirty="0">
                <a:latin typeface="Calibri"/>
                <a:cs typeface="Calibri"/>
              </a:rPr>
              <a:t>(examples </a:t>
            </a:r>
            <a:r>
              <a:rPr sz="1800" b="1" dirty="0">
                <a:latin typeface="Calibri"/>
                <a:cs typeface="Calibri"/>
              </a:rPr>
              <a:t>of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 pathways)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356486" y="3141599"/>
            <a:ext cx="9609455" cy="3028950"/>
          </a:xfrm>
          <a:prstGeom prst="rect">
            <a:avLst/>
          </a:prstGeom>
        </p:spPr>
        <p:txBody>
          <a:bodyPr vert="horz" wrap="square" lIns="0" tIns="133985" rIns="0" bIns="0" rtlCol="0">
            <a:spAutoFit/>
          </a:bodyPr>
          <a:lstStyle/>
          <a:p>
            <a:pPr marR="266065" algn="ctr">
              <a:lnSpc>
                <a:spcPct val="100000"/>
              </a:lnSpc>
              <a:spcBef>
                <a:spcPts val="1055"/>
              </a:spcBef>
            </a:pP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800" b="1" spc="-20" dirty="0">
                <a:solidFill>
                  <a:srgbClr val="FF0000"/>
                </a:solidFill>
                <a:latin typeface="Calibri"/>
                <a:cs typeface="Calibri"/>
              </a:rPr>
              <a:t>Pathways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in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Glioblastoma</a:t>
            </a:r>
            <a:r>
              <a:rPr sz="1800" b="1" spc="-6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WP2261</a:t>
            </a:r>
            <a:endParaRPr sz="1800">
              <a:latin typeface="Calibri"/>
              <a:cs typeface="Calibri"/>
            </a:endParaRPr>
          </a:p>
          <a:p>
            <a:pPr marR="168275" algn="ctr">
              <a:lnSpc>
                <a:spcPct val="100000"/>
              </a:lnSpc>
              <a:spcBef>
                <a:spcPts val="960"/>
              </a:spcBef>
            </a:pPr>
            <a:r>
              <a:rPr sz="1800" b="1" i="1" spc="-10" dirty="0">
                <a:latin typeface="Calibri"/>
                <a:cs typeface="Calibri"/>
              </a:rPr>
              <a:t>ERRFI1;CCND1;IRS1;PDPK1;EP300;MAPK1;PRKCA;CBL;MET;EGFR;IGF1R</a:t>
            </a:r>
            <a:endParaRPr sz="1800">
              <a:latin typeface="Calibri"/>
              <a:cs typeface="Calibri"/>
            </a:endParaRPr>
          </a:p>
          <a:p>
            <a:pPr marR="265430" algn="ctr">
              <a:lnSpc>
                <a:spcPct val="100000"/>
              </a:lnSpc>
              <a:spcBef>
                <a:spcPts val="750"/>
              </a:spcBef>
            </a:pP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Androgen receptor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r>
              <a:rPr sz="1800" b="1" spc="-12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WP138</a:t>
            </a:r>
            <a:endParaRPr sz="1800">
              <a:latin typeface="Calibri"/>
              <a:cs typeface="Calibri"/>
            </a:endParaRPr>
          </a:p>
          <a:p>
            <a:pPr marR="171450" algn="ctr">
              <a:lnSpc>
                <a:spcPct val="100000"/>
              </a:lnSpc>
              <a:spcBef>
                <a:spcPts val="740"/>
              </a:spcBef>
            </a:pPr>
            <a:r>
              <a:rPr sz="1800" b="1" i="1" spc="-5" dirty="0">
                <a:latin typeface="Calibri"/>
                <a:cs typeface="Calibri"/>
              </a:rPr>
              <a:t>CREBBP;SMAD3;CCND1;ZMIZ1;SIN3A;SP1;NCOA3;ZNF318;EP300;NR2C2;RUNX2;EGFR</a:t>
            </a:r>
            <a:endParaRPr sz="1800">
              <a:latin typeface="Calibri"/>
              <a:cs typeface="Calibri"/>
            </a:endParaRPr>
          </a:p>
          <a:p>
            <a:pPr marR="264160" algn="ctr">
              <a:lnSpc>
                <a:spcPct val="100000"/>
              </a:lnSpc>
              <a:spcBef>
                <a:spcPts val="740"/>
              </a:spcBef>
            </a:pP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Alpha 6 </a:t>
            </a:r>
            <a:r>
              <a:rPr sz="1800" b="1" spc="-10" dirty="0">
                <a:solidFill>
                  <a:srgbClr val="FF0000"/>
                </a:solidFill>
                <a:latin typeface="Calibri"/>
                <a:cs typeface="Calibri"/>
              </a:rPr>
              <a:t>Beta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4 signaling </a:t>
            </a: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r>
              <a:rPr sz="1800" b="1" spc="-9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WP244</a:t>
            </a:r>
            <a:endParaRPr sz="1800">
              <a:latin typeface="Calibri"/>
              <a:cs typeface="Calibri"/>
            </a:endParaRPr>
          </a:p>
          <a:p>
            <a:pPr marR="158115" algn="ctr">
              <a:lnSpc>
                <a:spcPct val="100000"/>
              </a:lnSpc>
              <a:spcBef>
                <a:spcPts val="740"/>
              </a:spcBef>
            </a:pPr>
            <a:r>
              <a:rPr sz="1800" b="1" i="1" spc="-10" dirty="0">
                <a:latin typeface="Calibri"/>
                <a:cs typeface="Calibri"/>
              </a:rPr>
              <a:t>IRS1;LAMA1;LAMA3;MAPK1;PRKCA;LAMC1;MTOR</a:t>
            </a:r>
            <a:endParaRPr sz="1800">
              <a:latin typeface="Calibri"/>
              <a:cs typeface="Calibri"/>
            </a:endParaRPr>
          </a:p>
          <a:p>
            <a:pPr marR="260350" algn="ctr">
              <a:lnSpc>
                <a:spcPct val="100000"/>
              </a:lnSpc>
              <a:spcBef>
                <a:spcPts val="740"/>
              </a:spcBef>
            </a:pPr>
            <a:r>
              <a:rPr sz="1800" b="1" spc="-15" dirty="0">
                <a:solidFill>
                  <a:srgbClr val="FF0000"/>
                </a:solidFill>
                <a:latin typeface="Calibri"/>
                <a:cs typeface="Calibri"/>
              </a:rPr>
              <a:t>EGF/EGFR </a:t>
            </a:r>
            <a:r>
              <a:rPr sz="1800" b="1" dirty="0">
                <a:solidFill>
                  <a:srgbClr val="FF0000"/>
                </a:solidFill>
                <a:latin typeface="Calibri"/>
                <a:cs typeface="Calibri"/>
              </a:rPr>
              <a:t>Signaling </a:t>
            </a:r>
            <a:r>
              <a:rPr sz="1800" b="1" spc="-20" dirty="0">
                <a:solidFill>
                  <a:srgbClr val="FF0000"/>
                </a:solidFill>
                <a:latin typeface="Calibri"/>
                <a:cs typeface="Calibri"/>
              </a:rPr>
              <a:t>Pathway</a:t>
            </a:r>
            <a:r>
              <a:rPr sz="1800" b="1" spc="-40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800" b="1" spc="-5" dirty="0">
                <a:solidFill>
                  <a:srgbClr val="FF0000"/>
                </a:solidFill>
                <a:latin typeface="Calibri"/>
                <a:cs typeface="Calibri"/>
              </a:rPr>
              <a:t>WP437</a:t>
            </a:r>
            <a:endParaRPr sz="18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740"/>
              </a:spcBef>
            </a:pPr>
            <a:r>
              <a:rPr sz="1800" b="1" i="1" spc="-10" dirty="0">
                <a:latin typeface="Calibri"/>
                <a:cs typeface="Calibri"/>
              </a:rPr>
              <a:t>ERRFI1;IQSEC1;PDPK1;NCOA3;PRKCA;CBL;EGFR;MTOR;CRKL;ATXN2;SP1;GRB10;MAPK1;MAP3K4;JAK1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733800" y="3276600"/>
            <a:ext cx="4648200" cy="304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5-Point Star 5"/>
          <p:cNvSpPr/>
          <p:nvPr/>
        </p:nvSpPr>
        <p:spPr>
          <a:xfrm>
            <a:off x="5486400" y="2362200"/>
            <a:ext cx="152400" cy="152400"/>
          </a:xfrm>
          <a:prstGeom prst="star5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3366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2"/>
          <p:cNvGraphicFramePr>
            <a:graphicFrameLocks noGrp="1"/>
          </p:cNvGraphicFramePr>
          <p:nvPr/>
        </p:nvGraphicFramePr>
        <p:xfrm>
          <a:off x="200685" y="476884"/>
          <a:ext cx="11715113" cy="63011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80129"/>
                <a:gridCol w="733425"/>
                <a:gridCol w="7401559"/>
              </a:tblGrid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erm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70815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-value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Genes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68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GF-beta 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6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1.08E-0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4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UP214;CREBBP;SMAD3;TNC;FN1;ETS1;THBS1;RUNX2;TGFBR2;SKI;DAB2;CCND1;SP1;SIN3A;PRKAR2A;EP300;MAPK1;BTRC;MET;RNF111;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6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SPTB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562">
                <a:tc>
                  <a:txBody>
                    <a:bodyPr/>
                    <a:lstStyle/>
                    <a:p>
                      <a:pPr algn="ctr">
                        <a:lnSpc>
                          <a:spcPts val="114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ypothesized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s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in Pathogenesis of Cardiovascular</a:t>
                      </a:r>
                      <a:r>
                        <a:rPr sz="1000" b="1" spc="4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Disease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WP366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6.47E-0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BN2;SMAD3;MAPK1;NR2C2;LTBP1;RUNX2;TGFBR2;FB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68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ocal Adhesion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WP3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1.36E-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4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DPK1;LAMA1;LAMA3;FN1;TNC;PRKCA;LAMC1;THBS2;THBS1;EGFR;ARHGAP35;CRKL;MYLK;IGF1R;CCND1;COL5A2;MAPK1;TLN2;PPP1R12B;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marL="1270" algn="ctr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MET;VC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5100"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40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Pathways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ffected in Adenoid Cystic Carcinoma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65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60"/>
                        </a:lnSpc>
                        <a:spcBef>
                          <a:spcPts val="40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5.54E-06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40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MAGI1;CREBBP;SRCAP;KANSL1;PRKDC;KAT6A;NSD1;EP300;BCOR;SMC1A;ARID1A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4973"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3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ndrogen receptor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13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44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60"/>
                        </a:lnSpc>
                        <a:spcBef>
                          <a:spcPts val="3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2.62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44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3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REBBP;SMAD3;CCND1;ZMIZ1;SIN3A;SP1;NCOA3;ZNF318;EP300;NR2C2;RUNX2;EGF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44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s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in Glioblastoma</a:t>
                      </a:r>
                      <a:r>
                        <a:rPr sz="1000" b="1" spc="7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26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5.33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ERRFI1;CCND1;IRS1;PDPK1;EP300;MAPK1;PRKCA;CBL;MET;EGFR;IGF1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miRNA targets in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ECM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 membrane receptors</a:t>
                      </a:r>
                      <a:r>
                        <a:rPr sz="1000" b="1" spc="-5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91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4.75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OL5A2;FN1;COL6A3;LAMC1;THBS2;THBS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lpha 6 Beta 4 signaling pathway</a:t>
                      </a:r>
                      <a:r>
                        <a:rPr sz="1000" b="1" spc="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4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6.42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RS1;LAMA1;LAMA3;MAPK1;PRKCA;LAMC1;MTO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GF-beta Receptor Signaling</a:t>
                      </a:r>
                      <a:r>
                        <a:rPr sz="10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560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4.48E-0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KI;CREBBP;SMAD3;EP300;THBS1;LTBP1;RUNX2;JAK1;TGFBR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Rett syndrome causing genes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31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1.19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MECP2;KDM5B;CDKL5;TRRAP;SCN8A;HTT;TBL1X;SMC1A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01549"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32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EGF/EGFR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7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3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12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60"/>
                        </a:lnSpc>
                        <a:spcBef>
                          <a:spcPts val="32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2.02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12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60"/>
                        </a:lnSpc>
                        <a:spcBef>
                          <a:spcPts val="32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ERRFI1;IQSEC1;PDPK1;NCOA3;PRKCA;CBL;EGFR;MTOR;CRKL;ATXN2;SP1;GRB10;MAPK1;MAP3K4;JA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127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562">
                <a:tc>
                  <a:txBody>
                    <a:bodyPr/>
                    <a:lstStyle/>
                    <a:p>
                      <a:pPr algn="ctr">
                        <a:lnSpc>
                          <a:spcPts val="115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TGF-B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in Thyroid Cells for</a:t>
                      </a:r>
                      <a:r>
                        <a:rPr sz="1000" b="1" spc="9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Epithelial-Mesenchymal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ransition</a:t>
                      </a:r>
                      <a:r>
                        <a:rPr sz="10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85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1.90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MAD3;FN1;TNC;MAPK1;RUNX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2931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uclear Receptors Meta-Pathway</a:t>
                      </a:r>
                      <a:r>
                        <a:rPr sz="1000" b="1" spc="-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88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127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11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2.26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127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ct val="100000"/>
                        </a:lnSpc>
                        <a:spcBef>
                          <a:spcPts val="130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COA6;GPX3;NCOA3;ABHD2;MYOF;TNFAIP3;ARNT;SMC1A;SLC39A14;EGFR;TGFBR2;SLC6A6;AKAP13;CCND1;SERTAD2;SLC39A9;SP1;ENC1;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AHRR;EP300;STOM;PPARA;FKBP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1651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68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ocal Adhesion-PI3K-Akt-mTOR-signaling pathway</a:t>
                      </a:r>
                      <a:r>
                        <a:rPr sz="1000" b="1" spc="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93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2.79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5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HLPP2;PHLPP1;EPAS1;IRS1;PDPK1;LAMA1;LAMA3;FN1;TNC;LAMC1;OSMR;THBS2;THBS1;EGFR;ACACA;MTOR;IGF1R;CREB3L2;COL5A2;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MAPK1;MET;JA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562">
                <a:tc>
                  <a:txBody>
                    <a:bodyPr/>
                    <a:lstStyle/>
                    <a:p>
                      <a:pPr algn="ctr">
                        <a:lnSpc>
                          <a:spcPts val="115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TCA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Cycle Nutrient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Utilization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 Invasiveness of Ovarian</a:t>
                      </a:r>
                      <a:r>
                        <a:rPr sz="1000" b="1" spc="10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Cancer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WP286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3.01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9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60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MAPK1;EGFR;JA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umor suppressor activity of SMARCB1</a:t>
                      </a:r>
                      <a:r>
                        <a:rPr sz="1000" b="1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2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3.68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MARCC1;PTCH1;ARID1A;ARID1B;GLI3;GLI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edgehog 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24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4.26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EVC;CCND1;PTCH1;GLI3;GLI2;CDON;CSNK1G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ts val="1155"/>
                        </a:lnSpc>
                        <a:spcBef>
                          <a:spcPts val="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PI3K-Akt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7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17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ts val="1155"/>
                        </a:lnSpc>
                        <a:spcBef>
                          <a:spcPts val="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5.56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3005455" marR="123189" indent="-2874645">
                        <a:lnSpc>
                          <a:spcPts val="1200"/>
                        </a:lnSpc>
                        <a:spcBef>
                          <a:spcPts val="3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PHLPP2;PHLPP1;IRS1;PDPK1;LAMA1;LAMA3;FN1;TNC;PRKCA;LAMC1;OSMR;THBS2;THBS1;EGFR;MTOR;IGF1R;BCL2L11;CCND1;CREB3L2;  COL6A3;MAPK1;MET;JA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444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6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6.46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2;SPEN;ADAM17;CCND1;MAML1;NUMB;EP300;PSE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MECP2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and Associated Rett Syndrome</a:t>
                      </a:r>
                      <a:r>
                        <a:rPr sz="1000" b="1" spc="1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58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4033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7.22E-0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MECP2;BCL6;SIN3A;SP1;TET3;MTOR;CDON;FKBP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Hedgehog 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33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N3A;PTCH1;GLI3;GLI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219837">
                <a:tc>
                  <a:txBody>
                    <a:bodyPr/>
                    <a:lstStyle/>
                    <a:p>
                      <a:pPr algn="ctr">
                        <a:lnSpc>
                          <a:spcPts val="1155"/>
                        </a:lnSpc>
                        <a:spcBef>
                          <a:spcPts val="47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VEGFA-VEGFR2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8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88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03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55"/>
                        </a:lnSpc>
                        <a:spcBef>
                          <a:spcPts val="47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144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03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55"/>
                        </a:lnSpc>
                        <a:spcBef>
                          <a:spcPts val="47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BXW11;PDPK1;PRKCE;NFATC2;PRKCA;PTPRJ;CBL;ETS1;SLC8A1;ACACA;MTOR;AMOT;ERN1;CCND1;GRB10;MAPK1;VC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6032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8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Transcription co-factors SKI and SKIL protein partners</a:t>
                      </a:r>
                      <a:r>
                        <a:rPr sz="1000" b="1" spc="-3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53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135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70"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KI;MECP2;LATS2;SIN3A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162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ErbB 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3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673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34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BCL2L11;CCND1;ABL2;MAPK1;PRKCA;CBL;EGFR;MTOR;CRKL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38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Extracellular vesicle-mediated signaling in recipient cells</a:t>
                      </a:r>
                      <a:r>
                        <a:rPr sz="10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870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31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MAD3;MET;EGFR;MTOR;TGFBR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305625">
                <a:tc>
                  <a:txBody>
                    <a:bodyPr/>
                    <a:lstStyle/>
                    <a:p>
                      <a:pPr algn="ctr">
                        <a:lnSpc>
                          <a:spcPts val="115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Factors and pathways affecting insulin-like growth factor</a:t>
                      </a:r>
                      <a:r>
                        <a:rPr sz="1000" b="1" spc="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(IGF1)-Akt</a:t>
                      </a:r>
                      <a:endParaRPr sz="1000">
                        <a:latin typeface="Calibri"/>
                        <a:cs typeface="Calibri"/>
                      </a:endParaRPr>
                    </a:p>
                    <a:p>
                      <a:pPr algn="ctr">
                        <a:lnSpc>
                          <a:spcPts val="115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ignaling</a:t>
                      </a:r>
                      <a:r>
                        <a:rPr sz="1000" b="1" spc="2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3850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125095">
                        <a:lnSpc>
                          <a:spcPts val="115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68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  <a:p>
                      <a:pPr marL="635" algn="ctr">
                        <a:lnSpc>
                          <a:spcPts val="115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MAD3;IRS1;FBXO32;MTOR;IGF1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25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 Signaling</a:t>
                      </a:r>
                      <a:r>
                        <a:rPr sz="1000" b="1" spc="2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68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2797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NOTCH2;CREBBP;ADAM17;MAML1;NUMB;PSEN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65061">
                <a:tc>
                  <a:txBody>
                    <a:bodyPr/>
                    <a:lstStyle/>
                    <a:p>
                      <a:pPr algn="ctr">
                        <a:lnSpc>
                          <a:spcPts val="1155"/>
                        </a:lnSpc>
                        <a:spcBef>
                          <a:spcPts val="4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ntegrated Breast Cancer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-4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198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55"/>
                        </a:lnSpc>
                        <a:spcBef>
                          <a:spcPts val="45"/>
                        </a:spcBef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139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55"/>
                        </a:lnSpc>
                        <a:spcBef>
                          <a:spcPts val="45"/>
                        </a:spcBef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CCND1;IRS1;ZMIZ1;SP1;NCOA3;EP300;MAPK1;EGFR;MTOR;JAK1;TGFBR2;HIPK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5715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25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Pathways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Regulating Hippo Signaling</a:t>
                      </a:r>
                      <a:r>
                        <a:rPr sz="1000" b="1" spc="70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4540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388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SMAD3;LATS2;PRKCE;PRKAR2A;PRKCA;MET;EGFR;MTOR;IGF1R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  <a:tr h="153234"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Oncostatin M Signaling </a:t>
                      </a:r>
                      <a:r>
                        <a:rPr sz="1000" b="1" spc="-10" dirty="0">
                          <a:latin typeface="Calibri"/>
                          <a:cs typeface="Calibri"/>
                        </a:rPr>
                        <a:t>Pathway</a:t>
                      </a:r>
                      <a:r>
                        <a:rPr sz="1000" b="1" spc="55" dirty="0">
                          <a:latin typeface="Calibri"/>
                          <a:cs typeface="Calibri"/>
                        </a:rPr>
                        <a:t> </a:t>
                      </a:r>
                      <a:r>
                        <a:rPr sz="1000" b="1" spc="-5" dirty="0">
                          <a:latin typeface="Calibri"/>
                          <a:cs typeface="Calibri"/>
                        </a:rPr>
                        <a:t>WP2374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marL="125095">
                        <a:lnSpc>
                          <a:spcPts val="1105"/>
                        </a:lnSpc>
                      </a:pPr>
                      <a:r>
                        <a:rPr sz="1000" b="1" spc="-10" dirty="0">
                          <a:latin typeface="Calibri"/>
                          <a:cs typeface="Calibri"/>
                        </a:rPr>
                        <a:t>0.004372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05"/>
                        </a:lnSpc>
                      </a:pPr>
                      <a:r>
                        <a:rPr sz="1000" b="1" spc="-5" dirty="0">
                          <a:latin typeface="Calibri"/>
                          <a:cs typeface="Calibri"/>
                        </a:rPr>
                        <a:t>IRS1;PRKCE;MAPK1;PRKCA;OSMR;MTOR;JAK1</a:t>
                      </a:r>
                      <a:endParaRPr sz="10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12700">
                      <a:solidFill>
                        <a:srgbClr val="FFFFFF"/>
                      </a:solidFill>
                      <a:prstDash val="solid"/>
                    </a:lnL>
                    <a:lnR w="12700">
                      <a:solidFill>
                        <a:srgbClr val="FFFFFF"/>
                      </a:solidFill>
                      <a:prstDash val="solid"/>
                    </a:lnR>
                    <a:lnT w="12700">
                      <a:solidFill>
                        <a:srgbClr val="FFFFFF"/>
                      </a:solidFill>
                      <a:prstDash val="solid"/>
                    </a:lnT>
                    <a:lnB w="12700">
                      <a:solidFill>
                        <a:srgbClr val="FFFFFF"/>
                      </a:solidFill>
                      <a:prstDash val="solid"/>
                    </a:lnB>
                    <a:solidFill>
                      <a:srgbClr val="EAEEF7"/>
                    </a:solidFill>
                  </a:tcPr>
                </a:tc>
              </a:tr>
            </a:tbl>
          </a:graphicData>
        </a:graphic>
      </p:graphicFrame>
      <p:sp>
        <p:nvSpPr>
          <p:cNvPr id="3" name="object 3"/>
          <p:cNvSpPr txBox="1"/>
          <p:nvPr/>
        </p:nvSpPr>
        <p:spPr>
          <a:xfrm>
            <a:off x="2815844" y="17780"/>
            <a:ext cx="638302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5" dirty="0">
                <a:latin typeface="Calibri"/>
                <a:cs typeface="Calibri"/>
              </a:rPr>
              <a:t>WikiPathways </a:t>
            </a:r>
            <a:r>
              <a:rPr sz="1800" b="1" dirty="0">
                <a:latin typeface="Calibri"/>
                <a:cs typeface="Calibri"/>
              </a:rPr>
              <a:t>2019 </a:t>
            </a:r>
            <a:r>
              <a:rPr sz="1800" b="1" spc="-5" dirty="0">
                <a:latin typeface="Calibri"/>
                <a:cs typeface="Calibri"/>
              </a:rPr>
              <a:t>Human (top </a:t>
            </a:r>
            <a:r>
              <a:rPr sz="1800" b="1" dirty="0">
                <a:latin typeface="Calibri"/>
                <a:cs typeface="Calibri"/>
              </a:rPr>
              <a:t>30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</a:t>
            </a:r>
            <a:r>
              <a:rPr sz="1800" b="1" spc="-30" dirty="0">
                <a:latin typeface="Calibri"/>
                <a:cs typeface="Calibri"/>
              </a:rPr>
              <a:t> </a:t>
            </a:r>
            <a:r>
              <a:rPr sz="1800" b="1" spc="-15" dirty="0">
                <a:latin typeface="Calibri"/>
                <a:cs typeface="Calibri"/>
              </a:rPr>
              <a:t>pathways)</a:t>
            </a:r>
            <a:endParaRPr sz="180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819882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658851" y="509015"/>
            <a:ext cx="2732577" cy="620572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5623174" y="539535"/>
            <a:ext cx="5981344" cy="607347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4989067" y="526796"/>
            <a:ext cx="1492250" cy="29972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Reactome</a:t>
            </a:r>
            <a:r>
              <a:rPr sz="1800" b="1" spc="-55" dirty="0">
                <a:latin typeface="Calibri"/>
                <a:cs typeface="Calibri"/>
              </a:rPr>
              <a:t> </a:t>
            </a:r>
            <a:r>
              <a:rPr sz="1800" b="1" dirty="0">
                <a:latin typeface="Calibri"/>
                <a:cs typeface="Calibri"/>
              </a:rPr>
              <a:t>2016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854451" y="425965"/>
            <a:ext cx="6205728" cy="273404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>
            <a:spLocks noGrp="1"/>
          </p:cNvSpPr>
          <p:nvPr>
            <p:ph type="title"/>
          </p:nvPr>
        </p:nvSpPr>
        <p:spPr>
          <a:xfrm>
            <a:off x="3006344" y="17780"/>
            <a:ext cx="579755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Reactome </a:t>
            </a:r>
            <a:r>
              <a:rPr sz="1800" b="1" dirty="0">
                <a:latin typeface="Calibri"/>
                <a:cs typeface="Calibri"/>
              </a:rPr>
              <a:t>2016 </a:t>
            </a:r>
            <a:r>
              <a:rPr sz="1800" b="1" spc="-10" dirty="0">
                <a:latin typeface="Calibri"/>
                <a:cs typeface="Calibri"/>
              </a:rPr>
              <a:t>(examples </a:t>
            </a:r>
            <a:r>
              <a:rPr sz="1800" b="1" dirty="0">
                <a:latin typeface="Calibri"/>
                <a:cs typeface="Calibri"/>
              </a:rPr>
              <a:t>of </a:t>
            </a:r>
            <a:r>
              <a:rPr sz="1800" b="1" spc="-5" dirty="0">
                <a:latin typeface="Calibri"/>
                <a:cs typeface="Calibri"/>
              </a:rPr>
              <a:t>significantly </a:t>
            </a:r>
            <a:r>
              <a:rPr sz="1800" b="1" spc="-15" dirty="0">
                <a:latin typeface="Calibri"/>
                <a:cs typeface="Calibri"/>
              </a:rPr>
              <a:t>affected</a:t>
            </a:r>
            <a:r>
              <a:rPr sz="1800" b="1" spc="-20" dirty="0">
                <a:latin typeface="Calibri"/>
                <a:cs typeface="Calibri"/>
              </a:rPr>
              <a:t> </a:t>
            </a:r>
            <a:r>
              <a:rPr sz="1800" b="1" spc="-15" dirty="0">
                <a:latin typeface="Calibri"/>
                <a:cs typeface="Calibri"/>
              </a:rPr>
              <a:t>pathways)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4" name="object 4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vert="horz" wrap="square" lIns="0" tIns="106045" rIns="0" bIns="0" rtlCol="0">
            <a:spAutoFit/>
          </a:bodyPr>
          <a:lstStyle/>
          <a:p>
            <a:pPr marR="441325" algn="ctr">
              <a:lnSpc>
                <a:spcPct val="100000"/>
              </a:lnSpc>
              <a:spcBef>
                <a:spcPts val="835"/>
              </a:spcBef>
            </a:pPr>
            <a:r>
              <a:rPr spc="-15" dirty="0"/>
              <a:t>VEGFA-VEGFR2 </a:t>
            </a:r>
            <a:r>
              <a:rPr spc="-20" dirty="0"/>
              <a:t>Pathway </a:t>
            </a:r>
            <a:r>
              <a:rPr dirty="0"/>
              <a:t>Homo </a:t>
            </a:r>
            <a:r>
              <a:rPr spc="-5" dirty="0"/>
              <a:t>sapiens</a:t>
            </a:r>
            <a:r>
              <a:rPr spc="-65" dirty="0"/>
              <a:t> </a:t>
            </a:r>
            <a:r>
              <a:rPr spc="-5" dirty="0"/>
              <a:t>R-HSA-4420097</a:t>
            </a:r>
          </a:p>
          <a:p>
            <a:pPr marR="475615" algn="ctr">
              <a:lnSpc>
                <a:spcPct val="100000"/>
              </a:lnSpc>
              <a:spcBef>
                <a:spcPts val="740"/>
              </a:spcBef>
            </a:pPr>
            <a:r>
              <a:rPr i="1" spc="-5" dirty="0">
                <a:solidFill>
                  <a:srgbClr val="000000"/>
                </a:solidFill>
                <a:latin typeface="Calibri"/>
                <a:cs typeface="Calibri"/>
              </a:rPr>
              <a:t>AHCYL1;IRS1;PDPK1;FN1;PRKCA;ITPR3;DUSP16;EGFR;MTOR;SPRED2;GDNF;PSMD5;MAPK1;SPTBN1;VCL;JAK1</a:t>
            </a:r>
          </a:p>
          <a:p>
            <a:pPr marR="105410" algn="ctr">
              <a:lnSpc>
                <a:spcPct val="100000"/>
              </a:lnSpc>
              <a:spcBef>
                <a:spcPts val="745"/>
              </a:spcBef>
            </a:pPr>
            <a:r>
              <a:rPr spc="-5" dirty="0"/>
              <a:t>MAPK family </a:t>
            </a:r>
            <a:r>
              <a:rPr dirty="0"/>
              <a:t>signaling </a:t>
            </a:r>
            <a:r>
              <a:rPr spc="-5" dirty="0"/>
              <a:t>cascades </a:t>
            </a:r>
            <a:r>
              <a:rPr dirty="0"/>
              <a:t>Homo sapiens</a:t>
            </a:r>
            <a:r>
              <a:rPr spc="-130" dirty="0"/>
              <a:t> </a:t>
            </a:r>
            <a:r>
              <a:rPr spc="-5" dirty="0"/>
              <a:t>R-HSA-5683057</a:t>
            </a:r>
          </a:p>
          <a:p>
            <a:pPr marR="340995" algn="ctr">
              <a:lnSpc>
                <a:spcPct val="100000"/>
              </a:lnSpc>
              <a:spcBef>
                <a:spcPts val="1090"/>
              </a:spcBef>
            </a:pPr>
            <a:r>
              <a:rPr i="1" spc="-10" dirty="0">
                <a:solidFill>
                  <a:srgbClr val="000000"/>
                </a:solidFill>
                <a:latin typeface="Calibri"/>
                <a:cs typeface="Calibri"/>
              </a:rPr>
              <a:t>IRS1;NCOA3;FN1;DUSP16;EGFR;SPRED2;GDNF;PSMD5;AGO4;AGO1;AGO2;MAPK1;SPTBN1;VCL;JAK1</a:t>
            </a:r>
          </a:p>
          <a:p>
            <a:pPr marR="435609" algn="ctr">
              <a:lnSpc>
                <a:spcPct val="100000"/>
              </a:lnSpc>
              <a:spcBef>
                <a:spcPts val="1095"/>
              </a:spcBef>
            </a:pPr>
            <a:r>
              <a:rPr spc="-5" dirty="0"/>
              <a:t>Signaling by </a:t>
            </a:r>
            <a:r>
              <a:rPr spc="-20" dirty="0"/>
              <a:t>NOTCH </a:t>
            </a:r>
            <a:r>
              <a:rPr dirty="0"/>
              <a:t>Homo sapiens</a:t>
            </a:r>
            <a:r>
              <a:rPr spc="-85" dirty="0"/>
              <a:t> </a:t>
            </a:r>
            <a:r>
              <a:rPr spc="-5" dirty="0"/>
              <a:t>R-HSA-157118</a:t>
            </a:r>
          </a:p>
          <a:p>
            <a:pPr marR="344805" algn="ctr">
              <a:lnSpc>
                <a:spcPct val="100000"/>
              </a:lnSpc>
              <a:spcBef>
                <a:spcPts val="1095"/>
              </a:spcBef>
            </a:pPr>
            <a:r>
              <a:rPr i="1" spc="-10" dirty="0">
                <a:solidFill>
                  <a:srgbClr val="000000"/>
                </a:solidFill>
                <a:latin typeface="Calibri"/>
                <a:cs typeface="Calibri"/>
              </a:rPr>
              <a:t>NOTCH2;CREBBP;MAML1;NEURL1B;ADAM17;CCND1;AGO4;AGO1;AGO2;NUMB;EP300;TBL1X;MAMLD1</a:t>
            </a:r>
          </a:p>
          <a:p>
            <a:pPr marR="147955" algn="ctr">
              <a:lnSpc>
                <a:spcPct val="100000"/>
              </a:lnSpc>
              <a:spcBef>
                <a:spcPts val="1080"/>
              </a:spcBef>
            </a:pPr>
            <a:r>
              <a:rPr dirty="0"/>
              <a:t>NGF signaling </a:t>
            </a:r>
            <a:r>
              <a:rPr spc="-5" dirty="0"/>
              <a:t>via TRKA </a:t>
            </a:r>
            <a:r>
              <a:rPr spc="-10" dirty="0"/>
              <a:t>from </a:t>
            </a:r>
            <a:r>
              <a:rPr dirty="0"/>
              <a:t>the plasma </a:t>
            </a:r>
            <a:r>
              <a:rPr spc="-10" dirty="0"/>
              <a:t>membrane </a:t>
            </a:r>
            <a:r>
              <a:rPr dirty="0"/>
              <a:t>Homo </a:t>
            </a:r>
            <a:r>
              <a:rPr spc="-5" dirty="0"/>
              <a:t>sapiens</a:t>
            </a:r>
            <a:r>
              <a:rPr spc="-90" dirty="0"/>
              <a:t> </a:t>
            </a:r>
            <a:r>
              <a:rPr spc="-5" dirty="0"/>
              <a:t>R-HSA-187037</a:t>
            </a:r>
          </a:p>
          <a:p>
            <a:pPr marR="5080" algn="ctr">
              <a:lnSpc>
                <a:spcPct val="100000"/>
              </a:lnSpc>
              <a:spcBef>
                <a:spcPts val="750"/>
              </a:spcBef>
            </a:pPr>
            <a:r>
              <a:rPr i="1" spc="-5" dirty="0">
                <a:solidFill>
                  <a:srgbClr val="000000"/>
                </a:solidFill>
                <a:latin typeface="Calibri"/>
                <a:cs typeface="Calibri"/>
              </a:rPr>
              <a:t>PHLPP2;AHCYL1;PHLPP1;IRS1;ITPR3;ADCY7;DUSP16;EGFR;CRKL;SPRED2;PSMD5;PRKAR2A;PIP4K2A;MAPK1;SPTBN1;  </a:t>
            </a:r>
            <a:r>
              <a:rPr i="1" spc="-10" dirty="0">
                <a:solidFill>
                  <a:srgbClr val="000000"/>
                </a:solidFill>
                <a:latin typeface="Calibri"/>
                <a:cs typeface="Calibri"/>
              </a:rPr>
              <a:t>JAK1;PDPK1;PRKCE;FN1;PRKCA;MTOR;GDNF;AGO4;AGO1;AGO2;VCL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</TotalTime>
  <Words>2377</Words>
  <Application>Microsoft Office PowerPoint</Application>
  <PresentationFormat>Widescreen</PresentationFormat>
  <Paragraphs>818</Paragraphs>
  <Slides>2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WikiPathways 2019 Human (examples of significantly affected pathways)</vt:lpstr>
      <vt:lpstr>PowerPoint Presentation</vt:lpstr>
      <vt:lpstr>PowerPoint Presentation</vt:lpstr>
      <vt:lpstr>Reactome 2016 (examples of significantly affected pathways)</vt:lpstr>
      <vt:lpstr>PowerPoint Presentation</vt:lpstr>
      <vt:lpstr>PowerPoint Presentation</vt:lpstr>
      <vt:lpstr>PowerPoint Presentation</vt:lpstr>
      <vt:lpstr>NCI-Nature 2016 (examples of significantly affected pathways)</vt:lpstr>
      <vt:lpstr>PowerPoint Presentation</vt:lpstr>
      <vt:lpstr>PowerPoint Presentation</vt:lpstr>
      <vt:lpstr>KEGG 2019 Human (examples of significantly affected pathways)</vt:lpstr>
      <vt:lpstr>KEGG 2019 Human (top 25 of significantly affected pathways)</vt:lpstr>
      <vt:lpstr>PowerPoint Presentation</vt:lpstr>
      <vt:lpstr>PowerPoint Presentation</vt:lpstr>
      <vt:lpstr>PowerPoint Presentation</vt:lpstr>
      <vt:lpstr>PowerPoint Presentation</vt:lpstr>
      <vt:lpstr>GO Biological Process 2018 (examples of significantly affected biological processes)</vt:lpstr>
      <vt:lpstr>PowerPoint Presentation</vt:lpstr>
      <vt:lpstr>PowerPoint Presentation</vt:lpstr>
      <vt:lpstr>Effects of the fb-PMT on expression of cancer driver genes (p adj = 0.05)</vt:lpstr>
      <vt:lpstr>PowerPoint Presentation</vt:lpstr>
      <vt:lpstr>fb-PMT effects on RET and GDNF expression could  be sufficient to induce the programmed cell death  (apoptosis) of glioblastoma cells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b-PMT effect of gene expression in U87 cells 1,588 down-regulated genes</dc:title>
  <dc:creator>Guennadi Glinskii</dc:creator>
  <cp:lastModifiedBy>Guennadi Glinskii</cp:lastModifiedBy>
  <cp:revision>14</cp:revision>
  <dcterms:created xsi:type="dcterms:W3CDTF">2020-04-13T03:24:49Z</dcterms:created>
  <dcterms:modified xsi:type="dcterms:W3CDTF">2021-09-21T04:58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0-04-12T00:00:00Z</vt:filetime>
  </property>
  <property fmtid="{D5CDD505-2E9C-101B-9397-08002B2CF9AE}" pid="3" name="Creator">
    <vt:lpwstr>Microsoft® PowerPoint® 2013</vt:lpwstr>
  </property>
  <property fmtid="{D5CDD505-2E9C-101B-9397-08002B2CF9AE}" pid="4" name="LastSaved">
    <vt:filetime>2020-04-13T00:00:00Z</vt:filetime>
  </property>
</Properties>
</file>